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sldIdLst>
    <p:sldId id="260" r:id="rId5"/>
    <p:sldId id="262" r:id="rId6"/>
    <p:sldId id="258" r:id="rId7"/>
    <p:sldId id="257" r:id="rId8"/>
    <p:sldId id="263"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5F5F5"/>
    <a:srgbClr val="FFCCFF"/>
    <a:srgbClr val="FF66FF"/>
  </p:clrMru>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p:scale>
          <a:sx n="110" d="100"/>
          <a:sy n="110" d="100"/>
        </p:scale>
        <p:origin x="2412"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ableStyles" Target="tableStyle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heme" Target="theme/theme1.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viewProps" Target="viewProps.xml"/><Relationship Id="rId5" Type="http://schemas.openxmlformats.org/officeDocument/2006/relationships/slide" Target="slides/slide1.xml"/><Relationship Id="rId10"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81BCE48-1625-4B9C-AACB-CCA2EA9B20FB}" type="datetimeFigureOut">
              <a:rPr lang="en-US" smtClean="0"/>
              <a:t>4/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12291242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1BCE48-1625-4B9C-AACB-CCA2EA9B20FB}" type="datetimeFigureOut">
              <a:rPr lang="en-US" smtClean="0"/>
              <a:t>4/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10514107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1BCE48-1625-4B9C-AACB-CCA2EA9B20FB}" type="datetimeFigureOut">
              <a:rPr lang="en-US" smtClean="0"/>
              <a:t>4/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5741803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1BCE48-1625-4B9C-AACB-CCA2EA9B20FB}" type="datetimeFigureOut">
              <a:rPr lang="en-US" smtClean="0"/>
              <a:t>4/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18336445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81BCE48-1625-4B9C-AACB-CCA2EA9B20FB}" type="datetimeFigureOut">
              <a:rPr lang="en-US" smtClean="0"/>
              <a:t>4/17/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35351832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81BCE48-1625-4B9C-AACB-CCA2EA9B20FB}" type="datetimeFigureOut">
              <a:rPr lang="en-US" smtClean="0"/>
              <a:t>4/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14110753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81BCE48-1625-4B9C-AACB-CCA2EA9B20FB}" type="datetimeFigureOut">
              <a:rPr lang="en-US" smtClean="0"/>
              <a:t>4/17/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357764326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81BCE48-1625-4B9C-AACB-CCA2EA9B20FB}" type="datetimeFigureOut">
              <a:rPr lang="en-US" smtClean="0"/>
              <a:t>4/17/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27656320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1BCE48-1625-4B9C-AACB-CCA2EA9B20FB}" type="datetimeFigureOut">
              <a:rPr lang="en-US" smtClean="0"/>
              <a:t>4/17/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33336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81BCE48-1625-4B9C-AACB-CCA2EA9B20FB}" type="datetimeFigureOut">
              <a:rPr lang="en-US" smtClean="0"/>
              <a:t>4/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25640514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81BCE48-1625-4B9C-AACB-CCA2EA9B20FB}" type="datetimeFigureOut">
              <a:rPr lang="en-US" smtClean="0"/>
              <a:t>4/17/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21F80A-A7D6-4C4C-937F-867226097013}" type="slidenum">
              <a:rPr lang="en-US" smtClean="0"/>
              <a:t>‹#›</a:t>
            </a:fld>
            <a:endParaRPr lang="en-US"/>
          </a:p>
        </p:txBody>
      </p:sp>
    </p:spTree>
    <p:extLst>
      <p:ext uri="{BB962C8B-B14F-4D97-AF65-F5344CB8AC3E}">
        <p14:creationId xmlns:p14="http://schemas.microsoft.com/office/powerpoint/2010/main" val="29267405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81BCE48-1625-4B9C-AACB-CCA2EA9B20FB}" type="datetimeFigureOut">
              <a:rPr lang="en-US" smtClean="0"/>
              <a:t>4/17/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921F80A-A7D6-4C4C-937F-867226097013}" type="slidenum">
              <a:rPr lang="en-US" smtClean="0"/>
              <a:t>‹#›</a:t>
            </a:fld>
            <a:endParaRPr lang="en-US"/>
          </a:p>
        </p:txBody>
      </p:sp>
    </p:spTree>
    <p:extLst>
      <p:ext uri="{BB962C8B-B14F-4D97-AF65-F5344CB8AC3E}">
        <p14:creationId xmlns:p14="http://schemas.microsoft.com/office/powerpoint/2010/main" val="375997788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afeldstein@ucsd.edu"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emf"/><Relationship Id="rId7" Type="http://schemas.openxmlformats.org/officeDocument/2006/relationships/image" Target="../media/image6.emf"/><Relationship Id="rId12" Type="http://schemas.openxmlformats.org/officeDocument/2006/relationships/image" Target="../media/image11.tiff"/><Relationship Id="rId2" Type="http://schemas.openxmlformats.org/officeDocument/2006/relationships/image" Target="../media/image1.jpeg"/><Relationship Id="rId16" Type="http://schemas.openxmlformats.org/officeDocument/2006/relationships/image" Target="../media/image15.tiff"/><Relationship Id="rId1" Type="http://schemas.openxmlformats.org/officeDocument/2006/relationships/slideLayout" Target="../slideLayouts/slideLayout1.xml"/><Relationship Id="rId6" Type="http://schemas.openxmlformats.org/officeDocument/2006/relationships/image" Target="../media/image5.emf"/><Relationship Id="rId11" Type="http://schemas.openxmlformats.org/officeDocument/2006/relationships/image" Target="../media/image10.tiff"/><Relationship Id="rId5" Type="http://schemas.openxmlformats.org/officeDocument/2006/relationships/image" Target="../media/image4.em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emf"/><Relationship Id="rId9" Type="http://schemas.openxmlformats.org/officeDocument/2006/relationships/image" Target="../media/image8.tiff"/><Relationship Id="rId14" Type="http://schemas.openxmlformats.org/officeDocument/2006/relationships/image" Target="../media/image13.tiff"/></Relationships>
</file>

<file path=ppt/slides/_rels/slide3.xml.rels><?xml version="1.0" encoding="UTF-8" standalone="yes"?>
<Relationships xmlns="http://schemas.openxmlformats.org/package/2006/relationships"><Relationship Id="rId8" Type="http://schemas.microsoft.com/office/2007/relationships/hdphoto" Target="../media/hdphoto2.wdp"/><Relationship Id="rId13" Type="http://schemas.openxmlformats.org/officeDocument/2006/relationships/image" Target="../media/image24.jpeg"/><Relationship Id="rId18" Type="http://schemas.microsoft.com/office/2007/relationships/hdphoto" Target="../media/hdphoto5.wdp"/><Relationship Id="rId26" Type="http://schemas.openxmlformats.org/officeDocument/2006/relationships/image" Target="../media/image34.jpeg"/><Relationship Id="rId3" Type="http://schemas.openxmlformats.org/officeDocument/2006/relationships/image" Target="../media/image17.jpeg"/><Relationship Id="rId21" Type="http://schemas.openxmlformats.org/officeDocument/2006/relationships/image" Target="../media/image30.jpeg"/><Relationship Id="rId7" Type="http://schemas.openxmlformats.org/officeDocument/2006/relationships/image" Target="../media/image20.png"/><Relationship Id="rId12" Type="http://schemas.microsoft.com/office/2007/relationships/hdphoto" Target="../media/hdphoto3.wdp"/><Relationship Id="rId17" Type="http://schemas.openxmlformats.org/officeDocument/2006/relationships/image" Target="../media/image27.png"/><Relationship Id="rId25" Type="http://schemas.microsoft.com/office/2007/relationships/hdphoto" Target="../media/hdphoto6.wdp"/><Relationship Id="rId33" Type="http://schemas.openxmlformats.org/officeDocument/2006/relationships/image" Target="../media/image41.jpeg"/><Relationship Id="rId2" Type="http://schemas.openxmlformats.org/officeDocument/2006/relationships/image" Target="../media/image16.jpeg"/><Relationship Id="rId16" Type="http://schemas.openxmlformats.org/officeDocument/2006/relationships/image" Target="../media/image26.jpeg"/><Relationship Id="rId20" Type="http://schemas.openxmlformats.org/officeDocument/2006/relationships/image" Target="../media/image29.jpeg"/><Relationship Id="rId29" Type="http://schemas.openxmlformats.org/officeDocument/2006/relationships/image" Target="../media/image37.jpeg"/><Relationship Id="rId1" Type="http://schemas.openxmlformats.org/officeDocument/2006/relationships/slideLayout" Target="../slideLayouts/slideLayout2.xml"/><Relationship Id="rId6" Type="http://schemas.openxmlformats.org/officeDocument/2006/relationships/image" Target="../media/image19.jpeg"/><Relationship Id="rId11" Type="http://schemas.openxmlformats.org/officeDocument/2006/relationships/image" Target="../media/image23.png"/><Relationship Id="rId24" Type="http://schemas.openxmlformats.org/officeDocument/2006/relationships/image" Target="../media/image33.png"/><Relationship Id="rId32" Type="http://schemas.openxmlformats.org/officeDocument/2006/relationships/image" Target="../media/image40.jpeg"/><Relationship Id="rId5" Type="http://schemas.microsoft.com/office/2007/relationships/hdphoto" Target="../media/hdphoto1.wdp"/><Relationship Id="rId15" Type="http://schemas.microsoft.com/office/2007/relationships/hdphoto" Target="../media/hdphoto4.wdp"/><Relationship Id="rId23" Type="http://schemas.openxmlformats.org/officeDocument/2006/relationships/image" Target="../media/image32.jpeg"/><Relationship Id="rId28" Type="http://schemas.openxmlformats.org/officeDocument/2006/relationships/image" Target="../media/image36.jpeg"/><Relationship Id="rId10" Type="http://schemas.openxmlformats.org/officeDocument/2006/relationships/image" Target="../media/image22.jpeg"/><Relationship Id="rId19" Type="http://schemas.openxmlformats.org/officeDocument/2006/relationships/image" Target="../media/image28.jpeg"/><Relationship Id="rId31" Type="http://schemas.openxmlformats.org/officeDocument/2006/relationships/image" Target="../media/image39.jpeg"/><Relationship Id="rId4" Type="http://schemas.openxmlformats.org/officeDocument/2006/relationships/image" Target="../media/image18.png"/><Relationship Id="rId9" Type="http://schemas.openxmlformats.org/officeDocument/2006/relationships/image" Target="../media/image21.jpeg"/><Relationship Id="rId14" Type="http://schemas.openxmlformats.org/officeDocument/2006/relationships/image" Target="../media/image25.png"/><Relationship Id="rId22" Type="http://schemas.openxmlformats.org/officeDocument/2006/relationships/image" Target="../media/image31.jpeg"/><Relationship Id="rId27" Type="http://schemas.openxmlformats.org/officeDocument/2006/relationships/image" Target="../media/image35.jpeg"/><Relationship Id="rId30" Type="http://schemas.openxmlformats.org/officeDocument/2006/relationships/image" Target="../media/image38.jpeg"/></Relationships>
</file>

<file path=ppt/slides/_rels/slide4.xml.rels><?xml version="1.0" encoding="UTF-8" standalone="yes"?>
<Relationships xmlns="http://schemas.openxmlformats.org/package/2006/relationships"><Relationship Id="rId3" Type="http://schemas.microsoft.com/office/2007/relationships/hdphoto" Target="../media/hdphoto7.wdp"/><Relationship Id="rId2" Type="http://schemas.openxmlformats.org/officeDocument/2006/relationships/image" Target="../media/image42.png"/><Relationship Id="rId1" Type="http://schemas.openxmlformats.org/officeDocument/2006/relationships/slideLayout" Target="../slideLayouts/slideLayout2.xml"/><Relationship Id="rId5" Type="http://schemas.openxmlformats.org/officeDocument/2006/relationships/image" Target="../media/image44.tiff"/><Relationship Id="rId4" Type="http://schemas.openxmlformats.org/officeDocument/2006/relationships/image" Target="../media/image43.tiff"/></Relationships>
</file>

<file path=ppt/slides/_rels/slide5.xml.rels><?xml version="1.0" encoding="UTF-8" standalone="yes"?>
<Relationships xmlns="http://schemas.openxmlformats.org/package/2006/relationships"><Relationship Id="rId2" Type="http://schemas.openxmlformats.org/officeDocument/2006/relationships/image" Target="../media/image4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496202" y="988540"/>
            <a:ext cx="5915025" cy="8724572"/>
          </a:xfrm>
        </p:spPr>
        <p:txBody>
          <a:bodyPr>
            <a:normAutofit/>
          </a:bodyPr>
          <a:lstStyle/>
          <a:p>
            <a:pPr marL="0" indent="0">
              <a:buNone/>
            </a:pPr>
            <a:r>
              <a:rPr lang="en-US" sz="1200" b="1" dirty="0">
                <a:latin typeface="Arial" panose="020B0604020202020204" pitchFamily="34" charset="0"/>
                <a:cs typeface="Arial" panose="020B0604020202020204" pitchFamily="34" charset="0"/>
              </a:rPr>
              <a:t>Supplementary Information</a:t>
            </a:r>
          </a:p>
          <a:p>
            <a:pPr marL="0" indent="0">
              <a:buNone/>
            </a:pPr>
            <a:endParaRPr lang="en-US" sz="1200" b="1" dirty="0">
              <a:latin typeface="Arial" panose="020B0604020202020204" pitchFamily="34" charset="0"/>
              <a:cs typeface="Arial" panose="020B0604020202020204" pitchFamily="34" charset="0"/>
            </a:endParaRPr>
          </a:p>
          <a:p>
            <a:pPr marL="0" indent="0">
              <a:buNone/>
            </a:pPr>
            <a:r>
              <a:rPr lang="en-US" sz="1200" b="1" dirty="0">
                <a:latin typeface="Arial" panose="020B0604020202020204" pitchFamily="34" charset="0"/>
                <a:cs typeface="Arial" panose="020B0604020202020204" pitchFamily="34" charset="0"/>
              </a:rPr>
              <a:t>Myeloid specific deletion of chitinase 3 like 1 protein ameliorates murine diet induced steatohepatitis progression </a:t>
            </a: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Andrea D. Kim</a:t>
            </a: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 Lin Kui</a:t>
            </a: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Benedikt</a:t>
            </a:r>
            <a:r>
              <a:rPr lang="en-US" sz="1200" dirty="0">
                <a:latin typeface="Arial" panose="020B0604020202020204" pitchFamily="34" charset="0"/>
                <a:cs typeface="Arial" panose="020B0604020202020204" pitchFamily="34" charset="0"/>
              </a:rPr>
              <a:t> Kaufmann</a:t>
            </a:r>
            <a:r>
              <a:rPr lang="en-US" sz="1200" baseline="30000" dirty="0">
                <a:latin typeface="Arial" panose="020B0604020202020204" pitchFamily="34" charset="0"/>
                <a:cs typeface="Arial" panose="020B0604020202020204" pitchFamily="34" charset="0"/>
              </a:rPr>
              <a:t>1,2</a:t>
            </a:r>
            <a:r>
              <a:rPr lang="en-US" sz="1200" dirty="0">
                <a:latin typeface="Arial" panose="020B0604020202020204" pitchFamily="34" charset="0"/>
                <a:cs typeface="Arial" panose="020B0604020202020204" pitchFamily="34" charset="0"/>
              </a:rPr>
              <a:t>, Sung </a:t>
            </a:r>
            <a:r>
              <a:rPr lang="en-US" sz="1200" dirty="0" err="1">
                <a:latin typeface="Arial" panose="020B0604020202020204" pitchFamily="34" charset="0"/>
                <a:cs typeface="Arial" panose="020B0604020202020204" pitchFamily="34" charset="0"/>
              </a:rPr>
              <a:t>Eun</a:t>
            </a:r>
            <a:r>
              <a:rPr lang="en-US" sz="1200" dirty="0">
                <a:latin typeface="Arial" panose="020B0604020202020204" pitchFamily="34" charset="0"/>
                <a:cs typeface="Arial" panose="020B0604020202020204" pitchFamily="34" charset="0"/>
              </a:rPr>
              <a:t> Kim</a:t>
            </a:r>
            <a:r>
              <a:rPr lang="en-US" sz="1200" baseline="30000" dirty="0">
                <a:latin typeface="Arial" panose="020B0604020202020204" pitchFamily="34" charset="0"/>
                <a:cs typeface="Arial" panose="020B0604020202020204" pitchFamily="34" charset="0"/>
              </a:rPr>
              <a:t>1, 3, 4</a:t>
            </a:r>
            <a:r>
              <a:rPr lang="en-US" sz="1200" dirty="0">
                <a:latin typeface="Arial" panose="020B0604020202020204" pitchFamily="34" charset="0"/>
                <a:cs typeface="Arial" panose="020B0604020202020204" pitchFamily="34" charset="0"/>
              </a:rPr>
              <a:t>, Aleksandra Leszscynska</a:t>
            </a: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 Ariel E. Feldstein</a:t>
            </a: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a:t>
            </a:r>
          </a:p>
          <a:p>
            <a:pPr marL="0" indent="0">
              <a:buNone/>
            </a:pPr>
            <a:r>
              <a:rPr lang="en-US" sz="1200" dirty="0">
                <a:latin typeface="Arial" panose="020B0604020202020204" pitchFamily="34" charset="0"/>
                <a:cs typeface="Arial" panose="020B0604020202020204" pitchFamily="34" charset="0"/>
              </a:rPr>
              <a:t> </a:t>
            </a:r>
          </a:p>
          <a:p>
            <a:pPr marL="0" indent="0">
              <a:buNone/>
            </a:pPr>
            <a:r>
              <a:rPr lang="en-US" sz="1200" baseline="30000" dirty="0">
                <a:latin typeface="Arial" panose="020B0604020202020204" pitchFamily="34" charset="0"/>
                <a:cs typeface="Arial" panose="020B0604020202020204" pitchFamily="34" charset="0"/>
              </a:rPr>
              <a:t>1</a:t>
            </a:r>
            <a:r>
              <a:rPr lang="en-US" sz="1200" dirty="0">
                <a:latin typeface="Arial" panose="020B0604020202020204" pitchFamily="34" charset="0"/>
                <a:cs typeface="Arial" panose="020B0604020202020204" pitchFamily="34" charset="0"/>
              </a:rPr>
              <a:t>Department of Pediatrics, University of California San Diego, La Jolla, USA.</a:t>
            </a:r>
          </a:p>
          <a:p>
            <a:pPr marL="0" indent="0">
              <a:buNone/>
            </a:pPr>
            <a:r>
              <a:rPr lang="en-US" sz="1200" baseline="30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Department of Surgery, TUM School of Medicine, </a:t>
            </a:r>
            <a:r>
              <a:rPr lang="en-US" sz="1200" dirty="0" err="1">
                <a:latin typeface="Arial" panose="020B0604020202020204" pitchFamily="34" charset="0"/>
                <a:cs typeface="Arial" panose="020B0604020202020204" pitchFamily="34" charset="0"/>
              </a:rPr>
              <a:t>Klinikum</a:t>
            </a:r>
            <a:r>
              <a:rPr lang="en-US" sz="1200" dirty="0">
                <a:latin typeface="Arial" panose="020B0604020202020204" pitchFamily="34" charset="0"/>
                <a:cs typeface="Arial" panose="020B0604020202020204" pitchFamily="34" charset="0"/>
              </a:rPr>
              <a:t> </a:t>
            </a:r>
            <a:r>
              <a:rPr lang="en-US" sz="1200" dirty="0" err="1">
                <a:latin typeface="Arial" panose="020B0604020202020204" pitchFamily="34" charset="0"/>
                <a:cs typeface="Arial" panose="020B0604020202020204" pitchFamily="34" charset="0"/>
              </a:rPr>
              <a:t>rechts</a:t>
            </a:r>
            <a:r>
              <a:rPr lang="en-US" sz="1200" dirty="0">
                <a:latin typeface="Arial" panose="020B0604020202020204" pitchFamily="34" charset="0"/>
                <a:cs typeface="Arial" panose="020B0604020202020204" pitchFamily="34" charset="0"/>
              </a:rPr>
              <a:t> der </a:t>
            </a:r>
            <a:r>
              <a:rPr lang="en-US" sz="1200" dirty="0" err="1">
                <a:latin typeface="Arial" panose="020B0604020202020204" pitchFamily="34" charset="0"/>
                <a:cs typeface="Arial" panose="020B0604020202020204" pitchFamily="34" charset="0"/>
              </a:rPr>
              <a:t>Isar</a:t>
            </a:r>
            <a:r>
              <a:rPr lang="en-US" sz="1200" dirty="0">
                <a:latin typeface="Arial" panose="020B0604020202020204" pitchFamily="34" charset="0"/>
                <a:cs typeface="Arial" panose="020B0604020202020204" pitchFamily="34" charset="0"/>
              </a:rPr>
              <a:t>, Technical University of Munich, Munich, Germany.</a:t>
            </a:r>
          </a:p>
          <a:p>
            <a:pPr marL="0" indent="0">
              <a:buNone/>
            </a:pPr>
            <a:r>
              <a:rPr lang="en-US" sz="1200" baseline="30000" dirty="0">
                <a:latin typeface="Arial" panose="020B0604020202020204" pitchFamily="34" charset="0"/>
                <a:cs typeface="Arial" panose="020B0604020202020204" pitchFamily="34" charset="0"/>
              </a:rPr>
              <a:t>3</a:t>
            </a:r>
            <a:r>
              <a:rPr lang="en-US" sz="1200" dirty="0">
                <a:latin typeface="Arial" panose="020B0604020202020204" pitchFamily="34" charset="0"/>
                <a:cs typeface="Arial" panose="020B0604020202020204" pitchFamily="34" charset="0"/>
              </a:rPr>
              <a:t>Department of Internal Medicine, </a:t>
            </a:r>
            <a:r>
              <a:rPr lang="en-US" sz="1200" dirty="0" err="1">
                <a:latin typeface="Arial" panose="020B0604020202020204" pitchFamily="34" charset="0"/>
                <a:cs typeface="Arial" panose="020B0604020202020204" pitchFamily="34" charset="0"/>
              </a:rPr>
              <a:t>Hallym</a:t>
            </a:r>
            <a:r>
              <a:rPr lang="en-US" sz="1200" dirty="0">
                <a:latin typeface="Arial" panose="020B0604020202020204" pitchFamily="34" charset="0"/>
                <a:cs typeface="Arial" panose="020B0604020202020204" pitchFamily="34" charset="0"/>
              </a:rPr>
              <a:t> University College of Medicine, </a:t>
            </a:r>
            <a:r>
              <a:rPr lang="en-US" sz="1200" dirty="0" err="1">
                <a:latin typeface="Arial" panose="020B0604020202020204" pitchFamily="34" charset="0"/>
                <a:cs typeface="Arial" panose="020B0604020202020204" pitchFamily="34" charset="0"/>
              </a:rPr>
              <a:t>Chuncheon</a:t>
            </a:r>
            <a:r>
              <a:rPr lang="en-US" sz="1200" dirty="0">
                <a:latin typeface="Arial" panose="020B0604020202020204" pitchFamily="34" charset="0"/>
                <a:cs typeface="Arial" panose="020B0604020202020204" pitchFamily="34" charset="0"/>
              </a:rPr>
              <a:t>, Republic of Korea.</a:t>
            </a:r>
          </a:p>
          <a:p>
            <a:pPr marL="0" indent="0">
              <a:buNone/>
            </a:pPr>
            <a:r>
              <a:rPr lang="en-US" sz="1200" baseline="30000" dirty="0">
                <a:latin typeface="Arial" panose="020B0604020202020204" pitchFamily="34" charset="0"/>
                <a:cs typeface="Arial" panose="020B0604020202020204" pitchFamily="34" charset="0"/>
              </a:rPr>
              <a:t>4</a:t>
            </a:r>
            <a:r>
              <a:rPr lang="en-US" sz="1200" dirty="0">
                <a:latin typeface="Arial" panose="020B0604020202020204" pitchFamily="34" charset="0"/>
                <a:cs typeface="Arial" panose="020B0604020202020204" pitchFamily="34" charset="0"/>
              </a:rPr>
              <a:t>Institute for Liver and Digestive Diseases, </a:t>
            </a:r>
            <a:r>
              <a:rPr lang="en-US" sz="1200" dirty="0" err="1">
                <a:latin typeface="Arial" panose="020B0604020202020204" pitchFamily="34" charset="0"/>
                <a:cs typeface="Arial" panose="020B0604020202020204" pitchFamily="34" charset="0"/>
              </a:rPr>
              <a:t>Hallym</a:t>
            </a:r>
            <a:r>
              <a:rPr lang="en-US" sz="1200" dirty="0">
                <a:latin typeface="Arial" panose="020B0604020202020204" pitchFamily="34" charset="0"/>
                <a:cs typeface="Arial" panose="020B0604020202020204" pitchFamily="34" charset="0"/>
              </a:rPr>
              <a:t> University, </a:t>
            </a:r>
            <a:r>
              <a:rPr lang="en-US" sz="1200" dirty="0" err="1">
                <a:latin typeface="Arial" panose="020B0604020202020204" pitchFamily="34" charset="0"/>
                <a:cs typeface="Arial" panose="020B0604020202020204" pitchFamily="34" charset="0"/>
              </a:rPr>
              <a:t>Chuncheon</a:t>
            </a:r>
            <a:r>
              <a:rPr lang="en-US" sz="1200" dirty="0">
                <a:latin typeface="Arial" panose="020B0604020202020204" pitchFamily="34" charset="0"/>
                <a:cs typeface="Arial" panose="020B0604020202020204" pitchFamily="34" charset="0"/>
              </a:rPr>
              <a:t>, Republic of Korea.</a:t>
            </a:r>
          </a:p>
          <a:p>
            <a:pPr marL="0" indent="0">
              <a:buNone/>
            </a:pPr>
            <a:r>
              <a:rPr lang="en-US" sz="1200" dirty="0">
                <a:latin typeface="Arial" panose="020B0604020202020204" pitchFamily="34" charset="0"/>
                <a:cs typeface="Arial" panose="020B0604020202020204" pitchFamily="34" charset="0"/>
              </a:rPr>
              <a:t>  </a:t>
            </a:r>
          </a:p>
          <a:p>
            <a:pPr marL="0" indent="0">
              <a:buNone/>
            </a:pP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 </a:t>
            </a:r>
          </a:p>
          <a:p>
            <a:pPr marL="0" indent="0">
              <a:buNone/>
            </a:pPr>
            <a:r>
              <a:rPr lang="en-US" sz="1200" dirty="0">
                <a:latin typeface="Arial" panose="020B0604020202020204" pitchFamily="34" charset="0"/>
                <a:cs typeface="Arial" panose="020B0604020202020204" pitchFamily="34" charset="0"/>
              </a:rPr>
              <a:t>Corresponding author:</a:t>
            </a:r>
          </a:p>
          <a:p>
            <a:pPr marL="0" indent="0">
              <a:buNone/>
            </a:pPr>
            <a:r>
              <a:rPr lang="en-US" sz="1200" dirty="0">
                <a:latin typeface="Arial" panose="020B0604020202020204" pitchFamily="34" charset="0"/>
                <a:cs typeface="Arial" panose="020B0604020202020204" pitchFamily="34" charset="0"/>
              </a:rPr>
              <a:t>Ariel E. Feldstein, MD, Professor of Pediatrics, University of California San Diego</a:t>
            </a:r>
          </a:p>
          <a:p>
            <a:pPr marL="0" indent="0">
              <a:buNone/>
            </a:pPr>
            <a:r>
              <a:rPr lang="en-US" sz="1200" dirty="0">
                <a:latin typeface="Arial" panose="020B0604020202020204" pitchFamily="34" charset="0"/>
                <a:cs typeface="Arial" panose="020B0604020202020204" pitchFamily="34" charset="0"/>
              </a:rPr>
              <a:t>3020 Children’s Way, MC 5030, San Diego, CA, 92103-8450</a:t>
            </a:r>
          </a:p>
          <a:p>
            <a:pPr marL="0" indent="0">
              <a:buNone/>
            </a:pPr>
            <a:r>
              <a:rPr lang="en-US" sz="1200" dirty="0">
                <a:latin typeface="Arial" panose="020B0604020202020204" pitchFamily="34" charset="0"/>
                <a:cs typeface="Arial" panose="020B0604020202020204" pitchFamily="34" charset="0"/>
              </a:rPr>
              <a:t>Tel: (858) 966 – 8907</a:t>
            </a:r>
          </a:p>
          <a:p>
            <a:pPr marL="0" indent="0">
              <a:buNone/>
            </a:pPr>
            <a:r>
              <a:rPr lang="en-US" sz="1200" dirty="0">
                <a:latin typeface="Arial" panose="020B0604020202020204" pitchFamily="34" charset="0"/>
                <a:cs typeface="Arial" panose="020B0604020202020204" pitchFamily="34" charset="0"/>
              </a:rPr>
              <a:t>Email: </a:t>
            </a:r>
            <a:r>
              <a:rPr lang="en-US" sz="1200" u="sng" dirty="0">
                <a:latin typeface="Arial" panose="020B0604020202020204" pitchFamily="34" charset="0"/>
                <a:cs typeface="Arial" panose="020B0604020202020204" pitchFamily="34" charset="0"/>
                <a:hlinkClick r:id="rId2"/>
              </a:rPr>
              <a:t>afeldstein@ucsd.edu</a:t>
            </a: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 </a:t>
            </a:r>
          </a:p>
          <a:p>
            <a:pPr marL="0" indent="0">
              <a:buNone/>
            </a:pPr>
            <a:r>
              <a:rPr lang="en-US" sz="1200" dirty="0">
                <a:latin typeface="Arial" panose="020B0604020202020204" pitchFamily="34" charset="0"/>
                <a:cs typeface="Arial" panose="020B0604020202020204" pitchFamily="34" charset="0"/>
              </a:rPr>
              <a:t> </a:t>
            </a:r>
          </a:p>
          <a:p>
            <a:pPr marL="0" indent="0">
              <a:buNone/>
            </a:pP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824422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94B2B21-CEF3-431F-A01C-1A22CF15B04F}"/>
              </a:ext>
            </a:extLst>
          </p:cNvPr>
          <p:cNvSpPr txBox="1"/>
          <p:nvPr/>
        </p:nvSpPr>
        <p:spPr>
          <a:xfrm>
            <a:off x="66053" y="7869818"/>
            <a:ext cx="6652965" cy="1938992"/>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 Fig. 1: Conditional </a:t>
            </a:r>
            <a:r>
              <a:rPr lang="en-US" sz="1200" b="1" dirty="0" err="1">
                <a:latin typeface="Arial" panose="020B0604020202020204" pitchFamily="34" charset="0"/>
                <a:cs typeface="Arial" panose="020B0604020202020204" pitchFamily="34" charset="0"/>
              </a:rPr>
              <a:t>Cre</a:t>
            </a:r>
            <a:r>
              <a:rPr lang="en-US" sz="1200" b="1" dirty="0">
                <a:latin typeface="Arial" panose="020B0604020202020204" pitchFamily="34" charset="0"/>
                <a:cs typeface="Arial" panose="020B0604020202020204" pitchFamily="34" charset="0"/>
              </a:rPr>
              <a:t> recombinase mediated deletion of CHI3L1 coding gene. </a:t>
            </a:r>
            <a:r>
              <a:rPr lang="en-US" sz="1200" dirty="0">
                <a:latin typeface="Arial" panose="020B0604020202020204" pitchFamily="34" charset="0"/>
                <a:cs typeface="Arial" panose="020B0604020202020204" pitchFamily="34" charset="0"/>
              </a:rPr>
              <a:t>(A) Design of linearized vector containing exon 5 of mouse chromosome 1 as targeted CHI3L1 conditional knock out region. The knock out alleles are obtained after </a:t>
            </a:r>
            <a:r>
              <a:rPr lang="en-US" sz="1200" dirty="0" err="1">
                <a:latin typeface="Arial" panose="020B0604020202020204" pitchFamily="34" charset="0"/>
                <a:cs typeface="Arial" panose="020B0604020202020204" pitchFamily="34" charset="0"/>
              </a:rPr>
              <a:t>Cre</a:t>
            </a:r>
            <a:r>
              <a:rPr lang="en-US" sz="1200" dirty="0">
                <a:latin typeface="Arial" panose="020B0604020202020204" pitchFamily="34" charset="0"/>
                <a:cs typeface="Arial" panose="020B0604020202020204" pitchFamily="34" charset="0"/>
              </a:rPr>
              <a:t>-mediated recombination. In this model, mice with </a:t>
            </a:r>
            <a:r>
              <a:rPr lang="en-US" sz="1200" dirty="0" err="1">
                <a:latin typeface="Arial" panose="020B0604020202020204" pitchFamily="34" charset="0"/>
                <a:cs typeface="Arial" panose="020B0604020202020204" pitchFamily="34" charset="0"/>
              </a:rPr>
              <a:t>Cre</a:t>
            </a:r>
            <a:r>
              <a:rPr lang="en-US" sz="1200" dirty="0">
                <a:latin typeface="Arial" panose="020B0604020202020204" pitchFamily="34" charset="0"/>
                <a:cs typeface="Arial" panose="020B0604020202020204" pitchFamily="34" charset="0"/>
              </a:rPr>
              <a:t> recombinase under the control of albumin (</a:t>
            </a:r>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Alb</a:t>
            </a:r>
            <a:r>
              <a:rPr lang="en-US" sz="1200" dirty="0">
                <a:latin typeface="Arial" panose="020B0604020202020204" pitchFamily="34" charset="0"/>
                <a:cs typeface="Arial" panose="020B0604020202020204" pitchFamily="34" charset="0"/>
              </a:rPr>
              <a:t>, hepatocyte-specific) or lysozyme (</a:t>
            </a:r>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Lyz</a:t>
            </a:r>
            <a:r>
              <a:rPr lang="en-US" sz="1200" dirty="0">
                <a:latin typeface="Arial" panose="020B0604020202020204" pitchFamily="34" charset="0"/>
                <a:cs typeface="Arial" panose="020B0604020202020204" pitchFamily="34" charset="0"/>
              </a:rPr>
              <a:t>, myeloid cell-specific) were used for breeding. Littermates lacking the </a:t>
            </a:r>
            <a:r>
              <a:rPr lang="en-US" sz="1200" dirty="0" err="1">
                <a:latin typeface="Arial" panose="020B0604020202020204" pitchFamily="34" charset="0"/>
                <a:cs typeface="Arial" panose="020B0604020202020204" pitchFamily="34" charset="0"/>
              </a:rPr>
              <a:t>Cre</a:t>
            </a:r>
            <a:r>
              <a:rPr lang="en-US" sz="1200" dirty="0">
                <a:latin typeface="Arial" panose="020B0604020202020204" pitchFamily="34" charset="0"/>
                <a:cs typeface="Arial" panose="020B0604020202020204" pitchFamily="34" charset="0"/>
              </a:rPr>
              <a:t> recombinase were used as WT controls. (B) Basal expression of CHI3L1 coding gene </a:t>
            </a:r>
            <a:r>
              <a:rPr lang="en-US" sz="1200" i="1" dirty="0">
                <a:latin typeface="Arial" panose="020B0604020202020204" pitchFamily="34" charset="0"/>
                <a:cs typeface="Arial" panose="020B0604020202020204" pitchFamily="34" charset="0"/>
              </a:rPr>
              <a:t>Chil1 </a:t>
            </a:r>
            <a:r>
              <a:rPr lang="en-US" sz="1200" dirty="0">
                <a:latin typeface="Arial" panose="020B0604020202020204" pitchFamily="34" charset="0"/>
                <a:cs typeface="Arial" panose="020B0604020202020204" pitchFamily="34" charset="0"/>
              </a:rPr>
              <a:t>was measured in bone marrow derived macrophages from WT and </a:t>
            </a:r>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Lyz</a:t>
            </a:r>
            <a:r>
              <a:rPr lang="en-US" sz="1200" baseline="300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mice. (C) Immunofluorescence detection of macrophage subset markers and CHI3L1 were used to co-localize the specific source of CHI3L1 in murine diet-induced NASH liver of BRP </a:t>
            </a:r>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Lyz</a:t>
            </a:r>
            <a:r>
              <a:rPr lang="en-US" sz="1200" baseline="30000"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mice. </a:t>
            </a:r>
            <a:endParaRPr lang="en-US" sz="1200" baseline="30000" dirty="0">
              <a:latin typeface="Arial" panose="020B0604020202020204" pitchFamily="34" charset="0"/>
              <a:cs typeface="Arial" panose="020B0604020202020204" pitchFamily="34" charset="0"/>
            </a:endParaRPr>
          </a:p>
        </p:txBody>
      </p:sp>
      <p:grpSp>
        <p:nvGrpSpPr>
          <p:cNvPr id="8" name="Group 7">
            <a:extLst>
              <a:ext uri="{FF2B5EF4-FFF2-40B4-BE49-F238E27FC236}">
                <a16:creationId xmlns:a16="http://schemas.microsoft.com/office/drawing/2014/main" id="{7EA9C467-6609-47E6-A930-D270271C4242}"/>
              </a:ext>
            </a:extLst>
          </p:cNvPr>
          <p:cNvGrpSpPr/>
          <p:nvPr/>
        </p:nvGrpSpPr>
        <p:grpSpPr>
          <a:xfrm>
            <a:off x="-49755" y="3746118"/>
            <a:ext cx="2303261" cy="2272700"/>
            <a:chOff x="-1231" y="3745942"/>
            <a:chExt cx="2822328" cy="2272700"/>
          </a:xfrm>
        </p:grpSpPr>
        <p:pic>
          <p:nvPicPr>
            <p:cNvPr id="5" name="Picture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4674" y="3905822"/>
              <a:ext cx="1865047" cy="1629374"/>
            </a:xfrm>
            <a:prstGeom prst="rect">
              <a:avLst/>
            </a:prstGeom>
          </p:spPr>
        </p:pic>
        <p:cxnSp>
          <p:nvCxnSpPr>
            <p:cNvPr id="7" name="Straight Connector 6"/>
            <p:cNvCxnSpPr/>
            <p:nvPr/>
          </p:nvCxnSpPr>
          <p:spPr>
            <a:xfrm>
              <a:off x="644896" y="5691547"/>
              <a:ext cx="993985" cy="0"/>
            </a:xfrm>
            <a:prstGeom prst="line">
              <a:avLst/>
            </a:prstGeom>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209366" y="5772421"/>
              <a:ext cx="2611731"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Bone marrow derived macrophages</a:t>
              </a:r>
            </a:p>
          </p:txBody>
        </p:sp>
        <p:sp>
          <p:nvSpPr>
            <p:cNvPr id="25" name="TextBox 24"/>
            <p:cNvSpPr txBox="1"/>
            <p:nvPr/>
          </p:nvSpPr>
          <p:spPr>
            <a:xfrm rot="16200000">
              <a:off x="-194137" y="4660733"/>
              <a:ext cx="998003" cy="215444"/>
            </a:xfrm>
            <a:prstGeom prst="rect">
              <a:avLst/>
            </a:prstGeom>
            <a:solidFill>
              <a:schemeClr val="bg1"/>
            </a:solidFill>
          </p:spPr>
          <p:txBody>
            <a:bodyPr wrap="square" rtlCol="0">
              <a:spAutoFit/>
            </a:bodyPr>
            <a:lstStyle/>
            <a:p>
              <a:pPr algn="r"/>
              <a:r>
                <a:rPr lang="en-US" sz="800" i="1" dirty="0">
                  <a:latin typeface="Arial" panose="020B0604020202020204" pitchFamily="34" charset="0"/>
                  <a:cs typeface="Arial" panose="020B0604020202020204" pitchFamily="34" charset="0"/>
                </a:rPr>
                <a:t>Chil1</a:t>
              </a:r>
              <a:r>
                <a:rPr lang="en-US" sz="800" dirty="0">
                  <a:latin typeface="Arial" panose="020B0604020202020204" pitchFamily="34" charset="0"/>
                  <a:cs typeface="Arial" panose="020B0604020202020204" pitchFamily="34" charset="0"/>
                </a:rPr>
                <a:t> (2^</a:t>
              </a:r>
              <a:r>
                <a:rPr lang="en-US" sz="800" baseline="30000" dirty="0">
                  <a:latin typeface="Arial" panose="020B0604020202020204" pitchFamily="34" charset="0"/>
                  <a:cs typeface="Arial" panose="020B0604020202020204" pitchFamily="34" charset="0"/>
                </a:rPr>
                <a:t>-∆CT</a:t>
              </a:r>
              <a:r>
                <a:rPr lang="en-US" sz="800" dirty="0">
                  <a:latin typeface="Arial" panose="020B0604020202020204" pitchFamily="34" charset="0"/>
                  <a:cs typeface="Arial" panose="020B0604020202020204" pitchFamily="34" charset="0"/>
                </a:rPr>
                <a:t>)</a:t>
              </a:r>
            </a:p>
          </p:txBody>
        </p:sp>
        <p:sp>
          <p:nvSpPr>
            <p:cNvPr id="27" name="TextBox 26"/>
            <p:cNvSpPr txBox="1"/>
            <p:nvPr/>
          </p:nvSpPr>
          <p:spPr>
            <a:xfrm>
              <a:off x="-1231" y="3745942"/>
              <a:ext cx="240565"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38" name="TextBox 37">
              <a:extLst>
                <a:ext uri="{FF2B5EF4-FFF2-40B4-BE49-F238E27FC236}">
                  <a16:creationId xmlns:a16="http://schemas.microsoft.com/office/drawing/2014/main" id="{9039B7B1-3364-4000-B763-D7285D45FBB4}"/>
                </a:ext>
              </a:extLst>
            </p:cNvPr>
            <p:cNvSpPr txBox="1"/>
            <p:nvPr/>
          </p:nvSpPr>
          <p:spPr>
            <a:xfrm>
              <a:off x="644896" y="5395230"/>
              <a:ext cx="557212" cy="215444"/>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39" name="TextBox 38">
              <a:extLst>
                <a:ext uri="{FF2B5EF4-FFF2-40B4-BE49-F238E27FC236}">
                  <a16:creationId xmlns:a16="http://schemas.microsoft.com/office/drawing/2014/main" id="{91D43808-ED4A-46CC-B774-0DFB2B33184C}"/>
                </a:ext>
              </a:extLst>
            </p:cNvPr>
            <p:cNvSpPr txBox="1"/>
            <p:nvPr/>
          </p:nvSpPr>
          <p:spPr>
            <a:xfrm>
              <a:off x="1202108" y="5389571"/>
              <a:ext cx="557212"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Lyz</a:t>
              </a:r>
              <a:endParaRPr lang="en-US" sz="800" baseline="30000" dirty="0">
                <a:latin typeface="Arial" panose="020B0604020202020204" pitchFamily="34" charset="0"/>
                <a:cs typeface="Arial" panose="020B0604020202020204" pitchFamily="34" charset="0"/>
              </a:endParaRPr>
            </a:p>
          </p:txBody>
        </p:sp>
      </p:grpSp>
      <p:grpSp>
        <p:nvGrpSpPr>
          <p:cNvPr id="4" name="Group 3">
            <a:extLst>
              <a:ext uri="{FF2B5EF4-FFF2-40B4-BE49-F238E27FC236}">
                <a16:creationId xmlns:a16="http://schemas.microsoft.com/office/drawing/2014/main" id="{2486A8E5-8EA6-4350-BB78-2B5719FC5DE0}"/>
              </a:ext>
            </a:extLst>
          </p:cNvPr>
          <p:cNvGrpSpPr/>
          <p:nvPr/>
        </p:nvGrpSpPr>
        <p:grpSpPr>
          <a:xfrm>
            <a:off x="0" y="-19948"/>
            <a:ext cx="6918627" cy="3735344"/>
            <a:chOff x="0" y="-19948"/>
            <a:chExt cx="6918627" cy="3735344"/>
          </a:xfrm>
        </p:grpSpPr>
        <p:grpSp>
          <p:nvGrpSpPr>
            <p:cNvPr id="12" name="Group 11"/>
            <p:cNvGrpSpPr/>
            <p:nvPr/>
          </p:nvGrpSpPr>
          <p:grpSpPr>
            <a:xfrm>
              <a:off x="5953438" y="568302"/>
              <a:ext cx="553105" cy="681033"/>
              <a:chOff x="1988927" y="1732468"/>
              <a:chExt cx="4072856" cy="4265552"/>
            </a:xfrm>
          </p:grpSpPr>
          <p:sp>
            <p:nvSpPr>
              <p:cNvPr id="13" name="Freeform 12"/>
              <p:cNvSpPr/>
              <p:nvPr/>
            </p:nvSpPr>
            <p:spPr>
              <a:xfrm>
                <a:off x="1988927" y="1732468"/>
                <a:ext cx="4072856" cy="4265552"/>
              </a:xfrm>
              <a:custGeom>
                <a:avLst/>
                <a:gdLst>
                  <a:gd name="connsiteX0" fmla="*/ 179179 w 4072856"/>
                  <a:gd name="connsiteY0" fmla="*/ 838204 h 4265552"/>
                  <a:gd name="connsiteX1" fmla="*/ 265443 w 4072856"/>
                  <a:gd name="connsiteY1" fmla="*/ 1384543 h 4265552"/>
                  <a:gd name="connsiteX2" fmla="*/ 213684 w 4072856"/>
                  <a:gd name="connsiteY2" fmla="*/ 2068906 h 4265552"/>
                  <a:gd name="connsiteX3" fmla="*/ 150424 w 4072856"/>
                  <a:gd name="connsiteY3" fmla="*/ 2655502 h 4265552"/>
                  <a:gd name="connsiteX4" fmla="*/ 58409 w 4072856"/>
                  <a:gd name="connsiteY4" fmla="*/ 3518143 h 4265552"/>
                  <a:gd name="connsiteX5" fmla="*/ 374711 w 4072856"/>
                  <a:gd name="connsiteY5" fmla="*/ 4214007 h 4265552"/>
                  <a:gd name="connsiteX6" fmla="*/ 1668673 w 4072856"/>
                  <a:gd name="connsiteY6" fmla="*/ 4214007 h 4265552"/>
                  <a:gd name="connsiteX7" fmla="*/ 3186922 w 4072856"/>
                  <a:gd name="connsiteY7" fmla="*/ 4208257 h 4265552"/>
                  <a:gd name="connsiteX8" fmla="*/ 4015058 w 4072856"/>
                  <a:gd name="connsiteY8" fmla="*/ 3707924 h 4265552"/>
                  <a:gd name="connsiteX9" fmla="*/ 3986303 w 4072856"/>
                  <a:gd name="connsiteY9" fmla="*/ 2189675 h 4265552"/>
                  <a:gd name="connsiteX10" fmla="*/ 3854031 w 4072856"/>
                  <a:gd name="connsiteY10" fmla="*/ 1258023 h 4265552"/>
                  <a:gd name="connsiteX11" fmla="*/ 4020809 w 4072856"/>
                  <a:gd name="connsiteY11" fmla="*/ 257358 h 4265552"/>
                  <a:gd name="connsiteX12" fmla="*/ 3842530 w 4072856"/>
                  <a:gd name="connsiteY12" fmla="*/ 107834 h 4265552"/>
                  <a:gd name="connsiteX13" fmla="*/ 3727511 w 4072856"/>
                  <a:gd name="connsiteY13" fmla="*/ 585162 h 4265552"/>
                  <a:gd name="connsiteX14" fmla="*/ 3675752 w 4072856"/>
                  <a:gd name="connsiteY14" fmla="*/ 1114249 h 4265552"/>
                  <a:gd name="connsiteX15" fmla="*/ 3503224 w 4072856"/>
                  <a:gd name="connsiteY15" fmla="*/ 1488060 h 4265552"/>
                  <a:gd name="connsiteX16" fmla="*/ 3296190 w 4072856"/>
                  <a:gd name="connsiteY16" fmla="*/ 1131502 h 4265552"/>
                  <a:gd name="connsiteX17" fmla="*/ 3422711 w 4072856"/>
                  <a:gd name="connsiteY17" fmla="*/ 533404 h 4265552"/>
                  <a:gd name="connsiteX18" fmla="*/ 3388205 w 4072856"/>
                  <a:gd name="connsiteY18" fmla="*/ 297615 h 4265552"/>
                  <a:gd name="connsiteX19" fmla="*/ 3232930 w 4072856"/>
                  <a:gd name="connsiteY19" fmla="*/ 113585 h 4265552"/>
                  <a:gd name="connsiteX20" fmla="*/ 3198424 w 4072856"/>
                  <a:gd name="connsiteY20" fmla="*/ 452890 h 4265552"/>
                  <a:gd name="connsiteX21" fmla="*/ 3135164 w 4072856"/>
                  <a:gd name="connsiteY21" fmla="*/ 815200 h 4265552"/>
                  <a:gd name="connsiteX22" fmla="*/ 3140915 w 4072856"/>
                  <a:gd name="connsiteY22" fmla="*/ 1212015 h 4265552"/>
                  <a:gd name="connsiteX23" fmla="*/ 3089156 w 4072856"/>
                  <a:gd name="connsiteY23" fmla="*/ 1488060 h 4265552"/>
                  <a:gd name="connsiteX24" fmla="*/ 2870620 w 4072856"/>
                  <a:gd name="connsiteY24" fmla="*/ 1373041 h 4265552"/>
                  <a:gd name="connsiteX25" fmla="*/ 2974137 w 4072856"/>
                  <a:gd name="connsiteY25" fmla="*/ 1016483 h 4265552"/>
                  <a:gd name="connsiteX26" fmla="*/ 2956884 w 4072856"/>
                  <a:gd name="connsiteY26" fmla="*/ 671426 h 4265552"/>
                  <a:gd name="connsiteX27" fmla="*/ 2905126 w 4072856"/>
                  <a:gd name="connsiteY27" fmla="*/ 332121 h 4265552"/>
                  <a:gd name="connsiteX28" fmla="*/ 2824613 w 4072856"/>
                  <a:gd name="connsiteY28" fmla="*/ 33072 h 4265552"/>
                  <a:gd name="connsiteX29" fmla="*/ 2755601 w 4072856"/>
                  <a:gd name="connsiteY29" fmla="*/ 194098 h 4265552"/>
                  <a:gd name="connsiteX30" fmla="*/ 2749850 w 4072856"/>
                  <a:gd name="connsiteY30" fmla="*/ 481645 h 4265552"/>
                  <a:gd name="connsiteX31" fmla="*/ 2738348 w 4072856"/>
                  <a:gd name="connsiteY31" fmla="*/ 976226 h 4265552"/>
                  <a:gd name="connsiteX32" fmla="*/ 2709594 w 4072856"/>
                  <a:gd name="connsiteY32" fmla="*/ 1298279 h 4265552"/>
                  <a:gd name="connsiteX33" fmla="*/ 2623330 w 4072856"/>
                  <a:gd name="connsiteY33" fmla="*/ 1488060 h 4265552"/>
                  <a:gd name="connsiteX34" fmla="*/ 2514062 w 4072856"/>
                  <a:gd name="connsiteY34" fmla="*/ 1286777 h 4265552"/>
                  <a:gd name="connsiteX35" fmla="*/ 2617579 w 4072856"/>
                  <a:gd name="connsiteY35" fmla="*/ 935970 h 4265552"/>
                  <a:gd name="connsiteX36" fmla="*/ 2629081 w 4072856"/>
                  <a:gd name="connsiteY36" fmla="*/ 556407 h 4265552"/>
                  <a:gd name="connsiteX37" fmla="*/ 2600326 w 4072856"/>
                  <a:gd name="connsiteY37" fmla="*/ 240106 h 4265552"/>
                  <a:gd name="connsiteX38" fmla="*/ 2502560 w 4072856"/>
                  <a:gd name="connsiteY38" fmla="*/ 67577 h 4265552"/>
                  <a:gd name="connsiteX39" fmla="*/ 2381790 w 4072856"/>
                  <a:gd name="connsiteY39" fmla="*/ 182596 h 4265552"/>
                  <a:gd name="connsiteX40" fmla="*/ 2335782 w 4072856"/>
                  <a:gd name="connsiteY40" fmla="*/ 458641 h 4265552"/>
                  <a:gd name="connsiteX41" fmla="*/ 2347284 w 4072856"/>
                  <a:gd name="connsiteY41" fmla="*/ 757690 h 4265552"/>
                  <a:gd name="connsiteX42" fmla="*/ 2347284 w 4072856"/>
                  <a:gd name="connsiteY42" fmla="*/ 1039487 h 4265552"/>
                  <a:gd name="connsiteX43" fmla="*/ 2358786 w 4072856"/>
                  <a:gd name="connsiteY43" fmla="*/ 1229268 h 4265552"/>
                  <a:gd name="connsiteX44" fmla="*/ 2312779 w 4072856"/>
                  <a:gd name="connsiteY44" fmla="*/ 1442053 h 4265552"/>
                  <a:gd name="connsiteX45" fmla="*/ 2065488 w 4072856"/>
                  <a:gd name="connsiteY45" fmla="*/ 1424800 h 4265552"/>
                  <a:gd name="connsiteX46" fmla="*/ 2122998 w 4072856"/>
                  <a:gd name="connsiteY46" fmla="*/ 1010732 h 4265552"/>
                  <a:gd name="connsiteX47" fmla="*/ 2117247 w 4072856"/>
                  <a:gd name="connsiteY47" fmla="*/ 602415 h 4265552"/>
                  <a:gd name="connsiteX48" fmla="*/ 2134499 w 4072856"/>
                  <a:gd name="connsiteY48" fmla="*/ 199849 h 4265552"/>
                  <a:gd name="connsiteX49" fmla="*/ 2042484 w 4072856"/>
                  <a:gd name="connsiteY49" fmla="*/ 33072 h 4265552"/>
                  <a:gd name="connsiteX50" fmla="*/ 1904462 w 4072856"/>
                  <a:gd name="connsiteY50" fmla="*/ 96332 h 4265552"/>
                  <a:gd name="connsiteX51" fmla="*/ 1898711 w 4072856"/>
                  <a:gd name="connsiteY51" fmla="*/ 429887 h 4265552"/>
                  <a:gd name="connsiteX52" fmla="*/ 1898711 w 4072856"/>
                  <a:gd name="connsiteY52" fmla="*/ 734687 h 4265552"/>
                  <a:gd name="connsiteX53" fmla="*/ 1898711 w 4072856"/>
                  <a:gd name="connsiteY53" fmla="*/ 1114249 h 4265552"/>
                  <a:gd name="connsiteX54" fmla="*/ 1772190 w 4072856"/>
                  <a:gd name="connsiteY54" fmla="*/ 1367290 h 4265552"/>
                  <a:gd name="connsiteX55" fmla="*/ 1697428 w 4072856"/>
                  <a:gd name="connsiteY55" fmla="*/ 1246521 h 4265552"/>
                  <a:gd name="connsiteX56" fmla="*/ 1708930 w 4072856"/>
                  <a:gd name="connsiteY56" fmla="*/ 993479 h 4265552"/>
                  <a:gd name="connsiteX57" fmla="*/ 1708930 w 4072856"/>
                  <a:gd name="connsiteY57" fmla="*/ 619668 h 4265552"/>
                  <a:gd name="connsiteX58" fmla="*/ 1720431 w 4072856"/>
                  <a:gd name="connsiteY58" fmla="*/ 303366 h 4265552"/>
                  <a:gd name="connsiteX59" fmla="*/ 1628416 w 4072856"/>
                  <a:gd name="connsiteY59" fmla="*/ 73328 h 4265552"/>
                  <a:gd name="connsiteX60" fmla="*/ 1478892 w 4072856"/>
                  <a:gd name="connsiteY60" fmla="*/ 90581 h 4265552"/>
                  <a:gd name="connsiteX61" fmla="*/ 1421382 w 4072856"/>
                  <a:gd name="connsiteY61" fmla="*/ 493147 h 4265552"/>
                  <a:gd name="connsiteX62" fmla="*/ 1398379 w 4072856"/>
                  <a:gd name="connsiteY62" fmla="*/ 907215 h 4265552"/>
                  <a:gd name="connsiteX63" fmla="*/ 1392628 w 4072856"/>
                  <a:gd name="connsiteY63" fmla="*/ 1304030 h 4265552"/>
                  <a:gd name="connsiteX64" fmla="*/ 1306364 w 4072856"/>
                  <a:gd name="connsiteY64" fmla="*/ 1447804 h 4265552"/>
                  <a:gd name="connsiteX65" fmla="*/ 1082077 w 4072856"/>
                  <a:gd name="connsiteY65" fmla="*/ 1223517 h 4265552"/>
                  <a:gd name="connsiteX66" fmla="*/ 1122333 w 4072856"/>
                  <a:gd name="connsiteY66" fmla="*/ 1045238 h 4265552"/>
                  <a:gd name="connsiteX67" fmla="*/ 1231601 w 4072856"/>
                  <a:gd name="connsiteY67" fmla="*/ 602415 h 4265552"/>
                  <a:gd name="connsiteX68" fmla="*/ 1237352 w 4072856"/>
                  <a:gd name="connsiteY68" fmla="*/ 314868 h 4265552"/>
                  <a:gd name="connsiteX69" fmla="*/ 1110831 w 4072856"/>
                  <a:gd name="connsiteY69" fmla="*/ 148090 h 4265552"/>
                  <a:gd name="connsiteX70" fmla="*/ 915299 w 4072856"/>
                  <a:gd name="connsiteY70" fmla="*/ 320619 h 4265552"/>
                  <a:gd name="connsiteX71" fmla="*/ 898047 w 4072856"/>
                  <a:gd name="connsiteY71" fmla="*/ 613917 h 4265552"/>
                  <a:gd name="connsiteX72" fmla="*/ 880794 w 4072856"/>
                  <a:gd name="connsiteY72" fmla="*/ 889962 h 4265552"/>
                  <a:gd name="connsiteX73" fmla="*/ 915299 w 4072856"/>
                  <a:gd name="connsiteY73" fmla="*/ 1085494 h 4265552"/>
                  <a:gd name="connsiteX74" fmla="*/ 909548 w 4072856"/>
                  <a:gd name="connsiteY74" fmla="*/ 1315532 h 4265552"/>
                  <a:gd name="connsiteX75" fmla="*/ 800281 w 4072856"/>
                  <a:gd name="connsiteY75" fmla="*/ 1407547 h 4265552"/>
                  <a:gd name="connsiteX76" fmla="*/ 656507 w 4072856"/>
                  <a:gd name="connsiteY76" fmla="*/ 1131502 h 4265552"/>
                  <a:gd name="connsiteX77" fmla="*/ 673760 w 4072856"/>
                  <a:gd name="connsiteY77" fmla="*/ 958974 h 4265552"/>
                  <a:gd name="connsiteX78" fmla="*/ 748522 w 4072856"/>
                  <a:gd name="connsiteY78" fmla="*/ 590913 h 4265552"/>
                  <a:gd name="connsiteX79" fmla="*/ 771526 w 4072856"/>
                  <a:gd name="connsiteY79" fmla="*/ 194098 h 4265552"/>
                  <a:gd name="connsiteX80" fmla="*/ 627752 w 4072856"/>
                  <a:gd name="connsiteY80" fmla="*/ 73328 h 4265552"/>
                  <a:gd name="connsiteX81" fmla="*/ 495481 w 4072856"/>
                  <a:gd name="connsiteY81" fmla="*/ 228604 h 4265552"/>
                  <a:gd name="connsiteX82" fmla="*/ 420718 w 4072856"/>
                  <a:gd name="connsiteY82" fmla="*/ 562158 h 4265552"/>
                  <a:gd name="connsiteX83" fmla="*/ 455224 w 4072856"/>
                  <a:gd name="connsiteY83" fmla="*/ 981977 h 4265552"/>
                  <a:gd name="connsiteX84" fmla="*/ 558741 w 4072856"/>
                  <a:gd name="connsiteY84" fmla="*/ 1309781 h 4265552"/>
                  <a:gd name="connsiteX85" fmla="*/ 432220 w 4072856"/>
                  <a:gd name="connsiteY85" fmla="*/ 1315532 h 4265552"/>
                  <a:gd name="connsiteX86" fmla="*/ 363209 w 4072856"/>
                  <a:gd name="connsiteY86" fmla="*/ 999230 h 4265552"/>
                  <a:gd name="connsiteX87" fmla="*/ 380462 w 4072856"/>
                  <a:gd name="connsiteY87" fmla="*/ 533404 h 4265552"/>
                  <a:gd name="connsiteX88" fmla="*/ 397715 w 4072856"/>
                  <a:gd name="connsiteY88" fmla="*/ 113585 h 4265552"/>
                  <a:gd name="connsiteX89" fmla="*/ 202182 w 4072856"/>
                  <a:gd name="connsiteY89" fmla="*/ 15819 h 4265552"/>
                  <a:gd name="connsiteX90" fmla="*/ 6650 w 4072856"/>
                  <a:gd name="connsiteY90" fmla="*/ 38823 h 4265552"/>
                  <a:gd name="connsiteX91" fmla="*/ 52658 w 4072856"/>
                  <a:gd name="connsiteY91" fmla="*/ 378128 h 4265552"/>
                  <a:gd name="connsiteX92" fmla="*/ 121669 w 4072856"/>
                  <a:gd name="connsiteY92" fmla="*/ 717434 h 4265552"/>
                  <a:gd name="connsiteX93" fmla="*/ 179179 w 4072856"/>
                  <a:gd name="connsiteY93" fmla="*/ 838204 h 42655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Lst>
                <a:rect l="l" t="t" r="r" b="b"/>
                <a:pathLst>
                  <a:path w="4072856" h="4265552">
                    <a:moveTo>
                      <a:pt x="179179" y="838204"/>
                    </a:moveTo>
                    <a:cubicBezTo>
                      <a:pt x="203141" y="949389"/>
                      <a:pt x="259692" y="1179426"/>
                      <a:pt x="265443" y="1384543"/>
                    </a:cubicBezTo>
                    <a:cubicBezTo>
                      <a:pt x="271194" y="1589660"/>
                      <a:pt x="232854" y="1857080"/>
                      <a:pt x="213684" y="2068906"/>
                    </a:cubicBezTo>
                    <a:cubicBezTo>
                      <a:pt x="194514" y="2280733"/>
                      <a:pt x="176303" y="2413963"/>
                      <a:pt x="150424" y="2655502"/>
                    </a:cubicBezTo>
                    <a:cubicBezTo>
                      <a:pt x="124545" y="2897042"/>
                      <a:pt x="21028" y="3258392"/>
                      <a:pt x="58409" y="3518143"/>
                    </a:cubicBezTo>
                    <a:cubicBezTo>
                      <a:pt x="95790" y="3777894"/>
                      <a:pt x="106334" y="4098030"/>
                      <a:pt x="374711" y="4214007"/>
                    </a:cubicBezTo>
                    <a:cubicBezTo>
                      <a:pt x="643088" y="4329984"/>
                      <a:pt x="1668673" y="4214007"/>
                      <a:pt x="1668673" y="4214007"/>
                    </a:cubicBezTo>
                    <a:cubicBezTo>
                      <a:pt x="2137375" y="4213049"/>
                      <a:pt x="2795858" y="4292604"/>
                      <a:pt x="3186922" y="4208257"/>
                    </a:cubicBezTo>
                    <a:cubicBezTo>
                      <a:pt x="3577986" y="4123910"/>
                      <a:pt x="3881828" y="4044354"/>
                      <a:pt x="4015058" y="3707924"/>
                    </a:cubicBezTo>
                    <a:cubicBezTo>
                      <a:pt x="4148288" y="3371494"/>
                      <a:pt x="4013141" y="2597992"/>
                      <a:pt x="3986303" y="2189675"/>
                    </a:cubicBezTo>
                    <a:cubicBezTo>
                      <a:pt x="3959465" y="1781358"/>
                      <a:pt x="3848280" y="1580076"/>
                      <a:pt x="3854031" y="1258023"/>
                    </a:cubicBezTo>
                    <a:cubicBezTo>
                      <a:pt x="3859782" y="935970"/>
                      <a:pt x="4022726" y="449056"/>
                      <a:pt x="4020809" y="257358"/>
                    </a:cubicBezTo>
                    <a:cubicBezTo>
                      <a:pt x="4018892" y="65660"/>
                      <a:pt x="3891413" y="53200"/>
                      <a:pt x="3842530" y="107834"/>
                    </a:cubicBezTo>
                    <a:cubicBezTo>
                      <a:pt x="3793647" y="162468"/>
                      <a:pt x="3755307" y="417426"/>
                      <a:pt x="3727511" y="585162"/>
                    </a:cubicBezTo>
                    <a:cubicBezTo>
                      <a:pt x="3699715" y="752898"/>
                      <a:pt x="3713133" y="963766"/>
                      <a:pt x="3675752" y="1114249"/>
                    </a:cubicBezTo>
                    <a:cubicBezTo>
                      <a:pt x="3638371" y="1264732"/>
                      <a:pt x="3566484" y="1485185"/>
                      <a:pt x="3503224" y="1488060"/>
                    </a:cubicBezTo>
                    <a:cubicBezTo>
                      <a:pt x="3439964" y="1490935"/>
                      <a:pt x="3309609" y="1290611"/>
                      <a:pt x="3296190" y="1131502"/>
                    </a:cubicBezTo>
                    <a:cubicBezTo>
                      <a:pt x="3282771" y="972393"/>
                      <a:pt x="3407375" y="672385"/>
                      <a:pt x="3422711" y="533404"/>
                    </a:cubicBezTo>
                    <a:cubicBezTo>
                      <a:pt x="3438047" y="394423"/>
                      <a:pt x="3419835" y="367585"/>
                      <a:pt x="3388205" y="297615"/>
                    </a:cubicBezTo>
                    <a:cubicBezTo>
                      <a:pt x="3356575" y="227645"/>
                      <a:pt x="3264560" y="87706"/>
                      <a:pt x="3232930" y="113585"/>
                    </a:cubicBezTo>
                    <a:cubicBezTo>
                      <a:pt x="3201300" y="139464"/>
                      <a:pt x="3214718" y="335954"/>
                      <a:pt x="3198424" y="452890"/>
                    </a:cubicBezTo>
                    <a:cubicBezTo>
                      <a:pt x="3182130" y="569826"/>
                      <a:pt x="3144749" y="688679"/>
                      <a:pt x="3135164" y="815200"/>
                    </a:cubicBezTo>
                    <a:cubicBezTo>
                      <a:pt x="3125579" y="941721"/>
                      <a:pt x="3148583" y="1099872"/>
                      <a:pt x="3140915" y="1212015"/>
                    </a:cubicBezTo>
                    <a:cubicBezTo>
                      <a:pt x="3133247" y="1324158"/>
                      <a:pt x="3134205" y="1461222"/>
                      <a:pt x="3089156" y="1488060"/>
                    </a:cubicBezTo>
                    <a:cubicBezTo>
                      <a:pt x="3044107" y="1514898"/>
                      <a:pt x="2889790" y="1451637"/>
                      <a:pt x="2870620" y="1373041"/>
                    </a:cubicBezTo>
                    <a:cubicBezTo>
                      <a:pt x="2851450" y="1294445"/>
                      <a:pt x="2959760" y="1133419"/>
                      <a:pt x="2974137" y="1016483"/>
                    </a:cubicBezTo>
                    <a:cubicBezTo>
                      <a:pt x="2988514" y="899547"/>
                      <a:pt x="2968386" y="785486"/>
                      <a:pt x="2956884" y="671426"/>
                    </a:cubicBezTo>
                    <a:cubicBezTo>
                      <a:pt x="2945382" y="557366"/>
                      <a:pt x="2927171" y="438513"/>
                      <a:pt x="2905126" y="332121"/>
                    </a:cubicBezTo>
                    <a:cubicBezTo>
                      <a:pt x="2883081" y="225729"/>
                      <a:pt x="2849534" y="56076"/>
                      <a:pt x="2824613" y="33072"/>
                    </a:cubicBezTo>
                    <a:cubicBezTo>
                      <a:pt x="2799692" y="10068"/>
                      <a:pt x="2768061" y="119336"/>
                      <a:pt x="2755601" y="194098"/>
                    </a:cubicBezTo>
                    <a:cubicBezTo>
                      <a:pt x="2743141" y="268860"/>
                      <a:pt x="2752726" y="351290"/>
                      <a:pt x="2749850" y="481645"/>
                    </a:cubicBezTo>
                    <a:cubicBezTo>
                      <a:pt x="2746975" y="612000"/>
                      <a:pt x="2745057" y="840120"/>
                      <a:pt x="2738348" y="976226"/>
                    </a:cubicBezTo>
                    <a:cubicBezTo>
                      <a:pt x="2731639" y="1112332"/>
                      <a:pt x="2728764" y="1212973"/>
                      <a:pt x="2709594" y="1298279"/>
                    </a:cubicBezTo>
                    <a:cubicBezTo>
                      <a:pt x="2690424" y="1383585"/>
                      <a:pt x="2655919" y="1489977"/>
                      <a:pt x="2623330" y="1488060"/>
                    </a:cubicBezTo>
                    <a:cubicBezTo>
                      <a:pt x="2590741" y="1486143"/>
                      <a:pt x="2515021" y="1378792"/>
                      <a:pt x="2514062" y="1286777"/>
                    </a:cubicBezTo>
                    <a:cubicBezTo>
                      <a:pt x="2513104" y="1194762"/>
                      <a:pt x="2598409" y="1057698"/>
                      <a:pt x="2617579" y="935970"/>
                    </a:cubicBezTo>
                    <a:cubicBezTo>
                      <a:pt x="2636749" y="814242"/>
                      <a:pt x="2631957" y="672384"/>
                      <a:pt x="2629081" y="556407"/>
                    </a:cubicBezTo>
                    <a:cubicBezTo>
                      <a:pt x="2626205" y="440430"/>
                      <a:pt x="2621413" y="321578"/>
                      <a:pt x="2600326" y="240106"/>
                    </a:cubicBezTo>
                    <a:cubicBezTo>
                      <a:pt x="2579239" y="158634"/>
                      <a:pt x="2538983" y="77162"/>
                      <a:pt x="2502560" y="67577"/>
                    </a:cubicBezTo>
                    <a:cubicBezTo>
                      <a:pt x="2466137" y="57992"/>
                      <a:pt x="2409586" y="117419"/>
                      <a:pt x="2381790" y="182596"/>
                    </a:cubicBezTo>
                    <a:cubicBezTo>
                      <a:pt x="2353994" y="247773"/>
                      <a:pt x="2341533" y="362792"/>
                      <a:pt x="2335782" y="458641"/>
                    </a:cubicBezTo>
                    <a:cubicBezTo>
                      <a:pt x="2330031" y="554490"/>
                      <a:pt x="2345367" y="660882"/>
                      <a:pt x="2347284" y="757690"/>
                    </a:cubicBezTo>
                    <a:cubicBezTo>
                      <a:pt x="2349201" y="854498"/>
                      <a:pt x="2345367" y="960891"/>
                      <a:pt x="2347284" y="1039487"/>
                    </a:cubicBezTo>
                    <a:cubicBezTo>
                      <a:pt x="2349201" y="1118083"/>
                      <a:pt x="2364537" y="1162174"/>
                      <a:pt x="2358786" y="1229268"/>
                    </a:cubicBezTo>
                    <a:cubicBezTo>
                      <a:pt x="2353035" y="1296362"/>
                      <a:pt x="2361662" y="1409464"/>
                      <a:pt x="2312779" y="1442053"/>
                    </a:cubicBezTo>
                    <a:cubicBezTo>
                      <a:pt x="2263896" y="1474642"/>
                      <a:pt x="2097118" y="1496687"/>
                      <a:pt x="2065488" y="1424800"/>
                    </a:cubicBezTo>
                    <a:cubicBezTo>
                      <a:pt x="2033858" y="1352913"/>
                      <a:pt x="2114372" y="1147796"/>
                      <a:pt x="2122998" y="1010732"/>
                    </a:cubicBezTo>
                    <a:cubicBezTo>
                      <a:pt x="2131624" y="873668"/>
                      <a:pt x="2115330" y="737562"/>
                      <a:pt x="2117247" y="602415"/>
                    </a:cubicBezTo>
                    <a:cubicBezTo>
                      <a:pt x="2119164" y="467268"/>
                      <a:pt x="2146960" y="294740"/>
                      <a:pt x="2134499" y="199849"/>
                    </a:cubicBezTo>
                    <a:cubicBezTo>
                      <a:pt x="2122038" y="104958"/>
                      <a:pt x="2080823" y="50325"/>
                      <a:pt x="2042484" y="33072"/>
                    </a:cubicBezTo>
                    <a:cubicBezTo>
                      <a:pt x="2004145" y="15819"/>
                      <a:pt x="1928424" y="30196"/>
                      <a:pt x="1904462" y="96332"/>
                    </a:cubicBezTo>
                    <a:cubicBezTo>
                      <a:pt x="1880500" y="162468"/>
                      <a:pt x="1899669" y="323495"/>
                      <a:pt x="1898711" y="429887"/>
                    </a:cubicBezTo>
                    <a:cubicBezTo>
                      <a:pt x="1897753" y="536279"/>
                      <a:pt x="1898711" y="734687"/>
                      <a:pt x="1898711" y="734687"/>
                    </a:cubicBezTo>
                    <a:cubicBezTo>
                      <a:pt x="1898711" y="848747"/>
                      <a:pt x="1919798" y="1008815"/>
                      <a:pt x="1898711" y="1114249"/>
                    </a:cubicBezTo>
                    <a:cubicBezTo>
                      <a:pt x="1877624" y="1219683"/>
                      <a:pt x="1805737" y="1345245"/>
                      <a:pt x="1772190" y="1367290"/>
                    </a:cubicBezTo>
                    <a:cubicBezTo>
                      <a:pt x="1738643" y="1389335"/>
                      <a:pt x="1707971" y="1308823"/>
                      <a:pt x="1697428" y="1246521"/>
                    </a:cubicBezTo>
                    <a:cubicBezTo>
                      <a:pt x="1686885" y="1184219"/>
                      <a:pt x="1707013" y="1097954"/>
                      <a:pt x="1708930" y="993479"/>
                    </a:cubicBezTo>
                    <a:cubicBezTo>
                      <a:pt x="1710847" y="889004"/>
                      <a:pt x="1707013" y="734687"/>
                      <a:pt x="1708930" y="619668"/>
                    </a:cubicBezTo>
                    <a:cubicBezTo>
                      <a:pt x="1710847" y="504649"/>
                      <a:pt x="1733850" y="394423"/>
                      <a:pt x="1720431" y="303366"/>
                    </a:cubicBezTo>
                    <a:cubicBezTo>
                      <a:pt x="1707012" y="212309"/>
                      <a:pt x="1668672" y="108792"/>
                      <a:pt x="1628416" y="73328"/>
                    </a:cubicBezTo>
                    <a:cubicBezTo>
                      <a:pt x="1588160" y="37864"/>
                      <a:pt x="1513398" y="20611"/>
                      <a:pt x="1478892" y="90581"/>
                    </a:cubicBezTo>
                    <a:cubicBezTo>
                      <a:pt x="1444386" y="160551"/>
                      <a:pt x="1434801" y="357041"/>
                      <a:pt x="1421382" y="493147"/>
                    </a:cubicBezTo>
                    <a:cubicBezTo>
                      <a:pt x="1407963" y="629253"/>
                      <a:pt x="1403171" y="772068"/>
                      <a:pt x="1398379" y="907215"/>
                    </a:cubicBezTo>
                    <a:cubicBezTo>
                      <a:pt x="1393587" y="1042362"/>
                      <a:pt x="1407964" y="1213932"/>
                      <a:pt x="1392628" y="1304030"/>
                    </a:cubicBezTo>
                    <a:cubicBezTo>
                      <a:pt x="1377292" y="1394128"/>
                      <a:pt x="1358122" y="1461223"/>
                      <a:pt x="1306364" y="1447804"/>
                    </a:cubicBezTo>
                    <a:cubicBezTo>
                      <a:pt x="1254606" y="1434385"/>
                      <a:pt x="1112749" y="1290611"/>
                      <a:pt x="1082077" y="1223517"/>
                    </a:cubicBezTo>
                    <a:cubicBezTo>
                      <a:pt x="1051405" y="1156423"/>
                      <a:pt x="1097412" y="1148755"/>
                      <a:pt x="1122333" y="1045238"/>
                    </a:cubicBezTo>
                    <a:cubicBezTo>
                      <a:pt x="1147254" y="941721"/>
                      <a:pt x="1212431" y="724143"/>
                      <a:pt x="1231601" y="602415"/>
                    </a:cubicBezTo>
                    <a:cubicBezTo>
                      <a:pt x="1250771" y="480687"/>
                      <a:pt x="1257480" y="390589"/>
                      <a:pt x="1237352" y="314868"/>
                    </a:cubicBezTo>
                    <a:cubicBezTo>
                      <a:pt x="1217224" y="239147"/>
                      <a:pt x="1164506" y="147132"/>
                      <a:pt x="1110831" y="148090"/>
                    </a:cubicBezTo>
                    <a:cubicBezTo>
                      <a:pt x="1057156" y="149048"/>
                      <a:pt x="950763" y="242981"/>
                      <a:pt x="915299" y="320619"/>
                    </a:cubicBezTo>
                    <a:cubicBezTo>
                      <a:pt x="879835" y="398257"/>
                      <a:pt x="903798" y="519027"/>
                      <a:pt x="898047" y="613917"/>
                    </a:cubicBezTo>
                    <a:cubicBezTo>
                      <a:pt x="892296" y="708807"/>
                      <a:pt x="877919" y="811366"/>
                      <a:pt x="880794" y="889962"/>
                    </a:cubicBezTo>
                    <a:cubicBezTo>
                      <a:pt x="883669" y="968558"/>
                      <a:pt x="910507" y="1014566"/>
                      <a:pt x="915299" y="1085494"/>
                    </a:cubicBezTo>
                    <a:cubicBezTo>
                      <a:pt x="920091" y="1156422"/>
                      <a:pt x="928718" y="1261857"/>
                      <a:pt x="909548" y="1315532"/>
                    </a:cubicBezTo>
                    <a:cubicBezTo>
                      <a:pt x="890378" y="1369207"/>
                      <a:pt x="842455" y="1438219"/>
                      <a:pt x="800281" y="1407547"/>
                    </a:cubicBezTo>
                    <a:cubicBezTo>
                      <a:pt x="758107" y="1376875"/>
                      <a:pt x="677594" y="1206264"/>
                      <a:pt x="656507" y="1131502"/>
                    </a:cubicBezTo>
                    <a:cubicBezTo>
                      <a:pt x="635420" y="1056740"/>
                      <a:pt x="658424" y="1049072"/>
                      <a:pt x="673760" y="958974"/>
                    </a:cubicBezTo>
                    <a:cubicBezTo>
                      <a:pt x="689096" y="868876"/>
                      <a:pt x="732228" y="718392"/>
                      <a:pt x="748522" y="590913"/>
                    </a:cubicBezTo>
                    <a:cubicBezTo>
                      <a:pt x="764816" y="463434"/>
                      <a:pt x="791654" y="280362"/>
                      <a:pt x="771526" y="194098"/>
                    </a:cubicBezTo>
                    <a:cubicBezTo>
                      <a:pt x="751398" y="107834"/>
                      <a:pt x="673760" y="67577"/>
                      <a:pt x="627752" y="73328"/>
                    </a:cubicBezTo>
                    <a:cubicBezTo>
                      <a:pt x="581745" y="79079"/>
                      <a:pt x="529987" y="147132"/>
                      <a:pt x="495481" y="228604"/>
                    </a:cubicBezTo>
                    <a:cubicBezTo>
                      <a:pt x="460975" y="310076"/>
                      <a:pt x="427427" y="436596"/>
                      <a:pt x="420718" y="562158"/>
                    </a:cubicBezTo>
                    <a:cubicBezTo>
                      <a:pt x="414009" y="687720"/>
                      <a:pt x="432220" y="857373"/>
                      <a:pt x="455224" y="981977"/>
                    </a:cubicBezTo>
                    <a:cubicBezTo>
                      <a:pt x="478228" y="1106581"/>
                      <a:pt x="562575" y="1254189"/>
                      <a:pt x="558741" y="1309781"/>
                    </a:cubicBezTo>
                    <a:cubicBezTo>
                      <a:pt x="554907" y="1365373"/>
                      <a:pt x="464809" y="1367290"/>
                      <a:pt x="432220" y="1315532"/>
                    </a:cubicBezTo>
                    <a:cubicBezTo>
                      <a:pt x="399631" y="1263774"/>
                      <a:pt x="371835" y="1129585"/>
                      <a:pt x="363209" y="999230"/>
                    </a:cubicBezTo>
                    <a:cubicBezTo>
                      <a:pt x="354583" y="868875"/>
                      <a:pt x="374711" y="681011"/>
                      <a:pt x="380462" y="533404"/>
                    </a:cubicBezTo>
                    <a:cubicBezTo>
                      <a:pt x="386213" y="385797"/>
                      <a:pt x="427428" y="199849"/>
                      <a:pt x="397715" y="113585"/>
                    </a:cubicBezTo>
                    <a:cubicBezTo>
                      <a:pt x="368002" y="27321"/>
                      <a:pt x="267360" y="28279"/>
                      <a:pt x="202182" y="15819"/>
                    </a:cubicBezTo>
                    <a:cubicBezTo>
                      <a:pt x="137004" y="3359"/>
                      <a:pt x="31571" y="-21562"/>
                      <a:pt x="6650" y="38823"/>
                    </a:cubicBezTo>
                    <a:cubicBezTo>
                      <a:pt x="-18271" y="99208"/>
                      <a:pt x="33488" y="265026"/>
                      <a:pt x="52658" y="378128"/>
                    </a:cubicBezTo>
                    <a:cubicBezTo>
                      <a:pt x="71828" y="491230"/>
                      <a:pt x="100582" y="637879"/>
                      <a:pt x="121669" y="717434"/>
                    </a:cubicBezTo>
                    <a:cubicBezTo>
                      <a:pt x="142756" y="796989"/>
                      <a:pt x="155217" y="727019"/>
                      <a:pt x="179179" y="838204"/>
                    </a:cubicBezTo>
                    <a:close/>
                  </a:path>
                </a:pathLst>
              </a:custGeom>
              <a:solidFill>
                <a:schemeClr val="accent2">
                  <a:lumMod val="20000"/>
                  <a:lumOff val="80000"/>
                </a:schemeClr>
              </a:solid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75631" tIns="37816" rIns="75631" bIns="37816" numCol="1" spcCol="0" rtlCol="0" fromWordArt="0" anchor="ctr" anchorCtr="0" forceAA="0" compatLnSpc="1">
                <a:prstTxWarp prst="textNoShape">
                  <a:avLst/>
                </a:prstTxWarp>
                <a:noAutofit/>
              </a:bodyPr>
              <a:lstStyle/>
              <a:p>
                <a:pPr algn="ctr"/>
                <a:endParaRPr lang="en-US" sz="1489"/>
              </a:p>
            </p:txBody>
          </p:sp>
          <p:sp>
            <p:nvSpPr>
              <p:cNvPr id="14" name="Oval 13"/>
              <p:cNvSpPr/>
              <p:nvPr/>
            </p:nvSpPr>
            <p:spPr>
              <a:xfrm>
                <a:off x="2513162" y="4638301"/>
                <a:ext cx="1734421" cy="1016634"/>
              </a:xfrm>
              <a:prstGeom prst="ellipse">
                <a:avLst/>
              </a:prstGeom>
              <a:solidFill>
                <a:schemeClr val="accent1">
                  <a:lumMod val="5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75631" tIns="37816" rIns="75631" bIns="37816" numCol="1" spcCol="0" rtlCol="0" fromWordArt="0" anchor="ctr" anchorCtr="0" forceAA="0" compatLnSpc="1">
                <a:prstTxWarp prst="textNoShape">
                  <a:avLst/>
                </a:prstTxWarp>
                <a:noAutofit/>
              </a:bodyPr>
              <a:lstStyle/>
              <a:p>
                <a:pPr algn="ctr"/>
                <a:endParaRPr lang="en-US" sz="1489"/>
              </a:p>
            </p:txBody>
          </p:sp>
        </p:grpSp>
        <p:grpSp>
          <p:nvGrpSpPr>
            <p:cNvPr id="15" name="Group 14"/>
            <p:cNvGrpSpPr/>
            <p:nvPr/>
          </p:nvGrpSpPr>
          <p:grpSpPr>
            <a:xfrm>
              <a:off x="5833132" y="1834430"/>
              <a:ext cx="793716" cy="859502"/>
              <a:chOff x="674165" y="1137449"/>
              <a:chExt cx="4238978" cy="3932395"/>
            </a:xfrm>
          </p:grpSpPr>
          <p:sp>
            <p:nvSpPr>
              <p:cNvPr id="16" name="Freeform 15"/>
              <p:cNvSpPr/>
              <p:nvPr/>
            </p:nvSpPr>
            <p:spPr>
              <a:xfrm>
                <a:off x="674165" y="1137449"/>
                <a:ext cx="4238978" cy="3932395"/>
              </a:xfrm>
              <a:custGeom>
                <a:avLst/>
                <a:gdLst>
                  <a:gd name="connsiteX0" fmla="*/ 832463 w 4238978"/>
                  <a:gd name="connsiteY0" fmla="*/ 1477830 h 3932395"/>
                  <a:gd name="connsiteX1" fmla="*/ 931957 w 4238978"/>
                  <a:gd name="connsiteY1" fmla="*/ 1520470 h 3932395"/>
                  <a:gd name="connsiteX2" fmla="*/ 1036189 w 4238978"/>
                  <a:gd name="connsiteY2" fmla="*/ 1492043 h 3932395"/>
                  <a:gd name="connsiteX3" fmla="*/ 988811 w 4238978"/>
                  <a:gd name="connsiteY3" fmla="*/ 1378335 h 3932395"/>
                  <a:gd name="connsiteX4" fmla="*/ 894055 w 4238978"/>
                  <a:gd name="connsiteY4" fmla="*/ 1307268 h 3932395"/>
                  <a:gd name="connsiteX5" fmla="*/ 799298 w 4238978"/>
                  <a:gd name="connsiteY5" fmla="*/ 1207774 h 3932395"/>
                  <a:gd name="connsiteX6" fmla="*/ 747182 w 4238978"/>
                  <a:gd name="connsiteY6" fmla="*/ 1084590 h 3932395"/>
                  <a:gd name="connsiteX7" fmla="*/ 822987 w 4238978"/>
                  <a:gd name="connsiteY7" fmla="*/ 1004047 h 3932395"/>
                  <a:gd name="connsiteX8" fmla="*/ 913006 w 4238978"/>
                  <a:gd name="connsiteY8" fmla="*/ 1079853 h 3932395"/>
                  <a:gd name="connsiteX9" fmla="*/ 1083568 w 4238978"/>
                  <a:gd name="connsiteY9" fmla="*/ 1117755 h 3932395"/>
                  <a:gd name="connsiteX10" fmla="*/ 1116732 w 4238978"/>
                  <a:gd name="connsiteY10" fmla="*/ 980358 h 3932395"/>
                  <a:gd name="connsiteX11" fmla="*/ 969860 w 4238978"/>
                  <a:gd name="connsiteY11" fmla="*/ 880864 h 3932395"/>
                  <a:gd name="connsiteX12" fmla="*/ 794560 w 4238978"/>
                  <a:gd name="connsiteY12" fmla="*/ 700827 h 3932395"/>
                  <a:gd name="connsiteX13" fmla="*/ 837201 w 4238978"/>
                  <a:gd name="connsiteY13" fmla="*/ 549216 h 3932395"/>
                  <a:gd name="connsiteX14" fmla="*/ 979336 w 4238978"/>
                  <a:gd name="connsiteY14" fmla="*/ 492362 h 3932395"/>
                  <a:gd name="connsiteX15" fmla="*/ 1159373 w 4238978"/>
                  <a:gd name="connsiteY15" fmla="*/ 582381 h 3932395"/>
                  <a:gd name="connsiteX16" fmla="*/ 1292032 w 4238978"/>
                  <a:gd name="connsiteY16" fmla="*/ 691351 h 3932395"/>
                  <a:gd name="connsiteX17" fmla="*/ 1434167 w 4238978"/>
                  <a:gd name="connsiteY17" fmla="*/ 814534 h 3932395"/>
                  <a:gd name="connsiteX18" fmla="*/ 1595253 w 4238978"/>
                  <a:gd name="connsiteY18" fmla="*/ 914029 h 3932395"/>
                  <a:gd name="connsiteX19" fmla="*/ 1675796 w 4238978"/>
                  <a:gd name="connsiteY19" fmla="*/ 847699 h 3932395"/>
                  <a:gd name="connsiteX20" fmla="*/ 1656844 w 4238978"/>
                  <a:gd name="connsiteY20" fmla="*/ 658186 h 3932395"/>
                  <a:gd name="connsiteX21" fmla="*/ 1590515 w 4238978"/>
                  <a:gd name="connsiteY21" fmla="*/ 558692 h 3932395"/>
                  <a:gd name="connsiteX22" fmla="*/ 1533661 w 4238978"/>
                  <a:gd name="connsiteY22" fmla="*/ 411819 h 3932395"/>
                  <a:gd name="connsiteX23" fmla="*/ 1590515 w 4238978"/>
                  <a:gd name="connsiteY23" fmla="*/ 354966 h 3932395"/>
                  <a:gd name="connsiteX24" fmla="*/ 1789503 w 4238978"/>
                  <a:gd name="connsiteY24" fmla="*/ 407082 h 3932395"/>
                  <a:gd name="connsiteX25" fmla="*/ 1851095 w 4238978"/>
                  <a:gd name="connsiteY25" fmla="*/ 568168 h 3932395"/>
                  <a:gd name="connsiteX26" fmla="*/ 1931638 w 4238978"/>
                  <a:gd name="connsiteY26" fmla="*/ 710302 h 3932395"/>
                  <a:gd name="connsiteX27" fmla="*/ 1979016 w 4238978"/>
                  <a:gd name="connsiteY27" fmla="*/ 620284 h 3932395"/>
                  <a:gd name="connsiteX28" fmla="*/ 1969541 w 4238978"/>
                  <a:gd name="connsiteY28" fmla="*/ 520789 h 3932395"/>
                  <a:gd name="connsiteX29" fmla="*/ 1922162 w 4238978"/>
                  <a:gd name="connsiteY29" fmla="*/ 288636 h 3932395"/>
                  <a:gd name="connsiteX30" fmla="*/ 1879522 w 4238978"/>
                  <a:gd name="connsiteY30" fmla="*/ 174928 h 3932395"/>
                  <a:gd name="connsiteX31" fmla="*/ 1879522 w 4238978"/>
                  <a:gd name="connsiteY31" fmla="*/ 47007 h 3932395"/>
                  <a:gd name="connsiteX32" fmla="*/ 2092724 w 4238978"/>
                  <a:gd name="connsiteY32" fmla="*/ 4367 h 3932395"/>
                  <a:gd name="connsiteX33" fmla="*/ 2159054 w 4238978"/>
                  <a:gd name="connsiteY33" fmla="*/ 141763 h 3932395"/>
                  <a:gd name="connsiteX34" fmla="*/ 2168529 w 4238978"/>
                  <a:gd name="connsiteY34" fmla="*/ 279160 h 3932395"/>
                  <a:gd name="connsiteX35" fmla="*/ 2173267 w 4238978"/>
                  <a:gd name="connsiteY35" fmla="*/ 430771 h 3932395"/>
                  <a:gd name="connsiteX36" fmla="*/ 2178005 w 4238978"/>
                  <a:gd name="connsiteY36" fmla="*/ 587119 h 3932395"/>
                  <a:gd name="connsiteX37" fmla="*/ 2239597 w 4238978"/>
                  <a:gd name="connsiteY37" fmla="*/ 696089 h 3932395"/>
                  <a:gd name="connsiteX38" fmla="*/ 2353304 w 4238978"/>
                  <a:gd name="connsiteY38" fmla="*/ 591857 h 3932395"/>
                  <a:gd name="connsiteX39" fmla="*/ 2372256 w 4238978"/>
                  <a:gd name="connsiteY39" fmla="*/ 421295 h 3932395"/>
                  <a:gd name="connsiteX40" fmla="*/ 2462274 w 4238978"/>
                  <a:gd name="connsiteY40" fmla="*/ 345490 h 3932395"/>
                  <a:gd name="connsiteX41" fmla="*/ 2552293 w 4238978"/>
                  <a:gd name="connsiteY41" fmla="*/ 444984 h 3932395"/>
                  <a:gd name="connsiteX42" fmla="*/ 2500177 w 4238978"/>
                  <a:gd name="connsiteY42" fmla="*/ 667662 h 3932395"/>
                  <a:gd name="connsiteX43" fmla="*/ 2571244 w 4238978"/>
                  <a:gd name="connsiteY43" fmla="*/ 800321 h 3932395"/>
                  <a:gd name="connsiteX44" fmla="*/ 2689690 w 4238978"/>
                  <a:gd name="connsiteY44" fmla="*/ 719778 h 3932395"/>
                  <a:gd name="connsiteX45" fmla="*/ 2784446 w 4238978"/>
                  <a:gd name="connsiteY45" fmla="*/ 544478 h 3932395"/>
                  <a:gd name="connsiteX46" fmla="*/ 2907630 w 4238978"/>
                  <a:gd name="connsiteY46" fmla="*/ 411819 h 3932395"/>
                  <a:gd name="connsiteX47" fmla="*/ 3016600 w 4238978"/>
                  <a:gd name="connsiteY47" fmla="*/ 302849 h 3932395"/>
                  <a:gd name="connsiteX48" fmla="*/ 3144521 w 4238978"/>
                  <a:gd name="connsiteY48" fmla="*/ 241258 h 3932395"/>
                  <a:gd name="connsiteX49" fmla="*/ 3419315 w 4238978"/>
                  <a:gd name="connsiteY49" fmla="*/ 317063 h 3932395"/>
                  <a:gd name="connsiteX50" fmla="*/ 3523547 w 4238978"/>
                  <a:gd name="connsiteY50" fmla="*/ 426033 h 3932395"/>
                  <a:gd name="connsiteX51" fmla="*/ 3433528 w 4238978"/>
                  <a:gd name="connsiteY51" fmla="*/ 506576 h 3932395"/>
                  <a:gd name="connsiteX52" fmla="*/ 3262967 w 4238978"/>
                  <a:gd name="connsiteY52" fmla="*/ 620284 h 3932395"/>
                  <a:gd name="connsiteX53" fmla="*/ 3054502 w 4238978"/>
                  <a:gd name="connsiteY53" fmla="*/ 729254 h 3932395"/>
                  <a:gd name="connsiteX54" fmla="*/ 2893416 w 4238978"/>
                  <a:gd name="connsiteY54" fmla="*/ 880864 h 3932395"/>
                  <a:gd name="connsiteX55" fmla="*/ 2959746 w 4238978"/>
                  <a:gd name="connsiteY55" fmla="*/ 923504 h 3932395"/>
                  <a:gd name="connsiteX56" fmla="*/ 3168210 w 4238978"/>
                  <a:gd name="connsiteY56" fmla="*/ 871388 h 3932395"/>
                  <a:gd name="connsiteX57" fmla="*/ 3381412 w 4238978"/>
                  <a:gd name="connsiteY57" fmla="*/ 757681 h 3932395"/>
                  <a:gd name="connsiteX58" fmla="*/ 3556712 w 4238978"/>
                  <a:gd name="connsiteY58" fmla="*/ 861913 h 3932395"/>
                  <a:gd name="connsiteX59" fmla="*/ 3589876 w 4238978"/>
                  <a:gd name="connsiteY59" fmla="*/ 975620 h 3932395"/>
                  <a:gd name="connsiteX60" fmla="*/ 3390888 w 4238978"/>
                  <a:gd name="connsiteY60" fmla="*/ 1070377 h 3932395"/>
                  <a:gd name="connsiteX61" fmla="*/ 3210851 w 4238978"/>
                  <a:gd name="connsiteY61" fmla="*/ 1089328 h 3932395"/>
                  <a:gd name="connsiteX62" fmla="*/ 3191899 w 4238978"/>
                  <a:gd name="connsiteY62" fmla="*/ 1217249 h 3932395"/>
                  <a:gd name="connsiteX63" fmla="*/ 3570925 w 4238978"/>
                  <a:gd name="connsiteY63" fmla="*/ 1250414 h 3932395"/>
                  <a:gd name="connsiteX64" fmla="*/ 3855195 w 4238978"/>
                  <a:gd name="connsiteY64" fmla="*/ 1136706 h 3932395"/>
                  <a:gd name="connsiteX65" fmla="*/ 3983116 w 4238978"/>
                  <a:gd name="connsiteY65" fmla="*/ 1089328 h 3932395"/>
                  <a:gd name="connsiteX66" fmla="*/ 4101561 w 4238978"/>
                  <a:gd name="connsiteY66" fmla="*/ 1255152 h 3932395"/>
                  <a:gd name="connsiteX67" fmla="*/ 3916786 w 4238978"/>
                  <a:gd name="connsiteY67" fmla="*/ 1297792 h 3932395"/>
                  <a:gd name="connsiteX68" fmla="*/ 3613566 w 4238978"/>
                  <a:gd name="connsiteY68" fmla="*/ 1340433 h 3932395"/>
                  <a:gd name="connsiteX69" fmla="*/ 3352985 w 4238978"/>
                  <a:gd name="connsiteY69" fmla="*/ 1368860 h 3932395"/>
                  <a:gd name="connsiteX70" fmla="*/ 3319820 w 4238978"/>
                  <a:gd name="connsiteY70" fmla="*/ 1477830 h 3932395"/>
                  <a:gd name="connsiteX71" fmla="*/ 3499858 w 4238978"/>
                  <a:gd name="connsiteY71" fmla="*/ 1473092 h 3932395"/>
                  <a:gd name="connsiteX72" fmla="*/ 3741487 w 4238978"/>
                  <a:gd name="connsiteY72" fmla="*/ 1510995 h 3932395"/>
                  <a:gd name="connsiteX73" fmla="*/ 3784127 w 4238978"/>
                  <a:gd name="connsiteY73" fmla="*/ 1662605 h 3932395"/>
                  <a:gd name="connsiteX74" fmla="*/ 3689371 w 4238978"/>
                  <a:gd name="connsiteY74" fmla="*/ 1709983 h 3932395"/>
                  <a:gd name="connsiteX75" fmla="*/ 3466693 w 4238978"/>
                  <a:gd name="connsiteY75" fmla="*/ 1705245 h 3932395"/>
                  <a:gd name="connsiteX76" fmla="*/ 3334034 w 4238978"/>
                  <a:gd name="connsiteY76" fmla="*/ 1818953 h 3932395"/>
                  <a:gd name="connsiteX77" fmla="*/ 3514071 w 4238978"/>
                  <a:gd name="connsiteY77" fmla="*/ 1951612 h 3932395"/>
                  <a:gd name="connsiteX78" fmla="*/ 3774652 w 4238978"/>
                  <a:gd name="connsiteY78" fmla="*/ 2074796 h 3932395"/>
                  <a:gd name="connsiteX79" fmla="*/ 3793603 w 4238978"/>
                  <a:gd name="connsiteY79" fmla="*/ 2202717 h 3932395"/>
                  <a:gd name="connsiteX80" fmla="*/ 3566187 w 4238978"/>
                  <a:gd name="connsiteY80" fmla="*/ 2283260 h 3932395"/>
                  <a:gd name="connsiteX81" fmla="*/ 3409839 w 4238978"/>
                  <a:gd name="connsiteY81" fmla="*/ 2250095 h 3932395"/>
                  <a:gd name="connsiteX82" fmla="*/ 3286656 w 4238978"/>
                  <a:gd name="connsiteY82" fmla="*/ 2287998 h 3932395"/>
                  <a:gd name="connsiteX83" fmla="*/ 3471431 w 4238978"/>
                  <a:gd name="connsiteY83" fmla="*/ 2411181 h 3932395"/>
                  <a:gd name="connsiteX84" fmla="*/ 3594614 w 4238978"/>
                  <a:gd name="connsiteY84" fmla="*/ 2439608 h 3932395"/>
                  <a:gd name="connsiteX85" fmla="*/ 3845719 w 4238978"/>
                  <a:gd name="connsiteY85" fmla="*/ 2534364 h 3932395"/>
                  <a:gd name="connsiteX86" fmla="*/ 4092086 w 4238978"/>
                  <a:gd name="connsiteY86" fmla="*/ 2577005 h 3932395"/>
                  <a:gd name="connsiteX87" fmla="*/ 4238958 w 4238978"/>
                  <a:gd name="connsiteY87" fmla="*/ 2738091 h 3932395"/>
                  <a:gd name="connsiteX88" fmla="*/ 4101561 w 4238978"/>
                  <a:gd name="connsiteY88" fmla="*/ 2965506 h 3932395"/>
                  <a:gd name="connsiteX89" fmla="*/ 3940475 w 4238978"/>
                  <a:gd name="connsiteY89" fmla="*/ 2946555 h 3932395"/>
                  <a:gd name="connsiteX90" fmla="*/ 3679895 w 4238978"/>
                  <a:gd name="connsiteY90" fmla="*/ 2785469 h 3932395"/>
                  <a:gd name="connsiteX91" fmla="*/ 3533023 w 4238978"/>
                  <a:gd name="connsiteY91" fmla="*/ 2709664 h 3932395"/>
                  <a:gd name="connsiteX92" fmla="*/ 3300869 w 4238978"/>
                  <a:gd name="connsiteY92" fmla="*/ 2624383 h 3932395"/>
                  <a:gd name="connsiteX93" fmla="*/ 3158734 w 4238978"/>
                  <a:gd name="connsiteY93" fmla="*/ 2638597 h 3932395"/>
                  <a:gd name="connsiteX94" fmla="*/ 3130308 w 4238978"/>
                  <a:gd name="connsiteY94" fmla="*/ 2728615 h 3932395"/>
                  <a:gd name="connsiteX95" fmla="*/ 3253491 w 4238978"/>
                  <a:gd name="connsiteY95" fmla="*/ 2856536 h 3932395"/>
                  <a:gd name="connsiteX96" fmla="*/ 3319820 w 4238978"/>
                  <a:gd name="connsiteY96" fmla="*/ 2970244 h 3932395"/>
                  <a:gd name="connsiteX97" fmla="*/ 3357723 w 4238978"/>
                  <a:gd name="connsiteY97" fmla="*/ 3107641 h 3932395"/>
                  <a:gd name="connsiteX98" fmla="*/ 3172948 w 4238978"/>
                  <a:gd name="connsiteY98" fmla="*/ 3140806 h 3932395"/>
                  <a:gd name="connsiteX99" fmla="*/ 3097143 w 4238978"/>
                  <a:gd name="connsiteY99" fmla="*/ 3098166 h 3932395"/>
                  <a:gd name="connsiteX100" fmla="*/ 3030813 w 4238978"/>
                  <a:gd name="connsiteY100" fmla="*/ 3012885 h 3932395"/>
                  <a:gd name="connsiteX101" fmla="*/ 2874465 w 4238978"/>
                  <a:gd name="connsiteY101" fmla="*/ 2956031 h 3932395"/>
                  <a:gd name="connsiteX102" fmla="*/ 2822349 w 4238978"/>
                  <a:gd name="connsiteY102" fmla="*/ 3169233 h 3932395"/>
                  <a:gd name="connsiteX103" fmla="*/ 2992911 w 4238978"/>
                  <a:gd name="connsiteY103" fmla="*/ 3320843 h 3932395"/>
                  <a:gd name="connsiteX104" fmla="*/ 3153997 w 4238978"/>
                  <a:gd name="connsiteY104" fmla="*/ 3377697 h 3932395"/>
                  <a:gd name="connsiteX105" fmla="*/ 3016600 w 4238978"/>
                  <a:gd name="connsiteY105" fmla="*/ 3543521 h 3932395"/>
                  <a:gd name="connsiteX106" fmla="*/ 2831825 w 4238978"/>
                  <a:gd name="connsiteY106" fmla="*/ 3571948 h 3932395"/>
                  <a:gd name="connsiteX107" fmla="*/ 2770233 w 4238978"/>
                  <a:gd name="connsiteY107" fmla="*/ 3496143 h 3932395"/>
                  <a:gd name="connsiteX108" fmla="*/ 2703903 w 4238978"/>
                  <a:gd name="connsiteY108" fmla="*/ 3363484 h 3932395"/>
                  <a:gd name="connsiteX109" fmla="*/ 2680214 w 4238978"/>
                  <a:gd name="connsiteY109" fmla="*/ 3211873 h 3932395"/>
                  <a:gd name="connsiteX110" fmla="*/ 2571244 w 4238978"/>
                  <a:gd name="connsiteY110" fmla="*/ 3093428 h 3932395"/>
                  <a:gd name="connsiteX111" fmla="*/ 2438585 w 4238978"/>
                  <a:gd name="connsiteY111" fmla="*/ 3145544 h 3932395"/>
                  <a:gd name="connsiteX112" fmla="*/ 2414896 w 4238978"/>
                  <a:gd name="connsiteY112" fmla="*/ 3216611 h 3932395"/>
                  <a:gd name="connsiteX113" fmla="*/ 2490701 w 4238978"/>
                  <a:gd name="connsiteY113" fmla="*/ 3363484 h 3932395"/>
                  <a:gd name="connsiteX114" fmla="*/ 2519128 w 4238978"/>
                  <a:gd name="connsiteY114" fmla="*/ 3505618 h 3932395"/>
                  <a:gd name="connsiteX115" fmla="*/ 2533342 w 4238978"/>
                  <a:gd name="connsiteY115" fmla="*/ 3633540 h 3932395"/>
                  <a:gd name="connsiteX116" fmla="*/ 2538080 w 4238978"/>
                  <a:gd name="connsiteY116" fmla="*/ 3770936 h 3932395"/>
                  <a:gd name="connsiteX117" fmla="*/ 2519128 w 4238978"/>
                  <a:gd name="connsiteY117" fmla="*/ 3898858 h 3932395"/>
                  <a:gd name="connsiteX118" fmla="*/ 2467012 w 4238978"/>
                  <a:gd name="connsiteY118" fmla="*/ 3932023 h 3932395"/>
                  <a:gd name="connsiteX119" fmla="*/ 2272761 w 4238978"/>
                  <a:gd name="connsiteY119" fmla="*/ 3884644 h 3932395"/>
                  <a:gd name="connsiteX120" fmla="*/ 2234859 w 4238978"/>
                  <a:gd name="connsiteY120" fmla="*/ 3780412 h 3932395"/>
                  <a:gd name="connsiteX121" fmla="*/ 2253810 w 4238978"/>
                  <a:gd name="connsiteY121" fmla="*/ 3605113 h 3932395"/>
                  <a:gd name="connsiteX122" fmla="*/ 2211170 w 4238978"/>
                  <a:gd name="connsiteY122" fmla="*/ 3458240 h 3932395"/>
                  <a:gd name="connsiteX123" fmla="*/ 2159054 w 4238978"/>
                  <a:gd name="connsiteY123" fmla="*/ 3344532 h 3932395"/>
                  <a:gd name="connsiteX124" fmla="*/ 2054822 w 4238978"/>
                  <a:gd name="connsiteY124" fmla="*/ 3320843 h 3932395"/>
                  <a:gd name="connsiteX125" fmla="*/ 1974279 w 4238978"/>
                  <a:gd name="connsiteY125" fmla="*/ 3481929 h 3932395"/>
                  <a:gd name="connsiteX126" fmla="*/ 1960065 w 4238978"/>
                  <a:gd name="connsiteY126" fmla="*/ 3624064 h 3932395"/>
                  <a:gd name="connsiteX127" fmla="*/ 1832144 w 4238978"/>
                  <a:gd name="connsiteY127" fmla="*/ 3609850 h 3932395"/>
                  <a:gd name="connsiteX128" fmla="*/ 1784766 w 4238978"/>
                  <a:gd name="connsiteY128" fmla="*/ 3481929 h 3932395"/>
                  <a:gd name="connsiteX129" fmla="*/ 1765814 w 4238978"/>
                  <a:gd name="connsiteY129" fmla="*/ 3268727 h 3932395"/>
                  <a:gd name="connsiteX130" fmla="*/ 1808455 w 4238978"/>
                  <a:gd name="connsiteY130" fmla="*/ 3173971 h 3932395"/>
                  <a:gd name="connsiteX131" fmla="*/ 1846357 w 4238978"/>
                  <a:gd name="connsiteY131" fmla="*/ 3041312 h 3932395"/>
                  <a:gd name="connsiteX132" fmla="*/ 1751601 w 4238978"/>
                  <a:gd name="connsiteY132" fmla="*/ 3012885 h 3932395"/>
                  <a:gd name="connsiteX133" fmla="*/ 1618942 w 4238978"/>
                  <a:gd name="connsiteY133" fmla="*/ 3325581 h 3932395"/>
                  <a:gd name="connsiteX134" fmla="*/ 1543137 w 4238978"/>
                  <a:gd name="connsiteY134" fmla="*/ 3519832 h 3932395"/>
                  <a:gd name="connsiteX135" fmla="*/ 1419953 w 4238978"/>
                  <a:gd name="connsiteY135" fmla="*/ 3652491 h 3932395"/>
                  <a:gd name="connsiteX136" fmla="*/ 1292032 w 4238978"/>
                  <a:gd name="connsiteY136" fmla="*/ 3695131 h 3932395"/>
                  <a:gd name="connsiteX137" fmla="*/ 1059879 w 4238978"/>
                  <a:gd name="connsiteY137" fmla="*/ 3685656 h 3932395"/>
                  <a:gd name="connsiteX138" fmla="*/ 908268 w 4238978"/>
                  <a:gd name="connsiteY138" fmla="*/ 3491405 h 3932395"/>
                  <a:gd name="connsiteX139" fmla="*/ 927219 w 4238978"/>
                  <a:gd name="connsiteY139" fmla="*/ 3368221 h 3932395"/>
                  <a:gd name="connsiteX140" fmla="*/ 1055141 w 4238978"/>
                  <a:gd name="connsiteY140" fmla="*/ 3349270 h 3932395"/>
                  <a:gd name="connsiteX141" fmla="*/ 1183062 w 4238978"/>
                  <a:gd name="connsiteY141" fmla="*/ 3311368 h 3932395"/>
                  <a:gd name="connsiteX142" fmla="*/ 1287294 w 4238978"/>
                  <a:gd name="connsiteY142" fmla="*/ 3221349 h 3932395"/>
                  <a:gd name="connsiteX143" fmla="*/ 1391526 w 4238978"/>
                  <a:gd name="connsiteY143" fmla="*/ 3074476 h 3932395"/>
                  <a:gd name="connsiteX144" fmla="*/ 1443642 w 4238978"/>
                  <a:gd name="connsiteY144" fmla="*/ 2937079 h 3932395"/>
                  <a:gd name="connsiteX145" fmla="*/ 1443642 w 4238978"/>
                  <a:gd name="connsiteY145" fmla="*/ 2809158 h 3932395"/>
                  <a:gd name="connsiteX146" fmla="*/ 1334672 w 4238978"/>
                  <a:gd name="connsiteY146" fmla="*/ 2813896 h 3932395"/>
                  <a:gd name="connsiteX147" fmla="*/ 1135684 w 4238978"/>
                  <a:gd name="connsiteY147" fmla="*/ 2946555 h 3932395"/>
                  <a:gd name="connsiteX148" fmla="*/ 1003025 w 4238978"/>
                  <a:gd name="connsiteY148" fmla="*/ 3046049 h 3932395"/>
                  <a:gd name="connsiteX149" fmla="*/ 903530 w 4238978"/>
                  <a:gd name="connsiteY149" fmla="*/ 3159757 h 3932395"/>
                  <a:gd name="connsiteX150" fmla="*/ 709280 w 4238978"/>
                  <a:gd name="connsiteY150" fmla="*/ 3207135 h 3932395"/>
                  <a:gd name="connsiteX151" fmla="*/ 671377 w 4238978"/>
                  <a:gd name="connsiteY151" fmla="*/ 3098166 h 3932395"/>
                  <a:gd name="connsiteX152" fmla="*/ 723493 w 4238978"/>
                  <a:gd name="connsiteY152" fmla="*/ 2908653 h 3932395"/>
                  <a:gd name="connsiteX153" fmla="*/ 898793 w 4238978"/>
                  <a:gd name="connsiteY153" fmla="*/ 2809158 h 3932395"/>
                  <a:gd name="connsiteX154" fmla="*/ 1116732 w 4238978"/>
                  <a:gd name="connsiteY154" fmla="*/ 2771256 h 3932395"/>
                  <a:gd name="connsiteX155" fmla="*/ 1258867 w 4238978"/>
                  <a:gd name="connsiteY155" fmla="*/ 2652810 h 3932395"/>
                  <a:gd name="connsiteX156" fmla="*/ 1268343 w 4238978"/>
                  <a:gd name="connsiteY156" fmla="*/ 2586481 h 3932395"/>
                  <a:gd name="connsiteX157" fmla="*/ 1093043 w 4238978"/>
                  <a:gd name="connsiteY157" fmla="*/ 2581743 h 3932395"/>
                  <a:gd name="connsiteX158" fmla="*/ 941433 w 4238978"/>
                  <a:gd name="connsiteY158" fmla="*/ 2610170 h 3932395"/>
                  <a:gd name="connsiteX159" fmla="*/ 804036 w 4238978"/>
                  <a:gd name="connsiteY159" fmla="*/ 2600694 h 3932395"/>
                  <a:gd name="connsiteX160" fmla="*/ 851414 w 4238978"/>
                  <a:gd name="connsiteY160" fmla="*/ 2477511 h 3932395"/>
                  <a:gd name="connsiteX161" fmla="*/ 1064616 w 4238978"/>
                  <a:gd name="connsiteY161" fmla="*/ 2439608 h 3932395"/>
                  <a:gd name="connsiteX162" fmla="*/ 1258867 w 4238978"/>
                  <a:gd name="connsiteY162" fmla="*/ 2273784 h 3932395"/>
                  <a:gd name="connsiteX163" fmla="*/ 1102519 w 4238978"/>
                  <a:gd name="connsiteY163" fmla="*/ 2264309 h 3932395"/>
                  <a:gd name="connsiteX164" fmla="*/ 913006 w 4238978"/>
                  <a:gd name="connsiteY164" fmla="*/ 2311687 h 3932395"/>
                  <a:gd name="connsiteX165" fmla="*/ 699804 w 4238978"/>
                  <a:gd name="connsiteY165" fmla="*/ 2335376 h 3932395"/>
                  <a:gd name="connsiteX166" fmla="*/ 770871 w 4238978"/>
                  <a:gd name="connsiteY166" fmla="*/ 2202717 h 3932395"/>
                  <a:gd name="connsiteX167" fmla="*/ 1040927 w 4238978"/>
                  <a:gd name="connsiteY167" fmla="*/ 2141125 h 3932395"/>
                  <a:gd name="connsiteX168" fmla="*/ 1140422 w 4238978"/>
                  <a:gd name="connsiteY168" fmla="*/ 2036893 h 3932395"/>
                  <a:gd name="connsiteX169" fmla="*/ 913006 w 4238978"/>
                  <a:gd name="connsiteY169" fmla="*/ 2008466 h 3932395"/>
                  <a:gd name="connsiteX170" fmla="*/ 647688 w 4238978"/>
                  <a:gd name="connsiteY170" fmla="*/ 2032155 h 3932395"/>
                  <a:gd name="connsiteX171" fmla="*/ 358681 w 4238978"/>
                  <a:gd name="connsiteY171" fmla="*/ 2060582 h 3932395"/>
                  <a:gd name="connsiteX172" fmla="*/ 27033 w 4238978"/>
                  <a:gd name="connsiteY172" fmla="*/ 2003728 h 3932395"/>
                  <a:gd name="connsiteX173" fmla="*/ 31771 w 4238978"/>
                  <a:gd name="connsiteY173" fmla="*/ 1814215 h 3932395"/>
                  <a:gd name="connsiteX174" fmla="*/ 131265 w 4238978"/>
                  <a:gd name="connsiteY174" fmla="*/ 1695770 h 3932395"/>
                  <a:gd name="connsiteX175" fmla="*/ 439224 w 4238978"/>
                  <a:gd name="connsiteY175" fmla="*/ 1738410 h 3932395"/>
                  <a:gd name="connsiteX176" fmla="*/ 652426 w 4238978"/>
                  <a:gd name="connsiteY176" fmla="*/ 1738410 h 3932395"/>
                  <a:gd name="connsiteX177" fmla="*/ 960384 w 4238978"/>
                  <a:gd name="connsiteY177" fmla="*/ 1714721 h 3932395"/>
                  <a:gd name="connsiteX178" fmla="*/ 1017238 w 4238978"/>
                  <a:gd name="connsiteY178" fmla="*/ 1657867 h 3932395"/>
                  <a:gd name="connsiteX179" fmla="*/ 813512 w 4238978"/>
                  <a:gd name="connsiteY179" fmla="*/ 1601013 h 3932395"/>
                  <a:gd name="connsiteX180" fmla="*/ 690328 w 4238978"/>
                  <a:gd name="connsiteY180" fmla="*/ 1615227 h 3932395"/>
                  <a:gd name="connsiteX181" fmla="*/ 515029 w 4238978"/>
                  <a:gd name="connsiteY181" fmla="*/ 1601013 h 3932395"/>
                  <a:gd name="connsiteX182" fmla="*/ 458175 w 4238978"/>
                  <a:gd name="connsiteY182" fmla="*/ 1501519 h 3932395"/>
                  <a:gd name="connsiteX183" fmla="*/ 524504 w 4238978"/>
                  <a:gd name="connsiteY183" fmla="*/ 1397287 h 3932395"/>
                  <a:gd name="connsiteX184" fmla="*/ 647688 w 4238978"/>
                  <a:gd name="connsiteY184" fmla="*/ 1349909 h 3932395"/>
                  <a:gd name="connsiteX185" fmla="*/ 799298 w 4238978"/>
                  <a:gd name="connsiteY185" fmla="*/ 1349909 h 3932395"/>
                  <a:gd name="connsiteX186" fmla="*/ 832463 w 4238978"/>
                  <a:gd name="connsiteY186" fmla="*/ 1477830 h 393239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Lst>
                <a:rect l="l" t="t" r="r" b="b"/>
                <a:pathLst>
                  <a:path w="4238978" h="3932395">
                    <a:moveTo>
                      <a:pt x="832463" y="1477830"/>
                    </a:moveTo>
                    <a:cubicBezTo>
                      <a:pt x="854573" y="1506257"/>
                      <a:pt x="898003" y="1518101"/>
                      <a:pt x="931957" y="1520470"/>
                    </a:cubicBezTo>
                    <a:cubicBezTo>
                      <a:pt x="965911" y="1522839"/>
                      <a:pt x="1026713" y="1515732"/>
                      <a:pt x="1036189" y="1492043"/>
                    </a:cubicBezTo>
                    <a:cubicBezTo>
                      <a:pt x="1045665" y="1468354"/>
                      <a:pt x="1012500" y="1409131"/>
                      <a:pt x="988811" y="1378335"/>
                    </a:cubicBezTo>
                    <a:cubicBezTo>
                      <a:pt x="965122" y="1347539"/>
                      <a:pt x="925641" y="1335695"/>
                      <a:pt x="894055" y="1307268"/>
                    </a:cubicBezTo>
                    <a:cubicBezTo>
                      <a:pt x="862470" y="1278841"/>
                      <a:pt x="823777" y="1244887"/>
                      <a:pt x="799298" y="1207774"/>
                    </a:cubicBezTo>
                    <a:cubicBezTo>
                      <a:pt x="774819" y="1170661"/>
                      <a:pt x="743234" y="1118544"/>
                      <a:pt x="747182" y="1084590"/>
                    </a:cubicBezTo>
                    <a:cubicBezTo>
                      <a:pt x="751130" y="1050636"/>
                      <a:pt x="795350" y="1004836"/>
                      <a:pt x="822987" y="1004047"/>
                    </a:cubicBezTo>
                    <a:cubicBezTo>
                      <a:pt x="850624" y="1003258"/>
                      <a:pt x="869576" y="1060902"/>
                      <a:pt x="913006" y="1079853"/>
                    </a:cubicBezTo>
                    <a:cubicBezTo>
                      <a:pt x="956436" y="1098804"/>
                      <a:pt x="1049614" y="1134338"/>
                      <a:pt x="1083568" y="1117755"/>
                    </a:cubicBezTo>
                    <a:cubicBezTo>
                      <a:pt x="1117522" y="1101172"/>
                      <a:pt x="1135683" y="1019840"/>
                      <a:pt x="1116732" y="980358"/>
                    </a:cubicBezTo>
                    <a:cubicBezTo>
                      <a:pt x="1097781" y="940876"/>
                      <a:pt x="1023555" y="927452"/>
                      <a:pt x="969860" y="880864"/>
                    </a:cubicBezTo>
                    <a:cubicBezTo>
                      <a:pt x="916165" y="834275"/>
                      <a:pt x="816670" y="756102"/>
                      <a:pt x="794560" y="700827"/>
                    </a:cubicBezTo>
                    <a:cubicBezTo>
                      <a:pt x="772450" y="645552"/>
                      <a:pt x="806405" y="583960"/>
                      <a:pt x="837201" y="549216"/>
                    </a:cubicBezTo>
                    <a:cubicBezTo>
                      <a:pt x="867997" y="514472"/>
                      <a:pt x="925641" y="486835"/>
                      <a:pt x="979336" y="492362"/>
                    </a:cubicBezTo>
                    <a:cubicBezTo>
                      <a:pt x="1033031" y="497889"/>
                      <a:pt x="1107257" y="549216"/>
                      <a:pt x="1159373" y="582381"/>
                    </a:cubicBezTo>
                    <a:cubicBezTo>
                      <a:pt x="1211489" y="615546"/>
                      <a:pt x="1246233" y="652659"/>
                      <a:pt x="1292032" y="691351"/>
                    </a:cubicBezTo>
                    <a:cubicBezTo>
                      <a:pt x="1337831" y="730043"/>
                      <a:pt x="1383630" y="777421"/>
                      <a:pt x="1434167" y="814534"/>
                    </a:cubicBezTo>
                    <a:cubicBezTo>
                      <a:pt x="1484704" y="851647"/>
                      <a:pt x="1554982" y="908501"/>
                      <a:pt x="1595253" y="914029"/>
                    </a:cubicBezTo>
                    <a:cubicBezTo>
                      <a:pt x="1635525" y="919556"/>
                      <a:pt x="1665531" y="890340"/>
                      <a:pt x="1675796" y="847699"/>
                    </a:cubicBezTo>
                    <a:cubicBezTo>
                      <a:pt x="1686061" y="805058"/>
                      <a:pt x="1671057" y="706354"/>
                      <a:pt x="1656844" y="658186"/>
                    </a:cubicBezTo>
                    <a:cubicBezTo>
                      <a:pt x="1642631" y="610018"/>
                      <a:pt x="1611045" y="599753"/>
                      <a:pt x="1590515" y="558692"/>
                    </a:cubicBezTo>
                    <a:cubicBezTo>
                      <a:pt x="1569985" y="517631"/>
                      <a:pt x="1533661" y="445773"/>
                      <a:pt x="1533661" y="411819"/>
                    </a:cubicBezTo>
                    <a:cubicBezTo>
                      <a:pt x="1533661" y="377865"/>
                      <a:pt x="1547875" y="355756"/>
                      <a:pt x="1590515" y="354966"/>
                    </a:cubicBezTo>
                    <a:cubicBezTo>
                      <a:pt x="1633155" y="354176"/>
                      <a:pt x="1746073" y="371548"/>
                      <a:pt x="1789503" y="407082"/>
                    </a:cubicBezTo>
                    <a:cubicBezTo>
                      <a:pt x="1832933" y="442616"/>
                      <a:pt x="1827406" y="517631"/>
                      <a:pt x="1851095" y="568168"/>
                    </a:cubicBezTo>
                    <a:cubicBezTo>
                      <a:pt x="1874784" y="618705"/>
                      <a:pt x="1910318" y="701616"/>
                      <a:pt x="1931638" y="710302"/>
                    </a:cubicBezTo>
                    <a:cubicBezTo>
                      <a:pt x="1952958" y="718988"/>
                      <a:pt x="1972699" y="651869"/>
                      <a:pt x="1979016" y="620284"/>
                    </a:cubicBezTo>
                    <a:cubicBezTo>
                      <a:pt x="1985333" y="588698"/>
                      <a:pt x="1979017" y="576064"/>
                      <a:pt x="1969541" y="520789"/>
                    </a:cubicBezTo>
                    <a:cubicBezTo>
                      <a:pt x="1960065" y="465514"/>
                      <a:pt x="1937165" y="346279"/>
                      <a:pt x="1922162" y="288636"/>
                    </a:cubicBezTo>
                    <a:cubicBezTo>
                      <a:pt x="1907159" y="230993"/>
                      <a:pt x="1886629" y="215199"/>
                      <a:pt x="1879522" y="174928"/>
                    </a:cubicBezTo>
                    <a:cubicBezTo>
                      <a:pt x="1872415" y="134656"/>
                      <a:pt x="1843988" y="75434"/>
                      <a:pt x="1879522" y="47007"/>
                    </a:cubicBezTo>
                    <a:cubicBezTo>
                      <a:pt x="1915056" y="18580"/>
                      <a:pt x="2046135" y="-11426"/>
                      <a:pt x="2092724" y="4367"/>
                    </a:cubicBezTo>
                    <a:cubicBezTo>
                      <a:pt x="2139313" y="20160"/>
                      <a:pt x="2146420" y="95964"/>
                      <a:pt x="2159054" y="141763"/>
                    </a:cubicBezTo>
                    <a:cubicBezTo>
                      <a:pt x="2171688" y="187562"/>
                      <a:pt x="2166160" y="230992"/>
                      <a:pt x="2168529" y="279160"/>
                    </a:cubicBezTo>
                    <a:cubicBezTo>
                      <a:pt x="2170898" y="327328"/>
                      <a:pt x="2171688" y="379444"/>
                      <a:pt x="2173267" y="430771"/>
                    </a:cubicBezTo>
                    <a:cubicBezTo>
                      <a:pt x="2174846" y="482097"/>
                      <a:pt x="2166950" y="542899"/>
                      <a:pt x="2178005" y="587119"/>
                    </a:cubicBezTo>
                    <a:cubicBezTo>
                      <a:pt x="2189060" y="631339"/>
                      <a:pt x="2210381" y="695299"/>
                      <a:pt x="2239597" y="696089"/>
                    </a:cubicBezTo>
                    <a:cubicBezTo>
                      <a:pt x="2268813" y="696879"/>
                      <a:pt x="2331194" y="637656"/>
                      <a:pt x="2353304" y="591857"/>
                    </a:cubicBezTo>
                    <a:cubicBezTo>
                      <a:pt x="2375414" y="546058"/>
                      <a:pt x="2354094" y="462356"/>
                      <a:pt x="2372256" y="421295"/>
                    </a:cubicBezTo>
                    <a:cubicBezTo>
                      <a:pt x="2390418" y="380234"/>
                      <a:pt x="2432268" y="341542"/>
                      <a:pt x="2462274" y="345490"/>
                    </a:cubicBezTo>
                    <a:cubicBezTo>
                      <a:pt x="2492280" y="349438"/>
                      <a:pt x="2545976" y="391289"/>
                      <a:pt x="2552293" y="444984"/>
                    </a:cubicBezTo>
                    <a:cubicBezTo>
                      <a:pt x="2558610" y="498679"/>
                      <a:pt x="2497019" y="608439"/>
                      <a:pt x="2500177" y="667662"/>
                    </a:cubicBezTo>
                    <a:cubicBezTo>
                      <a:pt x="2503335" y="726885"/>
                      <a:pt x="2539659" y="791635"/>
                      <a:pt x="2571244" y="800321"/>
                    </a:cubicBezTo>
                    <a:cubicBezTo>
                      <a:pt x="2602830" y="809007"/>
                      <a:pt x="2654156" y="762418"/>
                      <a:pt x="2689690" y="719778"/>
                    </a:cubicBezTo>
                    <a:cubicBezTo>
                      <a:pt x="2725224" y="677137"/>
                      <a:pt x="2748123" y="595804"/>
                      <a:pt x="2784446" y="544478"/>
                    </a:cubicBezTo>
                    <a:cubicBezTo>
                      <a:pt x="2820769" y="493152"/>
                      <a:pt x="2868938" y="452090"/>
                      <a:pt x="2907630" y="411819"/>
                    </a:cubicBezTo>
                    <a:cubicBezTo>
                      <a:pt x="2946322" y="371548"/>
                      <a:pt x="2977118" y="331276"/>
                      <a:pt x="3016600" y="302849"/>
                    </a:cubicBezTo>
                    <a:cubicBezTo>
                      <a:pt x="3056082" y="274422"/>
                      <a:pt x="3077402" y="238889"/>
                      <a:pt x="3144521" y="241258"/>
                    </a:cubicBezTo>
                    <a:cubicBezTo>
                      <a:pt x="3211640" y="243627"/>
                      <a:pt x="3356144" y="286267"/>
                      <a:pt x="3419315" y="317063"/>
                    </a:cubicBezTo>
                    <a:cubicBezTo>
                      <a:pt x="3482486" y="347859"/>
                      <a:pt x="3521178" y="394448"/>
                      <a:pt x="3523547" y="426033"/>
                    </a:cubicBezTo>
                    <a:cubicBezTo>
                      <a:pt x="3525916" y="457618"/>
                      <a:pt x="3476958" y="474201"/>
                      <a:pt x="3433528" y="506576"/>
                    </a:cubicBezTo>
                    <a:cubicBezTo>
                      <a:pt x="3390098" y="538951"/>
                      <a:pt x="3326138" y="583171"/>
                      <a:pt x="3262967" y="620284"/>
                    </a:cubicBezTo>
                    <a:cubicBezTo>
                      <a:pt x="3199796" y="657397"/>
                      <a:pt x="3116094" y="685824"/>
                      <a:pt x="3054502" y="729254"/>
                    </a:cubicBezTo>
                    <a:cubicBezTo>
                      <a:pt x="2992910" y="772684"/>
                      <a:pt x="2909209" y="848489"/>
                      <a:pt x="2893416" y="880864"/>
                    </a:cubicBezTo>
                    <a:cubicBezTo>
                      <a:pt x="2877623" y="913239"/>
                      <a:pt x="2913947" y="925083"/>
                      <a:pt x="2959746" y="923504"/>
                    </a:cubicBezTo>
                    <a:cubicBezTo>
                      <a:pt x="3005545" y="921925"/>
                      <a:pt x="3097932" y="899025"/>
                      <a:pt x="3168210" y="871388"/>
                    </a:cubicBezTo>
                    <a:cubicBezTo>
                      <a:pt x="3238488" y="843751"/>
                      <a:pt x="3316662" y="759260"/>
                      <a:pt x="3381412" y="757681"/>
                    </a:cubicBezTo>
                    <a:cubicBezTo>
                      <a:pt x="3446162" y="756102"/>
                      <a:pt x="3521968" y="825590"/>
                      <a:pt x="3556712" y="861913"/>
                    </a:cubicBezTo>
                    <a:cubicBezTo>
                      <a:pt x="3591456" y="898236"/>
                      <a:pt x="3617513" y="940876"/>
                      <a:pt x="3589876" y="975620"/>
                    </a:cubicBezTo>
                    <a:cubicBezTo>
                      <a:pt x="3562239" y="1010364"/>
                      <a:pt x="3454059" y="1051426"/>
                      <a:pt x="3390888" y="1070377"/>
                    </a:cubicBezTo>
                    <a:cubicBezTo>
                      <a:pt x="3327717" y="1089328"/>
                      <a:pt x="3244016" y="1064849"/>
                      <a:pt x="3210851" y="1089328"/>
                    </a:cubicBezTo>
                    <a:cubicBezTo>
                      <a:pt x="3177686" y="1113807"/>
                      <a:pt x="3131887" y="1190401"/>
                      <a:pt x="3191899" y="1217249"/>
                    </a:cubicBezTo>
                    <a:cubicBezTo>
                      <a:pt x="3251911" y="1244097"/>
                      <a:pt x="3460376" y="1263838"/>
                      <a:pt x="3570925" y="1250414"/>
                    </a:cubicBezTo>
                    <a:cubicBezTo>
                      <a:pt x="3681474" y="1236990"/>
                      <a:pt x="3786497" y="1163554"/>
                      <a:pt x="3855195" y="1136706"/>
                    </a:cubicBezTo>
                    <a:cubicBezTo>
                      <a:pt x="3923893" y="1109858"/>
                      <a:pt x="3942055" y="1069587"/>
                      <a:pt x="3983116" y="1089328"/>
                    </a:cubicBezTo>
                    <a:cubicBezTo>
                      <a:pt x="4024177" y="1109069"/>
                      <a:pt x="4112616" y="1220408"/>
                      <a:pt x="4101561" y="1255152"/>
                    </a:cubicBezTo>
                    <a:cubicBezTo>
                      <a:pt x="4090506" y="1289896"/>
                      <a:pt x="3998119" y="1283578"/>
                      <a:pt x="3916786" y="1297792"/>
                    </a:cubicBezTo>
                    <a:cubicBezTo>
                      <a:pt x="3835454" y="1312005"/>
                      <a:pt x="3707533" y="1328588"/>
                      <a:pt x="3613566" y="1340433"/>
                    </a:cubicBezTo>
                    <a:cubicBezTo>
                      <a:pt x="3519599" y="1352278"/>
                      <a:pt x="3401942" y="1345961"/>
                      <a:pt x="3352985" y="1368860"/>
                    </a:cubicBezTo>
                    <a:cubicBezTo>
                      <a:pt x="3304028" y="1391759"/>
                      <a:pt x="3295341" y="1460458"/>
                      <a:pt x="3319820" y="1477830"/>
                    </a:cubicBezTo>
                    <a:cubicBezTo>
                      <a:pt x="3344299" y="1495202"/>
                      <a:pt x="3429580" y="1467564"/>
                      <a:pt x="3499858" y="1473092"/>
                    </a:cubicBezTo>
                    <a:cubicBezTo>
                      <a:pt x="3570136" y="1478620"/>
                      <a:pt x="3694109" y="1479410"/>
                      <a:pt x="3741487" y="1510995"/>
                    </a:cubicBezTo>
                    <a:cubicBezTo>
                      <a:pt x="3788865" y="1542580"/>
                      <a:pt x="3792813" y="1629440"/>
                      <a:pt x="3784127" y="1662605"/>
                    </a:cubicBezTo>
                    <a:cubicBezTo>
                      <a:pt x="3775441" y="1695770"/>
                      <a:pt x="3742277" y="1702876"/>
                      <a:pt x="3689371" y="1709983"/>
                    </a:cubicBezTo>
                    <a:cubicBezTo>
                      <a:pt x="3636465" y="1717090"/>
                      <a:pt x="3525916" y="1687083"/>
                      <a:pt x="3466693" y="1705245"/>
                    </a:cubicBezTo>
                    <a:cubicBezTo>
                      <a:pt x="3407470" y="1723407"/>
                      <a:pt x="3326138" y="1777892"/>
                      <a:pt x="3334034" y="1818953"/>
                    </a:cubicBezTo>
                    <a:cubicBezTo>
                      <a:pt x="3341930" y="1860014"/>
                      <a:pt x="3440635" y="1908972"/>
                      <a:pt x="3514071" y="1951612"/>
                    </a:cubicBezTo>
                    <a:cubicBezTo>
                      <a:pt x="3587507" y="1994252"/>
                      <a:pt x="3728063" y="2032945"/>
                      <a:pt x="3774652" y="2074796"/>
                    </a:cubicBezTo>
                    <a:cubicBezTo>
                      <a:pt x="3821241" y="2116647"/>
                      <a:pt x="3828347" y="2167973"/>
                      <a:pt x="3793603" y="2202717"/>
                    </a:cubicBezTo>
                    <a:cubicBezTo>
                      <a:pt x="3758859" y="2237461"/>
                      <a:pt x="3630148" y="2275364"/>
                      <a:pt x="3566187" y="2283260"/>
                    </a:cubicBezTo>
                    <a:cubicBezTo>
                      <a:pt x="3502226" y="2291156"/>
                      <a:pt x="3456427" y="2249305"/>
                      <a:pt x="3409839" y="2250095"/>
                    </a:cubicBezTo>
                    <a:cubicBezTo>
                      <a:pt x="3363251" y="2250885"/>
                      <a:pt x="3276391" y="2261150"/>
                      <a:pt x="3286656" y="2287998"/>
                    </a:cubicBezTo>
                    <a:cubicBezTo>
                      <a:pt x="3296921" y="2314846"/>
                      <a:pt x="3420105" y="2385913"/>
                      <a:pt x="3471431" y="2411181"/>
                    </a:cubicBezTo>
                    <a:cubicBezTo>
                      <a:pt x="3522757" y="2436449"/>
                      <a:pt x="3532233" y="2419078"/>
                      <a:pt x="3594614" y="2439608"/>
                    </a:cubicBezTo>
                    <a:cubicBezTo>
                      <a:pt x="3656995" y="2460138"/>
                      <a:pt x="3762807" y="2511464"/>
                      <a:pt x="3845719" y="2534364"/>
                    </a:cubicBezTo>
                    <a:cubicBezTo>
                      <a:pt x="3928631" y="2557264"/>
                      <a:pt x="4026546" y="2543051"/>
                      <a:pt x="4092086" y="2577005"/>
                    </a:cubicBezTo>
                    <a:cubicBezTo>
                      <a:pt x="4157626" y="2610960"/>
                      <a:pt x="4237379" y="2673341"/>
                      <a:pt x="4238958" y="2738091"/>
                    </a:cubicBezTo>
                    <a:cubicBezTo>
                      <a:pt x="4240537" y="2802841"/>
                      <a:pt x="4151308" y="2930762"/>
                      <a:pt x="4101561" y="2965506"/>
                    </a:cubicBezTo>
                    <a:cubicBezTo>
                      <a:pt x="4051814" y="3000250"/>
                      <a:pt x="4010753" y="2976561"/>
                      <a:pt x="3940475" y="2946555"/>
                    </a:cubicBezTo>
                    <a:cubicBezTo>
                      <a:pt x="3870197" y="2916549"/>
                      <a:pt x="3747804" y="2824951"/>
                      <a:pt x="3679895" y="2785469"/>
                    </a:cubicBezTo>
                    <a:cubicBezTo>
                      <a:pt x="3611986" y="2745987"/>
                      <a:pt x="3596194" y="2736512"/>
                      <a:pt x="3533023" y="2709664"/>
                    </a:cubicBezTo>
                    <a:cubicBezTo>
                      <a:pt x="3469852" y="2682816"/>
                      <a:pt x="3363250" y="2636227"/>
                      <a:pt x="3300869" y="2624383"/>
                    </a:cubicBezTo>
                    <a:cubicBezTo>
                      <a:pt x="3238488" y="2612539"/>
                      <a:pt x="3187161" y="2621225"/>
                      <a:pt x="3158734" y="2638597"/>
                    </a:cubicBezTo>
                    <a:cubicBezTo>
                      <a:pt x="3130307" y="2655969"/>
                      <a:pt x="3114515" y="2692292"/>
                      <a:pt x="3130308" y="2728615"/>
                    </a:cubicBezTo>
                    <a:cubicBezTo>
                      <a:pt x="3146101" y="2764938"/>
                      <a:pt x="3221906" y="2816265"/>
                      <a:pt x="3253491" y="2856536"/>
                    </a:cubicBezTo>
                    <a:cubicBezTo>
                      <a:pt x="3285076" y="2896808"/>
                      <a:pt x="3302448" y="2928393"/>
                      <a:pt x="3319820" y="2970244"/>
                    </a:cubicBezTo>
                    <a:cubicBezTo>
                      <a:pt x="3337192" y="3012095"/>
                      <a:pt x="3382202" y="3079214"/>
                      <a:pt x="3357723" y="3107641"/>
                    </a:cubicBezTo>
                    <a:cubicBezTo>
                      <a:pt x="3333244" y="3136068"/>
                      <a:pt x="3216378" y="3142385"/>
                      <a:pt x="3172948" y="3140806"/>
                    </a:cubicBezTo>
                    <a:cubicBezTo>
                      <a:pt x="3129518" y="3139227"/>
                      <a:pt x="3120832" y="3119486"/>
                      <a:pt x="3097143" y="3098166"/>
                    </a:cubicBezTo>
                    <a:cubicBezTo>
                      <a:pt x="3073454" y="3076846"/>
                      <a:pt x="3067926" y="3036574"/>
                      <a:pt x="3030813" y="3012885"/>
                    </a:cubicBezTo>
                    <a:cubicBezTo>
                      <a:pt x="2993700" y="2989196"/>
                      <a:pt x="2909209" y="2929973"/>
                      <a:pt x="2874465" y="2956031"/>
                    </a:cubicBezTo>
                    <a:cubicBezTo>
                      <a:pt x="2839721" y="2982089"/>
                      <a:pt x="2802608" y="3108431"/>
                      <a:pt x="2822349" y="3169233"/>
                    </a:cubicBezTo>
                    <a:cubicBezTo>
                      <a:pt x="2842090" y="3230035"/>
                      <a:pt x="2937636" y="3286099"/>
                      <a:pt x="2992911" y="3320843"/>
                    </a:cubicBezTo>
                    <a:cubicBezTo>
                      <a:pt x="3048186" y="3355587"/>
                      <a:pt x="3150049" y="3340584"/>
                      <a:pt x="3153997" y="3377697"/>
                    </a:cubicBezTo>
                    <a:cubicBezTo>
                      <a:pt x="3157945" y="3414810"/>
                      <a:pt x="3070295" y="3511146"/>
                      <a:pt x="3016600" y="3543521"/>
                    </a:cubicBezTo>
                    <a:cubicBezTo>
                      <a:pt x="2962905" y="3575896"/>
                      <a:pt x="2872886" y="3579844"/>
                      <a:pt x="2831825" y="3571948"/>
                    </a:cubicBezTo>
                    <a:cubicBezTo>
                      <a:pt x="2790764" y="3564052"/>
                      <a:pt x="2791553" y="3530887"/>
                      <a:pt x="2770233" y="3496143"/>
                    </a:cubicBezTo>
                    <a:cubicBezTo>
                      <a:pt x="2748913" y="3461399"/>
                      <a:pt x="2718906" y="3410862"/>
                      <a:pt x="2703903" y="3363484"/>
                    </a:cubicBezTo>
                    <a:cubicBezTo>
                      <a:pt x="2688900" y="3316106"/>
                      <a:pt x="2702324" y="3256882"/>
                      <a:pt x="2680214" y="3211873"/>
                    </a:cubicBezTo>
                    <a:cubicBezTo>
                      <a:pt x="2658104" y="3166864"/>
                      <a:pt x="2611516" y="3104483"/>
                      <a:pt x="2571244" y="3093428"/>
                    </a:cubicBezTo>
                    <a:cubicBezTo>
                      <a:pt x="2530973" y="3082373"/>
                      <a:pt x="2464643" y="3125014"/>
                      <a:pt x="2438585" y="3145544"/>
                    </a:cubicBezTo>
                    <a:cubicBezTo>
                      <a:pt x="2412527" y="3166075"/>
                      <a:pt x="2406210" y="3180288"/>
                      <a:pt x="2414896" y="3216611"/>
                    </a:cubicBezTo>
                    <a:cubicBezTo>
                      <a:pt x="2423582" y="3252934"/>
                      <a:pt x="2473329" y="3315316"/>
                      <a:pt x="2490701" y="3363484"/>
                    </a:cubicBezTo>
                    <a:cubicBezTo>
                      <a:pt x="2508073" y="3411652"/>
                      <a:pt x="2512021" y="3460609"/>
                      <a:pt x="2519128" y="3505618"/>
                    </a:cubicBezTo>
                    <a:cubicBezTo>
                      <a:pt x="2526235" y="3550627"/>
                      <a:pt x="2530183" y="3589320"/>
                      <a:pt x="2533342" y="3633540"/>
                    </a:cubicBezTo>
                    <a:cubicBezTo>
                      <a:pt x="2536501" y="3677760"/>
                      <a:pt x="2540449" y="3726716"/>
                      <a:pt x="2538080" y="3770936"/>
                    </a:cubicBezTo>
                    <a:cubicBezTo>
                      <a:pt x="2535711" y="3815156"/>
                      <a:pt x="2530973" y="3872010"/>
                      <a:pt x="2519128" y="3898858"/>
                    </a:cubicBezTo>
                    <a:cubicBezTo>
                      <a:pt x="2507283" y="3925706"/>
                      <a:pt x="2508073" y="3934392"/>
                      <a:pt x="2467012" y="3932023"/>
                    </a:cubicBezTo>
                    <a:cubicBezTo>
                      <a:pt x="2425951" y="3929654"/>
                      <a:pt x="2311453" y="3909912"/>
                      <a:pt x="2272761" y="3884644"/>
                    </a:cubicBezTo>
                    <a:cubicBezTo>
                      <a:pt x="2234069" y="3859376"/>
                      <a:pt x="2238017" y="3827000"/>
                      <a:pt x="2234859" y="3780412"/>
                    </a:cubicBezTo>
                    <a:cubicBezTo>
                      <a:pt x="2231701" y="3733824"/>
                      <a:pt x="2257758" y="3658808"/>
                      <a:pt x="2253810" y="3605113"/>
                    </a:cubicBezTo>
                    <a:cubicBezTo>
                      <a:pt x="2249862" y="3551418"/>
                      <a:pt x="2226963" y="3501670"/>
                      <a:pt x="2211170" y="3458240"/>
                    </a:cubicBezTo>
                    <a:cubicBezTo>
                      <a:pt x="2195377" y="3414810"/>
                      <a:pt x="2185112" y="3367432"/>
                      <a:pt x="2159054" y="3344532"/>
                    </a:cubicBezTo>
                    <a:cubicBezTo>
                      <a:pt x="2132996" y="3321633"/>
                      <a:pt x="2085618" y="3297944"/>
                      <a:pt x="2054822" y="3320843"/>
                    </a:cubicBezTo>
                    <a:cubicBezTo>
                      <a:pt x="2024026" y="3343743"/>
                      <a:pt x="1990072" y="3431392"/>
                      <a:pt x="1974279" y="3481929"/>
                    </a:cubicBezTo>
                    <a:cubicBezTo>
                      <a:pt x="1958486" y="3532466"/>
                      <a:pt x="1983754" y="3602744"/>
                      <a:pt x="1960065" y="3624064"/>
                    </a:cubicBezTo>
                    <a:cubicBezTo>
                      <a:pt x="1936376" y="3645384"/>
                      <a:pt x="1861361" y="3633539"/>
                      <a:pt x="1832144" y="3609850"/>
                    </a:cubicBezTo>
                    <a:cubicBezTo>
                      <a:pt x="1802928" y="3586161"/>
                      <a:pt x="1795821" y="3538783"/>
                      <a:pt x="1784766" y="3481929"/>
                    </a:cubicBezTo>
                    <a:cubicBezTo>
                      <a:pt x="1773711" y="3425075"/>
                      <a:pt x="1761866" y="3320053"/>
                      <a:pt x="1765814" y="3268727"/>
                    </a:cubicBezTo>
                    <a:cubicBezTo>
                      <a:pt x="1769762" y="3217401"/>
                      <a:pt x="1795031" y="3211873"/>
                      <a:pt x="1808455" y="3173971"/>
                    </a:cubicBezTo>
                    <a:cubicBezTo>
                      <a:pt x="1821879" y="3136069"/>
                      <a:pt x="1855833" y="3068160"/>
                      <a:pt x="1846357" y="3041312"/>
                    </a:cubicBezTo>
                    <a:cubicBezTo>
                      <a:pt x="1836881" y="3014464"/>
                      <a:pt x="1789504" y="2965507"/>
                      <a:pt x="1751601" y="3012885"/>
                    </a:cubicBezTo>
                    <a:cubicBezTo>
                      <a:pt x="1713698" y="3060263"/>
                      <a:pt x="1653686" y="3241090"/>
                      <a:pt x="1618942" y="3325581"/>
                    </a:cubicBezTo>
                    <a:cubicBezTo>
                      <a:pt x="1584198" y="3410072"/>
                      <a:pt x="1576302" y="3465347"/>
                      <a:pt x="1543137" y="3519832"/>
                    </a:cubicBezTo>
                    <a:cubicBezTo>
                      <a:pt x="1509972" y="3574317"/>
                      <a:pt x="1461804" y="3623275"/>
                      <a:pt x="1419953" y="3652491"/>
                    </a:cubicBezTo>
                    <a:cubicBezTo>
                      <a:pt x="1378102" y="3681707"/>
                      <a:pt x="1352044" y="3689604"/>
                      <a:pt x="1292032" y="3695131"/>
                    </a:cubicBezTo>
                    <a:cubicBezTo>
                      <a:pt x="1232020" y="3700658"/>
                      <a:pt x="1123839" y="3719610"/>
                      <a:pt x="1059879" y="3685656"/>
                    </a:cubicBezTo>
                    <a:cubicBezTo>
                      <a:pt x="995919" y="3651702"/>
                      <a:pt x="930378" y="3544311"/>
                      <a:pt x="908268" y="3491405"/>
                    </a:cubicBezTo>
                    <a:cubicBezTo>
                      <a:pt x="886158" y="3438499"/>
                      <a:pt x="902740" y="3391910"/>
                      <a:pt x="927219" y="3368221"/>
                    </a:cubicBezTo>
                    <a:cubicBezTo>
                      <a:pt x="951698" y="3344532"/>
                      <a:pt x="1012501" y="3358745"/>
                      <a:pt x="1055141" y="3349270"/>
                    </a:cubicBezTo>
                    <a:cubicBezTo>
                      <a:pt x="1097781" y="3339795"/>
                      <a:pt x="1144370" y="3332688"/>
                      <a:pt x="1183062" y="3311368"/>
                    </a:cubicBezTo>
                    <a:cubicBezTo>
                      <a:pt x="1221754" y="3290048"/>
                      <a:pt x="1252550" y="3260831"/>
                      <a:pt x="1287294" y="3221349"/>
                    </a:cubicBezTo>
                    <a:cubicBezTo>
                      <a:pt x="1322038" y="3181867"/>
                      <a:pt x="1365468" y="3121854"/>
                      <a:pt x="1391526" y="3074476"/>
                    </a:cubicBezTo>
                    <a:cubicBezTo>
                      <a:pt x="1417584" y="3027098"/>
                      <a:pt x="1434956" y="2981299"/>
                      <a:pt x="1443642" y="2937079"/>
                    </a:cubicBezTo>
                    <a:cubicBezTo>
                      <a:pt x="1452328" y="2892859"/>
                      <a:pt x="1461804" y="2829689"/>
                      <a:pt x="1443642" y="2809158"/>
                    </a:cubicBezTo>
                    <a:cubicBezTo>
                      <a:pt x="1425480" y="2788628"/>
                      <a:pt x="1385998" y="2790996"/>
                      <a:pt x="1334672" y="2813896"/>
                    </a:cubicBezTo>
                    <a:cubicBezTo>
                      <a:pt x="1283346" y="2836796"/>
                      <a:pt x="1190958" y="2907863"/>
                      <a:pt x="1135684" y="2946555"/>
                    </a:cubicBezTo>
                    <a:cubicBezTo>
                      <a:pt x="1080410" y="2985247"/>
                      <a:pt x="1041717" y="3010515"/>
                      <a:pt x="1003025" y="3046049"/>
                    </a:cubicBezTo>
                    <a:cubicBezTo>
                      <a:pt x="964333" y="3081583"/>
                      <a:pt x="952487" y="3132909"/>
                      <a:pt x="903530" y="3159757"/>
                    </a:cubicBezTo>
                    <a:cubicBezTo>
                      <a:pt x="854573" y="3186605"/>
                      <a:pt x="747972" y="3217400"/>
                      <a:pt x="709280" y="3207135"/>
                    </a:cubicBezTo>
                    <a:cubicBezTo>
                      <a:pt x="670588" y="3196870"/>
                      <a:pt x="669008" y="3147913"/>
                      <a:pt x="671377" y="3098166"/>
                    </a:cubicBezTo>
                    <a:cubicBezTo>
                      <a:pt x="673746" y="3048419"/>
                      <a:pt x="685590" y="2956821"/>
                      <a:pt x="723493" y="2908653"/>
                    </a:cubicBezTo>
                    <a:cubicBezTo>
                      <a:pt x="761396" y="2860485"/>
                      <a:pt x="833253" y="2832057"/>
                      <a:pt x="898793" y="2809158"/>
                    </a:cubicBezTo>
                    <a:cubicBezTo>
                      <a:pt x="964333" y="2786259"/>
                      <a:pt x="1056720" y="2797314"/>
                      <a:pt x="1116732" y="2771256"/>
                    </a:cubicBezTo>
                    <a:cubicBezTo>
                      <a:pt x="1176744" y="2745198"/>
                      <a:pt x="1233599" y="2683606"/>
                      <a:pt x="1258867" y="2652810"/>
                    </a:cubicBezTo>
                    <a:cubicBezTo>
                      <a:pt x="1284135" y="2622014"/>
                      <a:pt x="1295980" y="2598325"/>
                      <a:pt x="1268343" y="2586481"/>
                    </a:cubicBezTo>
                    <a:cubicBezTo>
                      <a:pt x="1240706" y="2574637"/>
                      <a:pt x="1147528" y="2577795"/>
                      <a:pt x="1093043" y="2581743"/>
                    </a:cubicBezTo>
                    <a:cubicBezTo>
                      <a:pt x="1038558" y="2585691"/>
                      <a:pt x="989601" y="2607012"/>
                      <a:pt x="941433" y="2610170"/>
                    </a:cubicBezTo>
                    <a:cubicBezTo>
                      <a:pt x="893265" y="2613328"/>
                      <a:pt x="819039" y="2622804"/>
                      <a:pt x="804036" y="2600694"/>
                    </a:cubicBezTo>
                    <a:cubicBezTo>
                      <a:pt x="789033" y="2578584"/>
                      <a:pt x="807984" y="2504359"/>
                      <a:pt x="851414" y="2477511"/>
                    </a:cubicBezTo>
                    <a:cubicBezTo>
                      <a:pt x="894844" y="2450663"/>
                      <a:pt x="996707" y="2473563"/>
                      <a:pt x="1064616" y="2439608"/>
                    </a:cubicBezTo>
                    <a:cubicBezTo>
                      <a:pt x="1132525" y="2405654"/>
                      <a:pt x="1252550" y="2303000"/>
                      <a:pt x="1258867" y="2273784"/>
                    </a:cubicBezTo>
                    <a:cubicBezTo>
                      <a:pt x="1265184" y="2244568"/>
                      <a:pt x="1160162" y="2257992"/>
                      <a:pt x="1102519" y="2264309"/>
                    </a:cubicBezTo>
                    <a:cubicBezTo>
                      <a:pt x="1044876" y="2270626"/>
                      <a:pt x="980125" y="2299843"/>
                      <a:pt x="913006" y="2311687"/>
                    </a:cubicBezTo>
                    <a:cubicBezTo>
                      <a:pt x="845887" y="2323532"/>
                      <a:pt x="723493" y="2353538"/>
                      <a:pt x="699804" y="2335376"/>
                    </a:cubicBezTo>
                    <a:cubicBezTo>
                      <a:pt x="676115" y="2317214"/>
                      <a:pt x="714017" y="2235092"/>
                      <a:pt x="770871" y="2202717"/>
                    </a:cubicBezTo>
                    <a:cubicBezTo>
                      <a:pt x="827725" y="2170342"/>
                      <a:pt x="979335" y="2168762"/>
                      <a:pt x="1040927" y="2141125"/>
                    </a:cubicBezTo>
                    <a:cubicBezTo>
                      <a:pt x="1102519" y="2113488"/>
                      <a:pt x="1161742" y="2059003"/>
                      <a:pt x="1140422" y="2036893"/>
                    </a:cubicBezTo>
                    <a:cubicBezTo>
                      <a:pt x="1119102" y="2014783"/>
                      <a:pt x="995128" y="2009256"/>
                      <a:pt x="913006" y="2008466"/>
                    </a:cubicBezTo>
                    <a:cubicBezTo>
                      <a:pt x="830884" y="2007676"/>
                      <a:pt x="647688" y="2032155"/>
                      <a:pt x="647688" y="2032155"/>
                    </a:cubicBezTo>
                    <a:cubicBezTo>
                      <a:pt x="555301" y="2040841"/>
                      <a:pt x="462123" y="2065320"/>
                      <a:pt x="358681" y="2060582"/>
                    </a:cubicBezTo>
                    <a:cubicBezTo>
                      <a:pt x="255238" y="2055844"/>
                      <a:pt x="81518" y="2044789"/>
                      <a:pt x="27033" y="2003728"/>
                    </a:cubicBezTo>
                    <a:cubicBezTo>
                      <a:pt x="-27452" y="1962667"/>
                      <a:pt x="14399" y="1865541"/>
                      <a:pt x="31771" y="1814215"/>
                    </a:cubicBezTo>
                    <a:cubicBezTo>
                      <a:pt x="49143" y="1762889"/>
                      <a:pt x="63356" y="1708404"/>
                      <a:pt x="131265" y="1695770"/>
                    </a:cubicBezTo>
                    <a:cubicBezTo>
                      <a:pt x="199174" y="1683136"/>
                      <a:pt x="352364" y="1731303"/>
                      <a:pt x="439224" y="1738410"/>
                    </a:cubicBezTo>
                    <a:cubicBezTo>
                      <a:pt x="526084" y="1745517"/>
                      <a:pt x="565566" y="1742358"/>
                      <a:pt x="652426" y="1738410"/>
                    </a:cubicBezTo>
                    <a:cubicBezTo>
                      <a:pt x="739286" y="1734462"/>
                      <a:pt x="899582" y="1728145"/>
                      <a:pt x="960384" y="1714721"/>
                    </a:cubicBezTo>
                    <a:cubicBezTo>
                      <a:pt x="1021186" y="1701297"/>
                      <a:pt x="1041717" y="1676818"/>
                      <a:pt x="1017238" y="1657867"/>
                    </a:cubicBezTo>
                    <a:cubicBezTo>
                      <a:pt x="992759" y="1638916"/>
                      <a:pt x="867997" y="1608120"/>
                      <a:pt x="813512" y="1601013"/>
                    </a:cubicBezTo>
                    <a:cubicBezTo>
                      <a:pt x="759027" y="1593906"/>
                      <a:pt x="740075" y="1615227"/>
                      <a:pt x="690328" y="1615227"/>
                    </a:cubicBezTo>
                    <a:cubicBezTo>
                      <a:pt x="640581" y="1615227"/>
                      <a:pt x="553721" y="1619964"/>
                      <a:pt x="515029" y="1601013"/>
                    </a:cubicBezTo>
                    <a:cubicBezTo>
                      <a:pt x="476337" y="1582062"/>
                      <a:pt x="456596" y="1535473"/>
                      <a:pt x="458175" y="1501519"/>
                    </a:cubicBezTo>
                    <a:cubicBezTo>
                      <a:pt x="459754" y="1467565"/>
                      <a:pt x="492919" y="1422555"/>
                      <a:pt x="524504" y="1397287"/>
                    </a:cubicBezTo>
                    <a:cubicBezTo>
                      <a:pt x="556089" y="1372019"/>
                      <a:pt x="601889" y="1357805"/>
                      <a:pt x="647688" y="1349909"/>
                    </a:cubicBezTo>
                    <a:cubicBezTo>
                      <a:pt x="693487" y="1342013"/>
                      <a:pt x="766923" y="1336485"/>
                      <a:pt x="799298" y="1349909"/>
                    </a:cubicBezTo>
                    <a:cubicBezTo>
                      <a:pt x="831673" y="1363333"/>
                      <a:pt x="810353" y="1449403"/>
                      <a:pt x="832463" y="1477830"/>
                    </a:cubicBezTo>
                    <a:close/>
                  </a:path>
                </a:pathLst>
              </a:custGeom>
              <a:solidFill>
                <a:schemeClr val="accent4">
                  <a:lumMod val="20000"/>
                  <a:lumOff val="80000"/>
                </a:schemeClr>
              </a:solidFill>
            </p:spPr>
            <p:style>
              <a:lnRef idx="2">
                <a:schemeClr val="accent4">
                  <a:shade val="50000"/>
                </a:schemeClr>
              </a:lnRef>
              <a:fillRef idx="1">
                <a:schemeClr val="accent4"/>
              </a:fillRef>
              <a:effectRef idx="0">
                <a:schemeClr val="accent4"/>
              </a:effectRef>
              <a:fontRef idx="minor">
                <a:schemeClr val="lt1"/>
              </a:fontRef>
            </p:style>
            <p:txBody>
              <a:bodyPr rot="0" spcFirstLastPara="0" vertOverflow="overflow" horzOverflow="overflow" vert="horz" wrap="square" lIns="75631" tIns="37816" rIns="75631" bIns="37816" numCol="1" spcCol="0" rtlCol="0" fromWordArt="0" anchor="ctr" anchorCtr="0" forceAA="0" compatLnSpc="1">
                <a:prstTxWarp prst="textNoShape">
                  <a:avLst/>
                </a:prstTxWarp>
                <a:noAutofit/>
              </a:bodyPr>
              <a:lstStyle/>
              <a:p>
                <a:pPr algn="ctr"/>
                <a:endParaRPr lang="en-US" sz="1489"/>
              </a:p>
            </p:txBody>
          </p:sp>
          <p:sp>
            <p:nvSpPr>
              <p:cNvPr id="17" name="Oval 16"/>
              <p:cNvSpPr/>
              <p:nvPr/>
            </p:nvSpPr>
            <p:spPr>
              <a:xfrm rot="2360062">
                <a:off x="2150972" y="2051476"/>
                <a:ext cx="644345" cy="1108651"/>
              </a:xfrm>
              <a:prstGeom prst="ellipse">
                <a:avLst/>
              </a:prstGeom>
            </p:spPr>
            <p:style>
              <a:lnRef idx="2">
                <a:schemeClr val="accent5">
                  <a:shade val="50000"/>
                </a:schemeClr>
              </a:lnRef>
              <a:fillRef idx="1">
                <a:schemeClr val="accent5"/>
              </a:fillRef>
              <a:effectRef idx="0">
                <a:schemeClr val="accent5"/>
              </a:effectRef>
              <a:fontRef idx="minor">
                <a:schemeClr val="lt1"/>
              </a:fontRef>
            </p:style>
            <p:txBody>
              <a:bodyPr rot="0" spcFirstLastPara="0" vertOverflow="overflow" horzOverflow="overflow" vert="horz" wrap="square" lIns="75631" tIns="37816" rIns="75631" bIns="37816" numCol="1" spcCol="0" rtlCol="0" fromWordArt="0" anchor="ctr" anchorCtr="0" forceAA="0" compatLnSpc="1">
                <a:prstTxWarp prst="textNoShape">
                  <a:avLst/>
                </a:prstTxWarp>
                <a:noAutofit/>
              </a:bodyPr>
              <a:lstStyle/>
              <a:p>
                <a:pPr algn="ctr"/>
                <a:endParaRPr lang="en-US" sz="1489"/>
              </a:p>
            </p:txBody>
          </p:sp>
        </p:grpSp>
        <p:cxnSp>
          <p:nvCxnSpPr>
            <p:cNvPr id="18" name="Straight Arrow Connector 17"/>
            <p:cNvCxnSpPr/>
            <p:nvPr/>
          </p:nvCxnSpPr>
          <p:spPr>
            <a:xfrm>
              <a:off x="4690127" y="1506794"/>
              <a:ext cx="47970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9" name="Straight Arrow Connector 18"/>
            <p:cNvCxnSpPr/>
            <p:nvPr/>
          </p:nvCxnSpPr>
          <p:spPr>
            <a:xfrm>
              <a:off x="4625939" y="2427962"/>
              <a:ext cx="479704"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 name="TextBox 19"/>
            <p:cNvSpPr txBox="1"/>
            <p:nvPr/>
          </p:nvSpPr>
          <p:spPr>
            <a:xfrm>
              <a:off x="4560535" y="1184759"/>
              <a:ext cx="774438" cy="276999"/>
            </a:xfrm>
            <a:prstGeom prst="rect">
              <a:avLst/>
            </a:prstGeom>
            <a:noFill/>
          </p:spPr>
          <p:txBody>
            <a:bodyPr wrap="square" rtlCol="0">
              <a:spAutoFit/>
            </a:bodyPr>
            <a:lstStyle/>
            <a:p>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Alb</a:t>
              </a:r>
              <a:endParaRPr lang="en-US" sz="1200" baseline="30000" dirty="0">
                <a:latin typeface="Arial" panose="020B0604020202020204" pitchFamily="34" charset="0"/>
                <a:cs typeface="Arial" panose="020B0604020202020204" pitchFamily="34" charset="0"/>
              </a:endParaRPr>
            </a:p>
          </p:txBody>
        </p:sp>
        <p:sp>
          <p:nvSpPr>
            <p:cNvPr id="22" name="TextBox 21"/>
            <p:cNvSpPr txBox="1"/>
            <p:nvPr/>
          </p:nvSpPr>
          <p:spPr>
            <a:xfrm>
              <a:off x="4564780" y="2125681"/>
              <a:ext cx="774438" cy="276999"/>
            </a:xfrm>
            <a:prstGeom prst="rect">
              <a:avLst/>
            </a:prstGeom>
            <a:noFill/>
          </p:spPr>
          <p:txBody>
            <a:bodyPr wrap="square" rtlCol="0">
              <a:spAutoFit/>
            </a:bodyPr>
            <a:lstStyle/>
            <a:p>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Lyz</a:t>
              </a:r>
              <a:endParaRPr lang="en-US" sz="1200" baseline="30000" dirty="0">
                <a:latin typeface="Arial" panose="020B0604020202020204" pitchFamily="34" charset="0"/>
                <a:cs typeface="Arial" panose="020B0604020202020204" pitchFamily="34" charset="0"/>
              </a:endParaRPr>
            </a:p>
          </p:txBody>
        </p:sp>
        <p:sp>
          <p:nvSpPr>
            <p:cNvPr id="23" name="TextBox 22"/>
            <p:cNvSpPr txBox="1"/>
            <p:nvPr/>
          </p:nvSpPr>
          <p:spPr>
            <a:xfrm>
              <a:off x="5047536" y="1256760"/>
              <a:ext cx="1871091" cy="461665"/>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Hepatocyte-specific </a:t>
              </a:r>
            </a:p>
            <a:p>
              <a:pPr algn="ctr"/>
              <a:r>
                <a:rPr lang="en-US" sz="1200" dirty="0">
                  <a:latin typeface="Arial" panose="020B0604020202020204" pitchFamily="34" charset="0"/>
                  <a:cs typeface="Arial" panose="020B0604020202020204" pitchFamily="34" charset="0"/>
                </a:rPr>
                <a:t>CHI3L1 K.O</a:t>
              </a:r>
              <a:endParaRPr lang="en-US" sz="1200" i="1" baseline="30000" dirty="0">
                <a:latin typeface="Arial" panose="020B0604020202020204" pitchFamily="34" charset="0"/>
                <a:cs typeface="Arial" panose="020B0604020202020204" pitchFamily="34" charset="0"/>
              </a:endParaRPr>
            </a:p>
          </p:txBody>
        </p:sp>
        <p:sp>
          <p:nvSpPr>
            <p:cNvPr id="24" name="TextBox 23"/>
            <p:cNvSpPr txBox="1"/>
            <p:nvPr/>
          </p:nvSpPr>
          <p:spPr>
            <a:xfrm>
              <a:off x="5054592" y="2693932"/>
              <a:ext cx="1797691" cy="461665"/>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Myeloid cell-specific CHI3L1 K.O</a:t>
              </a:r>
              <a:endParaRPr lang="en-US" sz="1200" i="1" baseline="30000" dirty="0">
                <a:latin typeface="Arial" panose="020B0604020202020204" pitchFamily="34" charset="0"/>
                <a:cs typeface="Arial" panose="020B0604020202020204" pitchFamily="34" charset="0"/>
              </a:endParaRPr>
            </a:p>
          </p:txBody>
        </p:sp>
        <p:sp>
          <p:nvSpPr>
            <p:cNvPr id="26" name="TextBox 25"/>
            <p:cNvSpPr txBox="1"/>
            <p:nvPr/>
          </p:nvSpPr>
          <p:spPr>
            <a:xfrm>
              <a:off x="0" y="-19948"/>
              <a:ext cx="24056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grpSp>
          <p:nvGrpSpPr>
            <p:cNvPr id="36" name="Group 35">
              <a:extLst>
                <a:ext uri="{FF2B5EF4-FFF2-40B4-BE49-F238E27FC236}">
                  <a16:creationId xmlns:a16="http://schemas.microsoft.com/office/drawing/2014/main" id="{4A398C0A-3604-4DBB-A4CA-E43ADA62504C}"/>
                </a:ext>
              </a:extLst>
            </p:cNvPr>
            <p:cNvGrpSpPr/>
            <p:nvPr/>
          </p:nvGrpSpPr>
          <p:grpSpPr>
            <a:xfrm>
              <a:off x="94918" y="389820"/>
              <a:ext cx="4531021" cy="2497571"/>
              <a:chOff x="250529" y="932336"/>
              <a:chExt cx="3402961" cy="2497571"/>
            </a:xfrm>
          </p:grpSpPr>
          <p:sp>
            <p:nvSpPr>
              <p:cNvPr id="35" name="Rectangle 34">
                <a:extLst>
                  <a:ext uri="{FF2B5EF4-FFF2-40B4-BE49-F238E27FC236}">
                    <a16:creationId xmlns:a16="http://schemas.microsoft.com/office/drawing/2014/main" id="{288EE6E5-0B00-498A-BF09-4A407473DA96}"/>
                  </a:ext>
                </a:extLst>
              </p:cNvPr>
              <p:cNvSpPr/>
              <p:nvPr/>
            </p:nvSpPr>
            <p:spPr>
              <a:xfrm>
                <a:off x="250529" y="932336"/>
                <a:ext cx="3402961" cy="2497571"/>
              </a:xfrm>
              <a:prstGeom prst="rect">
                <a:avLst/>
              </a:prstGeom>
              <a:solidFill>
                <a:srgbClr val="F5F5F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grpSp>
            <p:nvGrpSpPr>
              <p:cNvPr id="34" name="Group 33">
                <a:extLst>
                  <a:ext uri="{FF2B5EF4-FFF2-40B4-BE49-F238E27FC236}">
                    <a16:creationId xmlns:a16="http://schemas.microsoft.com/office/drawing/2014/main" id="{79A6F8B2-BE51-4E05-8282-B3A0EC83EACD}"/>
                  </a:ext>
                </a:extLst>
              </p:cNvPr>
              <p:cNvGrpSpPr/>
              <p:nvPr/>
            </p:nvGrpSpPr>
            <p:grpSpPr>
              <a:xfrm>
                <a:off x="269580" y="1005116"/>
                <a:ext cx="2749846" cy="622921"/>
                <a:chOff x="269580" y="961410"/>
                <a:chExt cx="2749846" cy="622921"/>
              </a:xfrm>
            </p:grpSpPr>
            <p:pic>
              <p:nvPicPr>
                <p:cNvPr id="6" name="Picture 5">
                  <a:extLst>
                    <a:ext uri="{FF2B5EF4-FFF2-40B4-BE49-F238E27FC236}">
                      <a16:creationId xmlns:a16="http://schemas.microsoft.com/office/drawing/2014/main" id="{5CB23050-03BA-46AD-A63D-C76FE5E046BA}"/>
                    </a:ext>
                  </a:extLst>
                </p:cNvPr>
                <p:cNvPicPr>
                  <a:picLocks noChangeAspect="1"/>
                </p:cNvPicPr>
                <p:nvPr/>
              </p:nvPicPr>
              <p:blipFill>
                <a:blip r:embed="rId3"/>
                <a:stretch>
                  <a:fillRect/>
                </a:stretch>
              </p:blipFill>
              <p:spPr>
                <a:xfrm>
                  <a:off x="269580" y="1013209"/>
                  <a:ext cx="2749846" cy="571122"/>
                </a:xfrm>
                <a:prstGeom prst="rect">
                  <a:avLst/>
                </a:prstGeom>
              </p:spPr>
            </p:pic>
            <p:sp>
              <p:nvSpPr>
                <p:cNvPr id="10" name="TextBox 9">
                  <a:extLst>
                    <a:ext uri="{FF2B5EF4-FFF2-40B4-BE49-F238E27FC236}">
                      <a16:creationId xmlns:a16="http://schemas.microsoft.com/office/drawing/2014/main" id="{92A45826-8A00-4568-92A6-A3AD463D7F38}"/>
                    </a:ext>
                  </a:extLst>
                </p:cNvPr>
                <p:cNvSpPr txBox="1"/>
                <p:nvPr/>
              </p:nvSpPr>
              <p:spPr>
                <a:xfrm>
                  <a:off x="472837" y="961410"/>
                  <a:ext cx="123825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Wild-type allele</a:t>
                  </a:r>
                </a:p>
              </p:txBody>
            </p:sp>
          </p:grpSp>
          <p:pic>
            <p:nvPicPr>
              <p:cNvPr id="21" name="Picture 20">
                <a:extLst>
                  <a:ext uri="{FF2B5EF4-FFF2-40B4-BE49-F238E27FC236}">
                    <a16:creationId xmlns:a16="http://schemas.microsoft.com/office/drawing/2014/main" id="{D7EF6AEF-DC54-4A97-8F3E-07598D162B2F}"/>
                  </a:ext>
                </a:extLst>
              </p:cNvPr>
              <p:cNvPicPr>
                <a:picLocks noChangeAspect="1"/>
              </p:cNvPicPr>
              <p:nvPr/>
            </p:nvPicPr>
            <p:blipFill>
              <a:blip r:embed="rId4"/>
              <a:stretch>
                <a:fillRect/>
              </a:stretch>
            </p:blipFill>
            <p:spPr>
              <a:xfrm>
                <a:off x="269579" y="1681864"/>
                <a:ext cx="3383911" cy="532510"/>
              </a:xfrm>
              <a:prstGeom prst="rect">
                <a:avLst/>
              </a:prstGeom>
            </p:spPr>
          </p:pic>
          <p:sp>
            <p:nvSpPr>
              <p:cNvPr id="28" name="TextBox 27">
                <a:extLst>
                  <a:ext uri="{FF2B5EF4-FFF2-40B4-BE49-F238E27FC236}">
                    <a16:creationId xmlns:a16="http://schemas.microsoft.com/office/drawing/2014/main" id="{A7B11376-B4B0-41F4-A74A-8A4725D3D5F6}"/>
                  </a:ext>
                </a:extLst>
              </p:cNvPr>
              <p:cNvSpPr txBox="1"/>
              <p:nvPr/>
            </p:nvSpPr>
            <p:spPr>
              <a:xfrm>
                <a:off x="380251" y="1615887"/>
                <a:ext cx="225742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utant allele 1 (targeted allele)</a:t>
                </a:r>
              </a:p>
            </p:txBody>
          </p:sp>
          <p:pic>
            <p:nvPicPr>
              <p:cNvPr id="29" name="Picture 28">
                <a:extLst>
                  <a:ext uri="{FF2B5EF4-FFF2-40B4-BE49-F238E27FC236}">
                    <a16:creationId xmlns:a16="http://schemas.microsoft.com/office/drawing/2014/main" id="{9BDC75C7-F59D-4AFD-BD01-C2482F2DCC15}"/>
                  </a:ext>
                </a:extLst>
              </p:cNvPr>
              <p:cNvPicPr>
                <a:picLocks noChangeAspect="1"/>
              </p:cNvPicPr>
              <p:nvPr/>
            </p:nvPicPr>
            <p:blipFill>
              <a:blip r:embed="rId5"/>
              <a:stretch>
                <a:fillRect/>
              </a:stretch>
            </p:blipFill>
            <p:spPr>
              <a:xfrm>
                <a:off x="270951" y="2264557"/>
                <a:ext cx="2748475" cy="586167"/>
              </a:xfrm>
              <a:prstGeom prst="rect">
                <a:avLst/>
              </a:prstGeom>
            </p:spPr>
          </p:pic>
          <p:sp>
            <p:nvSpPr>
              <p:cNvPr id="30" name="TextBox 29">
                <a:extLst>
                  <a:ext uri="{FF2B5EF4-FFF2-40B4-BE49-F238E27FC236}">
                    <a16:creationId xmlns:a16="http://schemas.microsoft.com/office/drawing/2014/main" id="{8520FA9B-EBF2-4AE3-9892-C15FF22C1D58}"/>
                  </a:ext>
                </a:extLst>
              </p:cNvPr>
              <p:cNvSpPr txBox="1"/>
              <p:nvPr/>
            </p:nvSpPr>
            <p:spPr>
              <a:xfrm>
                <a:off x="380251" y="2196241"/>
                <a:ext cx="225742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utant allele 2 (after Neo deletion)</a:t>
                </a:r>
              </a:p>
            </p:txBody>
          </p:sp>
          <p:pic>
            <p:nvPicPr>
              <p:cNvPr id="32" name="Picture 31">
                <a:extLst>
                  <a:ext uri="{FF2B5EF4-FFF2-40B4-BE49-F238E27FC236}">
                    <a16:creationId xmlns:a16="http://schemas.microsoft.com/office/drawing/2014/main" id="{DF9D11AE-7021-479C-8F16-808F06A56FA2}"/>
                  </a:ext>
                </a:extLst>
              </p:cNvPr>
              <p:cNvPicPr>
                <a:picLocks noChangeAspect="1"/>
              </p:cNvPicPr>
              <p:nvPr/>
            </p:nvPicPr>
            <p:blipFill rotWithShape="1">
              <a:blip r:embed="rId6"/>
              <a:srcRect l="688" r="1"/>
              <a:stretch/>
            </p:blipFill>
            <p:spPr>
              <a:xfrm>
                <a:off x="269581" y="2910622"/>
                <a:ext cx="2313995" cy="503143"/>
              </a:xfrm>
              <a:prstGeom prst="rect">
                <a:avLst/>
              </a:prstGeom>
            </p:spPr>
          </p:pic>
          <p:sp>
            <p:nvSpPr>
              <p:cNvPr id="33" name="TextBox 32">
                <a:extLst>
                  <a:ext uri="{FF2B5EF4-FFF2-40B4-BE49-F238E27FC236}">
                    <a16:creationId xmlns:a16="http://schemas.microsoft.com/office/drawing/2014/main" id="{742734D7-D966-44EA-A677-9A787DDB2B51}"/>
                  </a:ext>
                </a:extLst>
              </p:cNvPr>
              <p:cNvSpPr txBox="1"/>
              <p:nvPr/>
            </p:nvSpPr>
            <p:spPr>
              <a:xfrm>
                <a:off x="390081" y="2862399"/>
                <a:ext cx="2257425"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Mutant allele 3 (after </a:t>
                </a:r>
                <a:r>
                  <a:rPr lang="en-US" sz="800" dirty="0" err="1">
                    <a:latin typeface="Arial" panose="020B0604020202020204" pitchFamily="34" charset="0"/>
                    <a:cs typeface="Arial" panose="020B0604020202020204" pitchFamily="34" charset="0"/>
                  </a:rPr>
                  <a:t>Cre</a:t>
                </a:r>
                <a:r>
                  <a:rPr lang="en-US" sz="800" dirty="0">
                    <a:latin typeface="Arial" panose="020B0604020202020204" pitchFamily="34" charset="0"/>
                    <a:cs typeface="Arial" panose="020B0604020202020204" pitchFamily="34" charset="0"/>
                  </a:rPr>
                  <a:t> recombination)</a:t>
                </a:r>
              </a:p>
            </p:txBody>
          </p:sp>
        </p:grpSp>
        <p:pic>
          <p:nvPicPr>
            <p:cNvPr id="37" name="Picture 36">
              <a:extLst>
                <a:ext uri="{FF2B5EF4-FFF2-40B4-BE49-F238E27FC236}">
                  <a16:creationId xmlns:a16="http://schemas.microsoft.com/office/drawing/2014/main" id="{2D85D511-E035-4D78-B494-E15ED079BF3A}"/>
                </a:ext>
              </a:extLst>
            </p:cNvPr>
            <p:cNvPicPr>
              <a:picLocks noChangeAspect="1"/>
            </p:cNvPicPr>
            <p:nvPr/>
          </p:nvPicPr>
          <p:blipFill>
            <a:blip r:embed="rId7"/>
            <a:stretch>
              <a:fillRect/>
            </a:stretch>
          </p:blipFill>
          <p:spPr>
            <a:xfrm>
              <a:off x="94917" y="2883418"/>
              <a:ext cx="4531022" cy="831978"/>
            </a:xfrm>
            <a:prstGeom prst="rect">
              <a:avLst/>
            </a:prstGeom>
          </p:spPr>
        </p:pic>
        <p:sp>
          <p:nvSpPr>
            <p:cNvPr id="2" name="TextBox 1">
              <a:extLst>
                <a:ext uri="{FF2B5EF4-FFF2-40B4-BE49-F238E27FC236}">
                  <a16:creationId xmlns:a16="http://schemas.microsoft.com/office/drawing/2014/main" id="{33A48050-CE9A-486D-AE9F-EA22A3A52D98}"/>
                </a:ext>
              </a:extLst>
            </p:cNvPr>
            <p:cNvSpPr txBox="1"/>
            <p:nvPr/>
          </p:nvSpPr>
          <p:spPr>
            <a:xfrm>
              <a:off x="456627" y="3190145"/>
              <a:ext cx="425988" cy="200055"/>
            </a:xfrm>
            <a:prstGeom prst="rect">
              <a:avLst/>
            </a:prstGeom>
            <a:solidFill>
              <a:srgbClr val="F5F5F5"/>
            </a:solidFill>
          </p:spPr>
          <p:txBody>
            <a:bodyPr wrap="square" rtlCol="0">
              <a:spAutoFit/>
            </a:bodyPr>
            <a:lstStyle/>
            <a:p>
              <a:r>
                <a:rPr lang="en-US" sz="700" dirty="0">
                  <a:latin typeface="Arial" panose="020B0604020202020204" pitchFamily="34" charset="0"/>
                  <a:cs typeface="Arial" panose="020B0604020202020204" pitchFamily="34" charset="0"/>
                </a:rPr>
                <a:t>Exon</a:t>
              </a:r>
            </a:p>
          </p:txBody>
        </p:sp>
        <p:sp>
          <p:nvSpPr>
            <p:cNvPr id="40" name="TextBox 39">
              <a:extLst>
                <a:ext uri="{FF2B5EF4-FFF2-40B4-BE49-F238E27FC236}">
                  <a16:creationId xmlns:a16="http://schemas.microsoft.com/office/drawing/2014/main" id="{5C44AECB-F716-45B5-B6D2-4098419F3CED}"/>
                </a:ext>
              </a:extLst>
            </p:cNvPr>
            <p:cNvSpPr txBox="1"/>
            <p:nvPr/>
          </p:nvSpPr>
          <p:spPr>
            <a:xfrm>
              <a:off x="1030592" y="3190145"/>
              <a:ext cx="704594" cy="200055"/>
            </a:xfrm>
            <a:prstGeom prst="rect">
              <a:avLst/>
            </a:prstGeom>
            <a:solidFill>
              <a:srgbClr val="F5F5F5"/>
            </a:solidFill>
          </p:spPr>
          <p:txBody>
            <a:bodyPr wrap="square" rtlCol="0">
              <a:spAutoFit/>
            </a:bodyPr>
            <a:lstStyle/>
            <a:p>
              <a:r>
                <a:rPr lang="en-US" sz="700" dirty="0" err="1">
                  <a:latin typeface="Arial" panose="020B0604020202020204" pitchFamily="34" charset="0"/>
                  <a:cs typeface="Arial" panose="020B0604020202020204" pitchFamily="34" charset="0"/>
                </a:rPr>
                <a:t>loxP</a:t>
              </a:r>
              <a:r>
                <a:rPr lang="en-US" sz="700" dirty="0">
                  <a:latin typeface="Arial" panose="020B0604020202020204" pitchFamily="34" charset="0"/>
                  <a:cs typeface="Arial" panose="020B0604020202020204" pitchFamily="34" charset="0"/>
                </a:rPr>
                <a:t> site</a:t>
              </a:r>
            </a:p>
          </p:txBody>
        </p:sp>
        <p:sp>
          <p:nvSpPr>
            <p:cNvPr id="41" name="TextBox 40">
              <a:extLst>
                <a:ext uri="{FF2B5EF4-FFF2-40B4-BE49-F238E27FC236}">
                  <a16:creationId xmlns:a16="http://schemas.microsoft.com/office/drawing/2014/main" id="{202E47B1-3B55-4BE5-AB92-C6E897B1DF57}"/>
                </a:ext>
              </a:extLst>
            </p:cNvPr>
            <p:cNvSpPr txBox="1"/>
            <p:nvPr/>
          </p:nvSpPr>
          <p:spPr>
            <a:xfrm>
              <a:off x="1888010" y="3181167"/>
              <a:ext cx="704594" cy="200055"/>
            </a:xfrm>
            <a:prstGeom prst="rect">
              <a:avLst/>
            </a:prstGeom>
            <a:solidFill>
              <a:srgbClr val="F5F5F5"/>
            </a:solidFill>
          </p:spPr>
          <p:txBody>
            <a:bodyPr wrap="square" rtlCol="0">
              <a:spAutoFit/>
            </a:bodyPr>
            <a:lstStyle/>
            <a:p>
              <a:r>
                <a:rPr lang="en-US" sz="700" dirty="0" err="1">
                  <a:latin typeface="Arial" panose="020B0604020202020204" pitchFamily="34" charset="0"/>
                  <a:cs typeface="Arial" panose="020B0604020202020204" pitchFamily="34" charset="0"/>
                </a:rPr>
                <a:t>cKO</a:t>
              </a:r>
              <a:r>
                <a:rPr lang="en-US" sz="700" dirty="0">
                  <a:latin typeface="Arial" panose="020B0604020202020204" pitchFamily="34" charset="0"/>
                  <a:cs typeface="Arial" panose="020B0604020202020204" pitchFamily="34" charset="0"/>
                </a:rPr>
                <a:t> region</a:t>
              </a:r>
            </a:p>
          </p:txBody>
        </p:sp>
        <p:sp>
          <p:nvSpPr>
            <p:cNvPr id="42" name="TextBox 41">
              <a:extLst>
                <a:ext uri="{FF2B5EF4-FFF2-40B4-BE49-F238E27FC236}">
                  <a16:creationId xmlns:a16="http://schemas.microsoft.com/office/drawing/2014/main" id="{2ACFB039-E2DE-402D-82B5-40FB4F46601C}"/>
                </a:ext>
              </a:extLst>
            </p:cNvPr>
            <p:cNvSpPr txBox="1"/>
            <p:nvPr/>
          </p:nvSpPr>
          <p:spPr>
            <a:xfrm>
              <a:off x="2884597" y="3211789"/>
              <a:ext cx="1675938" cy="200055"/>
            </a:xfrm>
            <a:prstGeom prst="rect">
              <a:avLst/>
            </a:prstGeom>
            <a:solidFill>
              <a:srgbClr val="F5F5F5"/>
            </a:solidFill>
          </p:spPr>
          <p:txBody>
            <a:bodyPr wrap="square" rtlCol="0">
              <a:spAutoFit/>
            </a:bodyPr>
            <a:lstStyle/>
            <a:p>
              <a:r>
                <a:rPr lang="en-US" sz="700" dirty="0">
                  <a:latin typeface="Arial" panose="020B0604020202020204" pitchFamily="34" charset="0"/>
                  <a:cs typeface="Arial" panose="020B0604020202020204" pitchFamily="34" charset="0"/>
                </a:rPr>
                <a:t>SDA(self-deletion anchor) site</a:t>
              </a:r>
            </a:p>
          </p:txBody>
        </p:sp>
        <p:sp>
          <p:nvSpPr>
            <p:cNvPr id="43" name="TextBox 42">
              <a:extLst>
                <a:ext uri="{FF2B5EF4-FFF2-40B4-BE49-F238E27FC236}">
                  <a16:creationId xmlns:a16="http://schemas.microsoft.com/office/drawing/2014/main" id="{ABF27DBC-8B05-48E5-9FFA-53E88474411A}"/>
                </a:ext>
              </a:extLst>
            </p:cNvPr>
            <p:cNvSpPr txBox="1"/>
            <p:nvPr/>
          </p:nvSpPr>
          <p:spPr>
            <a:xfrm>
              <a:off x="548820" y="3495024"/>
              <a:ext cx="844186" cy="200055"/>
            </a:xfrm>
            <a:prstGeom prst="rect">
              <a:avLst/>
            </a:prstGeom>
            <a:solidFill>
              <a:srgbClr val="F5F5F5"/>
            </a:solidFill>
          </p:spPr>
          <p:txBody>
            <a:bodyPr wrap="square" rtlCol="0">
              <a:spAutoFit/>
            </a:bodyPr>
            <a:lstStyle/>
            <a:p>
              <a:r>
                <a:rPr lang="en-US" sz="700" dirty="0">
                  <a:latin typeface="Arial" panose="020B0604020202020204" pitchFamily="34" charset="0"/>
                  <a:cs typeface="Arial" panose="020B0604020202020204" pitchFamily="34" charset="0"/>
                </a:rPr>
                <a:t>Homology arm</a:t>
              </a:r>
            </a:p>
          </p:txBody>
        </p:sp>
      </p:grpSp>
      <p:sp>
        <p:nvSpPr>
          <p:cNvPr id="44" name="TextBox 43">
            <a:extLst>
              <a:ext uri="{FF2B5EF4-FFF2-40B4-BE49-F238E27FC236}">
                <a16:creationId xmlns:a16="http://schemas.microsoft.com/office/drawing/2014/main" id="{A35BFB09-5BA6-48FE-87BF-6E22FD6F84F9}"/>
              </a:ext>
            </a:extLst>
          </p:cNvPr>
          <p:cNvSpPr txBox="1"/>
          <p:nvPr/>
        </p:nvSpPr>
        <p:spPr>
          <a:xfrm rot="16200000">
            <a:off x="1157010" y="5764098"/>
            <a:ext cx="919743"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CHI3L1</a:t>
            </a:r>
          </a:p>
        </p:txBody>
      </p:sp>
      <p:sp>
        <p:nvSpPr>
          <p:cNvPr id="45" name="TextBox 44">
            <a:extLst>
              <a:ext uri="{FF2B5EF4-FFF2-40B4-BE49-F238E27FC236}">
                <a16:creationId xmlns:a16="http://schemas.microsoft.com/office/drawing/2014/main" id="{8D9EA7AD-2DB4-4801-9508-EC29B1ECE426}"/>
              </a:ext>
            </a:extLst>
          </p:cNvPr>
          <p:cNvSpPr txBox="1"/>
          <p:nvPr/>
        </p:nvSpPr>
        <p:spPr>
          <a:xfrm rot="16200000">
            <a:off x="1184362" y="7094475"/>
            <a:ext cx="801806"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Merge</a:t>
            </a:r>
          </a:p>
        </p:txBody>
      </p:sp>
      <p:sp>
        <p:nvSpPr>
          <p:cNvPr id="46" name="TextBox 45">
            <a:extLst>
              <a:ext uri="{FF2B5EF4-FFF2-40B4-BE49-F238E27FC236}">
                <a16:creationId xmlns:a16="http://schemas.microsoft.com/office/drawing/2014/main" id="{8A986FCB-6397-4956-B9CC-47D1F779AEFC}"/>
              </a:ext>
            </a:extLst>
          </p:cNvPr>
          <p:cNvSpPr txBox="1"/>
          <p:nvPr/>
        </p:nvSpPr>
        <p:spPr>
          <a:xfrm rot="16200000">
            <a:off x="838788" y="4430055"/>
            <a:ext cx="1524540" cy="246221"/>
          </a:xfrm>
          <a:prstGeom prst="rect">
            <a:avLst/>
          </a:prstGeom>
          <a:noFill/>
        </p:spPr>
        <p:txBody>
          <a:bodyPr wrap="square" rtlCol="0">
            <a:spAutoFit/>
          </a:bodyPr>
          <a:lstStyle/>
          <a:p>
            <a:pPr algn="ctr"/>
            <a:r>
              <a:rPr lang="en-US" sz="1000" dirty="0">
                <a:latin typeface="Arial" panose="020B0604020202020204" pitchFamily="34" charset="0"/>
                <a:cs typeface="Arial" panose="020B0604020202020204" pitchFamily="34" charset="0"/>
              </a:rPr>
              <a:t>Macrophage marker</a:t>
            </a:r>
          </a:p>
        </p:txBody>
      </p:sp>
      <p:sp>
        <p:nvSpPr>
          <p:cNvPr id="47" name="TextBox 46">
            <a:extLst>
              <a:ext uri="{FF2B5EF4-FFF2-40B4-BE49-F238E27FC236}">
                <a16:creationId xmlns:a16="http://schemas.microsoft.com/office/drawing/2014/main" id="{D1A982FC-77F1-490D-9319-BDCDAF2C98AC}"/>
              </a:ext>
            </a:extLst>
          </p:cNvPr>
          <p:cNvSpPr txBox="1"/>
          <p:nvPr/>
        </p:nvSpPr>
        <p:spPr>
          <a:xfrm>
            <a:off x="2508731" y="7740838"/>
            <a:ext cx="935531" cy="184666"/>
          </a:xfrm>
          <a:prstGeom prst="rect">
            <a:avLst/>
          </a:prstGeom>
          <a:noFill/>
        </p:spPr>
        <p:txBody>
          <a:bodyPr wrap="square" rtlCol="0">
            <a:spAutoFit/>
          </a:bodyPr>
          <a:lstStyle/>
          <a:p>
            <a:pPr algn="ctr"/>
            <a:r>
              <a:rPr lang="en-US" sz="600" dirty="0">
                <a:solidFill>
                  <a:schemeClr val="accent6">
                    <a:lumMod val="75000"/>
                  </a:schemeClr>
                </a:solidFill>
                <a:latin typeface="Arial" panose="020B0604020202020204" pitchFamily="34" charset="0"/>
                <a:cs typeface="Arial" panose="020B0604020202020204" pitchFamily="34" charset="0"/>
              </a:rPr>
              <a:t>CHI3L1, </a:t>
            </a:r>
            <a:r>
              <a:rPr lang="en-US" sz="600" dirty="0">
                <a:solidFill>
                  <a:srgbClr val="FF0000"/>
                </a:solidFill>
                <a:latin typeface="Arial" panose="020B0604020202020204" pitchFamily="34" charset="0"/>
                <a:cs typeface="Arial" panose="020B0604020202020204" pitchFamily="34" charset="0"/>
              </a:rPr>
              <a:t>F4/80,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48" name="TextBox 47">
            <a:extLst>
              <a:ext uri="{FF2B5EF4-FFF2-40B4-BE49-F238E27FC236}">
                <a16:creationId xmlns:a16="http://schemas.microsoft.com/office/drawing/2014/main" id="{3F9EF498-C4F4-42AB-B408-ACCF273A732F}"/>
              </a:ext>
            </a:extLst>
          </p:cNvPr>
          <p:cNvSpPr txBox="1"/>
          <p:nvPr/>
        </p:nvSpPr>
        <p:spPr>
          <a:xfrm>
            <a:off x="4121724" y="7731991"/>
            <a:ext cx="1117756"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CHI3L1, </a:t>
            </a:r>
            <a:r>
              <a:rPr lang="en-US" sz="600" dirty="0">
                <a:solidFill>
                  <a:schemeClr val="accent6">
                    <a:lumMod val="75000"/>
                  </a:schemeClr>
                </a:solidFill>
                <a:latin typeface="Arial" panose="020B0604020202020204" pitchFamily="34" charset="0"/>
                <a:cs typeface="Arial" panose="020B0604020202020204" pitchFamily="34" charset="0"/>
              </a:rPr>
              <a:t>CLEC4F,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49" name="TextBox 48">
            <a:extLst>
              <a:ext uri="{FF2B5EF4-FFF2-40B4-BE49-F238E27FC236}">
                <a16:creationId xmlns:a16="http://schemas.microsoft.com/office/drawing/2014/main" id="{1A638A7A-9E14-4AB6-A64B-8A19A0A2BA98}"/>
              </a:ext>
            </a:extLst>
          </p:cNvPr>
          <p:cNvSpPr txBox="1"/>
          <p:nvPr/>
        </p:nvSpPr>
        <p:spPr>
          <a:xfrm>
            <a:off x="2758973" y="6431056"/>
            <a:ext cx="701746" cy="184666"/>
          </a:xfrm>
          <a:prstGeom prst="rect">
            <a:avLst/>
          </a:prstGeom>
          <a:noFill/>
        </p:spPr>
        <p:txBody>
          <a:bodyPr wrap="square" rtlCol="0">
            <a:spAutoFit/>
          </a:bodyPr>
          <a:lstStyle/>
          <a:p>
            <a:pPr algn="ctr"/>
            <a:r>
              <a:rPr lang="en-US" sz="600" dirty="0">
                <a:solidFill>
                  <a:schemeClr val="accent6">
                    <a:lumMod val="75000"/>
                  </a:schemeClr>
                </a:solidFill>
                <a:latin typeface="Arial" panose="020B0604020202020204" pitchFamily="34" charset="0"/>
                <a:cs typeface="Arial" panose="020B0604020202020204" pitchFamily="34" charset="0"/>
              </a:rPr>
              <a:t>CHI3L1,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0" name="TextBox 49">
            <a:extLst>
              <a:ext uri="{FF2B5EF4-FFF2-40B4-BE49-F238E27FC236}">
                <a16:creationId xmlns:a16="http://schemas.microsoft.com/office/drawing/2014/main" id="{B3C5D8FF-C204-4278-B296-262F1488A263}"/>
              </a:ext>
            </a:extLst>
          </p:cNvPr>
          <p:cNvSpPr txBox="1"/>
          <p:nvPr/>
        </p:nvSpPr>
        <p:spPr>
          <a:xfrm>
            <a:off x="2776375" y="5102943"/>
            <a:ext cx="701746"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F4/80,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1" name="TextBox 50">
            <a:extLst>
              <a:ext uri="{FF2B5EF4-FFF2-40B4-BE49-F238E27FC236}">
                <a16:creationId xmlns:a16="http://schemas.microsoft.com/office/drawing/2014/main" id="{C5D5DB04-3DE4-4BB0-97CD-A44CF2DB91CC}"/>
              </a:ext>
            </a:extLst>
          </p:cNvPr>
          <p:cNvSpPr txBox="1"/>
          <p:nvPr/>
        </p:nvSpPr>
        <p:spPr>
          <a:xfrm>
            <a:off x="4447155" y="6432575"/>
            <a:ext cx="807925"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CHI3L1,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2" name="TextBox 51">
            <a:extLst>
              <a:ext uri="{FF2B5EF4-FFF2-40B4-BE49-F238E27FC236}">
                <a16:creationId xmlns:a16="http://schemas.microsoft.com/office/drawing/2014/main" id="{DA7B3B7F-B373-4CA7-AE42-314E89605D06}"/>
              </a:ext>
            </a:extLst>
          </p:cNvPr>
          <p:cNvSpPr txBox="1"/>
          <p:nvPr/>
        </p:nvSpPr>
        <p:spPr>
          <a:xfrm>
            <a:off x="4381744" y="5110827"/>
            <a:ext cx="888722" cy="184666"/>
          </a:xfrm>
          <a:prstGeom prst="rect">
            <a:avLst/>
          </a:prstGeom>
          <a:noFill/>
        </p:spPr>
        <p:txBody>
          <a:bodyPr wrap="square" rtlCol="0">
            <a:spAutoFit/>
          </a:bodyPr>
          <a:lstStyle/>
          <a:p>
            <a:pPr algn="ctr"/>
            <a:r>
              <a:rPr lang="en-US" sz="600" dirty="0">
                <a:solidFill>
                  <a:schemeClr val="accent6">
                    <a:lumMod val="75000"/>
                  </a:schemeClr>
                </a:solidFill>
                <a:latin typeface="Arial" panose="020B0604020202020204" pitchFamily="34" charset="0"/>
                <a:cs typeface="Arial" panose="020B0604020202020204" pitchFamily="34" charset="0"/>
              </a:rPr>
              <a:t>CLEC4F,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3" name="TextBox 52">
            <a:extLst>
              <a:ext uri="{FF2B5EF4-FFF2-40B4-BE49-F238E27FC236}">
                <a16:creationId xmlns:a16="http://schemas.microsoft.com/office/drawing/2014/main" id="{7550AAE5-2C90-4B51-9948-31A247666205}"/>
              </a:ext>
            </a:extLst>
          </p:cNvPr>
          <p:cNvSpPr txBox="1"/>
          <p:nvPr/>
        </p:nvSpPr>
        <p:spPr>
          <a:xfrm>
            <a:off x="6178524" y="6418561"/>
            <a:ext cx="763292" cy="184666"/>
          </a:xfrm>
          <a:prstGeom prst="rect">
            <a:avLst/>
          </a:prstGeom>
          <a:noFill/>
        </p:spPr>
        <p:txBody>
          <a:bodyPr wrap="square" rtlCol="0">
            <a:spAutoFit/>
          </a:bodyPr>
          <a:lstStyle/>
          <a:p>
            <a:pPr algn="ctr"/>
            <a:r>
              <a:rPr lang="en-US" sz="600" dirty="0">
                <a:solidFill>
                  <a:schemeClr val="accent6">
                    <a:lumMod val="75000"/>
                  </a:schemeClr>
                </a:solidFill>
                <a:latin typeface="Arial" panose="020B0604020202020204" pitchFamily="34" charset="0"/>
                <a:cs typeface="Arial" panose="020B0604020202020204" pitchFamily="34" charset="0"/>
              </a:rPr>
              <a:t>CHI3L1,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4" name="TextBox 53">
            <a:extLst>
              <a:ext uri="{FF2B5EF4-FFF2-40B4-BE49-F238E27FC236}">
                <a16:creationId xmlns:a16="http://schemas.microsoft.com/office/drawing/2014/main" id="{901EAD0E-95F1-4DA1-8710-9019D18CA8D7}"/>
              </a:ext>
            </a:extLst>
          </p:cNvPr>
          <p:cNvSpPr txBox="1"/>
          <p:nvPr/>
        </p:nvSpPr>
        <p:spPr>
          <a:xfrm>
            <a:off x="6269996" y="5109777"/>
            <a:ext cx="658332"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Ly6C,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sp>
        <p:nvSpPr>
          <p:cNvPr id="55" name="TextBox 54">
            <a:extLst>
              <a:ext uri="{FF2B5EF4-FFF2-40B4-BE49-F238E27FC236}">
                <a16:creationId xmlns:a16="http://schemas.microsoft.com/office/drawing/2014/main" id="{CAC4F5D1-BF88-4882-BA6D-629E4B87F67D}"/>
              </a:ext>
            </a:extLst>
          </p:cNvPr>
          <p:cNvSpPr txBox="1"/>
          <p:nvPr/>
        </p:nvSpPr>
        <p:spPr>
          <a:xfrm>
            <a:off x="6011656" y="7722466"/>
            <a:ext cx="889826" cy="184666"/>
          </a:xfrm>
          <a:prstGeom prst="rect">
            <a:avLst/>
          </a:prstGeom>
          <a:noFill/>
        </p:spPr>
        <p:txBody>
          <a:bodyPr wrap="square" rtlCol="0">
            <a:spAutoFit/>
          </a:bodyPr>
          <a:lstStyle/>
          <a:p>
            <a:pPr algn="ctr"/>
            <a:r>
              <a:rPr lang="en-US" sz="600" dirty="0">
                <a:solidFill>
                  <a:srgbClr val="FF0000"/>
                </a:solidFill>
                <a:latin typeface="Arial" panose="020B0604020202020204" pitchFamily="34" charset="0"/>
                <a:cs typeface="Arial" panose="020B0604020202020204" pitchFamily="34" charset="0"/>
              </a:rPr>
              <a:t>Ly6C, </a:t>
            </a:r>
            <a:r>
              <a:rPr lang="en-US" sz="600" dirty="0">
                <a:solidFill>
                  <a:schemeClr val="accent6">
                    <a:lumMod val="75000"/>
                  </a:schemeClr>
                </a:solidFill>
                <a:latin typeface="Arial" panose="020B0604020202020204" pitchFamily="34" charset="0"/>
                <a:cs typeface="Arial" panose="020B0604020202020204" pitchFamily="34" charset="0"/>
              </a:rPr>
              <a:t>CHI3L1, </a:t>
            </a:r>
            <a:r>
              <a:rPr lang="en-US" sz="600" dirty="0">
                <a:solidFill>
                  <a:schemeClr val="accent1">
                    <a:lumMod val="75000"/>
                  </a:schemeClr>
                </a:solidFill>
                <a:latin typeface="Arial" panose="020B0604020202020204" pitchFamily="34" charset="0"/>
                <a:cs typeface="Arial" panose="020B0604020202020204" pitchFamily="34" charset="0"/>
              </a:rPr>
              <a:t>DAPI</a:t>
            </a:r>
          </a:p>
        </p:txBody>
      </p:sp>
      <p:pic>
        <p:nvPicPr>
          <p:cNvPr id="56" name="Picture 55">
            <a:extLst>
              <a:ext uri="{FF2B5EF4-FFF2-40B4-BE49-F238E27FC236}">
                <a16:creationId xmlns:a16="http://schemas.microsoft.com/office/drawing/2014/main" id="{6335A62F-47CE-4EB0-811F-F7B9BCBBE027}"/>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3358555" y="3926374"/>
            <a:ext cx="1714053" cy="1222307"/>
          </a:xfrm>
          <a:prstGeom prst="rect">
            <a:avLst/>
          </a:prstGeom>
        </p:spPr>
      </p:pic>
      <p:pic>
        <p:nvPicPr>
          <p:cNvPr id="57" name="Picture 56">
            <a:extLst>
              <a:ext uri="{FF2B5EF4-FFF2-40B4-BE49-F238E27FC236}">
                <a16:creationId xmlns:a16="http://schemas.microsoft.com/office/drawing/2014/main" id="{5B9BF0F1-A82D-4773-9F7B-A7D63402E955}"/>
              </a:ext>
            </a:extLst>
          </p:cNvPr>
          <p:cNvPicPr>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3360908" y="5254905"/>
            <a:ext cx="1714052" cy="1221845"/>
          </a:xfrm>
          <a:prstGeom prst="rect">
            <a:avLst/>
          </a:prstGeom>
        </p:spPr>
      </p:pic>
      <p:pic>
        <p:nvPicPr>
          <p:cNvPr id="58" name="Picture 57">
            <a:extLst>
              <a:ext uri="{FF2B5EF4-FFF2-40B4-BE49-F238E27FC236}">
                <a16:creationId xmlns:a16="http://schemas.microsoft.com/office/drawing/2014/main" id="{1C814353-EFEB-4A19-8A71-F256F714FA20}"/>
              </a:ext>
            </a:extLst>
          </p:cNvPr>
          <p:cNvPicPr>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3358555" y="6567075"/>
            <a:ext cx="1725929" cy="1213243"/>
          </a:xfrm>
          <a:prstGeom prst="rect">
            <a:avLst/>
          </a:prstGeom>
        </p:spPr>
      </p:pic>
      <p:pic>
        <p:nvPicPr>
          <p:cNvPr id="59" name="Picture 58">
            <a:extLst>
              <a:ext uri="{FF2B5EF4-FFF2-40B4-BE49-F238E27FC236}">
                <a16:creationId xmlns:a16="http://schemas.microsoft.com/office/drawing/2014/main" id="{6851A098-0C12-4FD7-B96E-DF2A8021A09F}"/>
              </a:ext>
            </a:extLst>
          </p:cNvPr>
          <p:cNvPicPr>
            <a:picLocks noChangeAspect="1"/>
          </p:cNvPicPr>
          <p:nvPr/>
        </p:nvPicPr>
        <p:blipFill>
          <a:blip r:embed="rId11" cstate="hqprint">
            <a:extLst>
              <a:ext uri="{28A0092B-C50C-407E-A947-70E740481C1C}">
                <a14:useLocalDpi xmlns:a14="http://schemas.microsoft.com/office/drawing/2010/main" val="0"/>
              </a:ext>
            </a:extLst>
          </a:blip>
          <a:stretch>
            <a:fillRect/>
          </a:stretch>
        </p:blipFill>
        <p:spPr>
          <a:xfrm>
            <a:off x="1688017" y="6559975"/>
            <a:ext cx="1647953" cy="1221844"/>
          </a:xfrm>
          <a:prstGeom prst="rect">
            <a:avLst/>
          </a:prstGeom>
        </p:spPr>
      </p:pic>
      <p:pic>
        <p:nvPicPr>
          <p:cNvPr id="60" name="Picture 59">
            <a:extLst>
              <a:ext uri="{FF2B5EF4-FFF2-40B4-BE49-F238E27FC236}">
                <a16:creationId xmlns:a16="http://schemas.microsoft.com/office/drawing/2014/main" id="{594B211F-31AE-4EB3-A6D3-32DE9CCD3E01}"/>
              </a:ext>
            </a:extLst>
          </p:cNvPr>
          <p:cNvPicPr>
            <a:picLocks noChangeAspect="1"/>
          </p:cNvPicPr>
          <p:nvPr/>
        </p:nvPicPr>
        <p:blipFill>
          <a:blip r:embed="rId12" cstate="hqprint">
            <a:extLst>
              <a:ext uri="{28A0092B-C50C-407E-A947-70E740481C1C}">
                <a14:useLocalDpi xmlns:a14="http://schemas.microsoft.com/office/drawing/2010/main" val="0"/>
              </a:ext>
            </a:extLst>
          </a:blip>
          <a:stretch>
            <a:fillRect/>
          </a:stretch>
        </p:blipFill>
        <p:spPr>
          <a:xfrm>
            <a:off x="1696749" y="3925523"/>
            <a:ext cx="1649510" cy="1223161"/>
          </a:xfrm>
          <a:prstGeom prst="rect">
            <a:avLst/>
          </a:prstGeom>
        </p:spPr>
      </p:pic>
      <p:pic>
        <p:nvPicPr>
          <p:cNvPr id="61" name="Picture 60">
            <a:extLst>
              <a:ext uri="{FF2B5EF4-FFF2-40B4-BE49-F238E27FC236}">
                <a16:creationId xmlns:a16="http://schemas.microsoft.com/office/drawing/2014/main" id="{FE58F853-E2E9-449E-AA56-149658CEC01E}"/>
              </a:ext>
            </a:extLst>
          </p:cNvPr>
          <p:cNvPicPr>
            <a:picLocks noChangeAspect="1"/>
          </p:cNvPicPr>
          <p:nvPr/>
        </p:nvPicPr>
        <p:blipFill>
          <a:blip r:embed="rId13" cstate="hqprint">
            <a:extLst>
              <a:ext uri="{28A0092B-C50C-407E-A947-70E740481C1C}">
                <a14:useLocalDpi xmlns:a14="http://schemas.microsoft.com/office/drawing/2010/main" val="0"/>
              </a:ext>
            </a:extLst>
          </a:blip>
          <a:stretch>
            <a:fillRect/>
          </a:stretch>
        </p:blipFill>
        <p:spPr>
          <a:xfrm>
            <a:off x="1694146" y="5257232"/>
            <a:ext cx="1647953" cy="1221845"/>
          </a:xfrm>
          <a:prstGeom prst="rect">
            <a:avLst/>
          </a:prstGeom>
        </p:spPr>
      </p:pic>
      <p:pic>
        <p:nvPicPr>
          <p:cNvPr id="62" name="Picture 61">
            <a:extLst>
              <a:ext uri="{FF2B5EF4-FFF2-40B4-BE49-F238E27FC236}">
                <a16:creationId xmlns:a16="http://schemas.microsoft.com/office/drawing/2014/main" id="{FCB32EA1-5301-4FA0-AADC-38AB09D7A5F2}"/>
              </a:ext>
            </a:extLst>
          </p:cNvPr>
          <p:cNvPicPr>
            <a:picLocks noChangeAspect="1"/>
          </p:cNvPicPr>
          <p:nvPr/>
        </p:nvPicPr>
        <p:blipFill>
          <a:blip r:embed="rId14" cstate="hqprint">
            <a:extLst>
              <a:ext uri="{28A0092B-C50C-407E-A947-70E740481C1C}">
                <a14:useLocalDpi xmlns:a14="http://schemas.microsoft.com/office/drawing/2010/main" val="0"/>
              </a:ext>
            </a:extLst>
          </a:blip>
          <a:stretch>
            <a:fillRect/>
          </a:stretch>
        </p:blipFill>
        <p:spPr>
          <a:xfrm>
            <a:off x="5094393" y="5254905"/>
            <a:ext cx="1703914" cy="1221844"/>
          </a:xfrm>
          <a:prstGeom prst="rect">
            <a:avLst/>
          </a:prstGeom>
        </p:spPr>
      </p:pic>
      <p:pic>
        <p:nvPicPr>
          <p:cNvPr id="63" name="Picture 62">
            <a:extLst>
              <a:ext uri="{FF2B5EF4-FFF2-40B4-BE49-F238E27FC236}">
                <a16:creationId xmlns:a16="http://schemas.microsoft.com/office/drawing/2014/main" id="{8068498A-2177-461B-A183-8B203298877D}"/>
              </a:ext>
            </a:extLst>
          </p:cNvPr>
          <p:cNvPicPr>
            <a:picLocks noChangeAspect="1"/>
          </p:cNvPicPr>
          <p:nvPr/>
        </p:nvPicPr>
        <p:blipFill>
          <a:blip r:embed="rId15" cstate="hqprint">
            <a:extLst>
              <a:ext uri="{28A0092B-C50C-407E-A947-70E740481C1C}">
                <a14:useLocalDpi xmlns:a14="http://schemas.microsoft.com/office/drawing/2010/main" val="0"/>
              </a:ext>
            </a:extLst>
          </a:blip>
          <a:stretch>
            <a:fillRect/>
          </a:stretch>
        </p:blipFill>
        <p:spPr>
          <a:xfrm>
            <a:off x="5105643" y="6567074"/>
            <a:ext cx="1692664" cy="1213243"/>
          </a:xfrm>
          <a:prstGeom prst="rect">
            <a:avLst/>
          </a:prstGeom>
        </p:spPr>
      </p:pic>
      <p:pic>
        <p:nvPicPr>
          <p:cNvPr id="64" name="Picture 63">
            <a:extLst>
              <a:ext uri="{FF2B5EF4-FFF2-40B4-BE49-F238E27FC236}">
                <a16:creationId xmlns:a16="http://schemas.microsoft.com/office/drawing/2014/main" id="{7988EC75-A89E-4169-A97B-C663269E142E}"/>
              </a:ext>
            </a:extLst>
          </p:cNvPr>
          <p:cNvPicPr>
            <a:picLocks noChangeAspect="1"/>
          </p:cNvPicPr>
          <p:nvPr/>
        </p:nvPicPr>
        <p:blipFill>
          <a:blip r:embed="rId16" cstate="hqprint">
            <a:extLst>
              <a:ext uri="{28A0092B-C50C-407E-A947-70E740481C1C}">
                <a14:useLocalDpi xmlns:a14="http://schemas.microsoft.com/office/drawing/2010/main" val="0"/>
              </a:ext>
            </a:extLst>
          </a:blip>
          <a:stretch>
            <a:fillRect/>
          </a:stretch>
        </p:blipFill>
        <p:spPr>
          <a:xfrm>
            <a:off x="5084485" y="3926835"/>
            <a:ext cx="1713822" cy="1221845"/>
          </a:xfrm>
          <a:prstGeom prst="rect">
            <a:avLst/>
          </a:prstGeom>
        </p:spPr>
      </p:pic>
      <p:sp>
        <p:nvSpPr>
          <p:cNvPr id="66" name="TextBox 65">
            <a:extLst>
              <a:ext uri="{FF2B5EF4-FFF2-40B4-BE49-F238E27FC236}">
                <a16:creationId xmlns:a16="http://schemas.microsoft.com/office/drawing/2014/main" id="{A987EAB1-701B-4406-95A2-1E396AEEA305}"/>
              </a:ext>
            </a:extLst>
          </p:cNvPr>
          <p:cNvSpPr txBox="1"/>
          <p:nvPr/>
        </p:nvSpPr>
        <p:spPr>
          <a:xfrm>
            <a:off x="1411848" y="3728343"/>
            <a:ext cx="24056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42027704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rotWithShape="1">
          <a:blip r:embed="rId2" cstate="print">
            <a:extLst>
              <a:ext uri="{28A0092B-C50C-407E-A947-70E740481C1C}">
                <a14:useLocalDpi xmlns:a14="http://schemas.microsoft.com/office/drawing/2010/main" val="0"/>
              </a:ext>
            </a:extLst>
          </a:blip>
          <a:srcRect l="-1" t="-408" r="332"/>
          <a:stretch/>
        </p:blipFill>
        <p:spPr>
          <a:xfrm>
            <a:off x="1595299" y="3419203"/>
            <a:ext cx="1043819" cy="587484"/>
          </a:xfrm>
          <a:prstGeom prst="rect">
            <a:avLst/>
          </a:prstGeom>
          <a:ln w="3175">
            <a:solidFill>
              <a:schemeClr val="tx1"/>
            </a:solidFill>
          </a:ln>
        </p:spPr>
      </p:pic>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32038" y="2791304"/>
            <a:ext cx="1043819" cy="587484"/>
          </a:xfrm>
          <a:prstGeom prst="rect">
            <a:avLst/>
          </a:prstGeom>
          <a:ln w="3175">
            <a:solidFill>
              <a:schemeClr val="tx1"/>
            </a:solidFill>
          </a:ln>
        </p:spPr>
      </p:pic>
      <p:pic>
        <p:nvPicPr>
          <p:cNvPr id="7" name="Picture 6"/>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contrast="20000"/>
                    </a14:imgEffect>
                  </a14:imgLayer>
                </a14:imgProps>
              </a:ext>
              <a:ext uri="{28A0092B-C50C-407E-A947-70E740481C1C}">
                <a14:useLocalDpi xmlns:a14="http://schemas.microsoft.com/office/drawing/2010/main" val="0"/>
              </a:ext>
            </a:extLst>
          </a:blip>
          <a:srcRect l="-1" t="-303" r="-29"/>
          <a:stretch/>
        </p:blipFill>
        <p:spPr>
          <a:xfrm>
            <a:off x="532039" y="3419204"/>
            <a:ext cx="1040757" cy="587484"/>
          </a:xfrm>
          <a:prstGeom prst="rect">
            <a:avLst/>
          </a:prstGeom>
          <a:ln w="3175">
            <a:solidFill>
              <a:schemeClr val="tx1"/>
            </a:solidFill>
          </a:ln>
        </p:spPr>
      </p:pic>
      <p:pic>
        <p:nvPicPr>
          <p:cNvPr id="8" name="Picture 7"/>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595299" y="2791304"/>
            <a:ext cx="1043819" cy="587484"/>
          </a:xfrm>
          <a:prstGeom prst="rect">
            <a:avLst/>
          </a:prstGeom>
          <a:ln w="3175">
            <a:solidFill>
              <a:schemeClr val="tx1"/>
            </a:solidFill>
          </a:ln>
        </p:spPr>
      </p:pic>
      <p:pic>
        <p:nvPicPr>
          <p:cNvPr id="10" name="Picture 9"/>
          <p:cNvPicPr>
            <a:picLocks noChangeAspect="1"/>
          </p:cNvPicPr>
          <p:nvPr/>
        </p:nvPicPr>
        <p:blipFill>
          <a:blip r:embed="rId7" cstate="print">
            <a:extLst>
              <a:ext uri="{BEBA8EAE-BF5A-486C-A8C5-ECC9F3942E4B}">
                <a14:imgProps xmlns:a14="http://schemas.microsoft.com/office/drawing/2010/main">
                  <a14:imgLayer r:embed="rId8">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27550" y="4670805"/>
            <a:ext cx="1043819" cy="587484"/>
          </a:xfrm>
          <a:prstGeom prst="rect">
            <a:avLst/>
          </a:prstGeom>
          <a:ln w="3175">
            <a:solidFill>
              <a:schemeClr val="tx1"/>
            </a:solidFill>
          </a:ln>
        </p:spPr>
      </p:pic>
      <p:pic>
        <p:nvPicPr>
          <p:cNvPr id="11" name="Picture 10"/>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590811" y="4670805"/>
            <a:ext cx="1043819" cy="587484"/>
          </a:xfrm>
          <a:prstGeom prst="rect">
            <a:avLst/>
          </a:prstGeom>
          <a:ln w="3175">
            <a:solidFill>
              <a:schemeClr val="tx1"/>
            </a:solidFill>
          </a:ln>
        </p:spPr>
      </p:pic>
      <p:pic>
        <p:nvPicPr>
          <p:cNvPr id="13" name="Picture 12"/>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593768" y="4045005"/>
            <a:ext cx="1043819" cy="587484"/>
          </a:xfrm>
          <a:prstGeom prst="rect">
            <a:avLst/>
          </a:prstGeom>
          <a:ln w="3175">
            <a:solidFill>
              <a:schemeClr val="tx1"/>
            </a:solidFill>
          </a:ln>
        </p:spPr>
      </p:pic>
      <p:pic>
        <p:nvPicPr>
          <p:cNvPr id="15" name="Picture 14"/>
          <p:cNvPicPr>
            <a:picLocks noChangeAspect="1"/>
          </p:cNvPicPr>
          <p:nvPr/>
        </p:nvPicPr>
        <p:blipFill>
          <a:blip r:embed="rId11" cstate="print">
            <a:extLst>
              <a:ext uri="{BEBA8EAE-BF5A-486C-A8C5-ECC9F3942E4B}">
                <a14:imgProps xmlns:a14="http://schemas.microsoft.com/office/drawing/2010/main">
                  <a14:imgLayer r:embed="rId12">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28976" y="4045005"/>
            <a:ext cx="1043819" cy="587484"/>
          </a:xfrm>
          <a:prstGeom prst="rect">
            <a:avLst/>
          </a:prstGeom>
          <a:ln w="3175">
            <a:solidFill>
              <a:schemeClr val="tx1"/>
            </a:solidFill>
          </a:ln>
        </p:spPr>
      </p:pic>
      <p:sp>
        <p:nvSpPr>
          <p:cNvPr id="16" name="TextBox 15"/>
          <p:cNvSpPr txBox="1"/>
          <p:nvPr/>
        </p:nvSpPr>
        <p:spPr>
          <a:xfrm>
            <a:off x="840385" y="2608428"/>
            <a:ext cx="544450"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ontrol</a:t>
            </a:r>
          </a:p>
        </p:txBody>
      </p:sp>
      <p:sp>
        <p:nvSpPr>
          <p:cNvPr id="17" name="TextBox 16"/>
          <p:cNvSpPr txBox="1"/>
          <p:nvPr/>
        </p:nvSpPr>
        <p:spPr>
          <a:xfrm>
            <a:off x="1980424" y="2608980"/>
            <a:ext cx="352485" cy="215444"/>
          </a:xfrm>
          <a:prstGeom prst="rect">
            <a:avLst/>
          </a:prstGeom>
          <a:noFill/>
        </p:spPr>
        <p:txBody>
          <a:bodyPr wrap="square" rtlCol="0">
            <a:spAutoFit/>
          </a:bodyPr>
          <a:lstStyle/>
          <a:p>
            <a:r>
              <a:rPr lang="en-US" sz="800">
                <a:latin typeface="Arial" panose="020B0604020202020204" pitchFamily="34" charset="0"/>
                <a:cs typeface="Arial" panose="020B0604020202020204" pitchFamily="34" charset="0"/>
              </a:rPr>
              <a:t>WT</a:t>
            </a:r>
          </a:p>
        </p:txBody>
      </p:sp>
      <p:sp>
        <p:nvSpPr>
          <p:cNvPr id="18" name="TextBox 17"/>
          <p:cNvSpPr txBox="1"/>
          <p:nvPr/>
        </p:nvSpPr>
        <p:spPr>
          <a:xfrm>
            <a:off x="2926923" y="2608428"/>
            <a:ext cx="443668" cy="215444"/>
          </a:xfrm>
          <a:prstGeom prst="rect">
            <a:avLst/>
          </a:prstGeom>
          <a:noFill/>
        </p:spPr>
        <p:txBody>
          <a:bodyPr wrap="square" rtlCol="0">
            <a:spAutoFit/>
          </a:bodyPr>
          <a:lstStyle/>
          <a:p>
            <a:r>
              <a:rPr lang="en-US" sz="800" dirty="0" err="1">
                <a:latin typeface="Arial" panose="020B0604020202020204" pitchFamily="34" charset="0"/>
                <a:cs typeface="Arial" panose="020B0604020202020204" pitchFamily="34" charset="0"/>
              </a:rPr>
              <a:t>Cre</a:t>
            </a:r>
            <a:r>
              <a:rPr lang="en-US" sz="800" i="1" baseline="30000" dirty="0" err="1">
                <a:latin typeface="Arial" panose="020B0604020202020204" pitchFamily="34" charset="0"/>
                <a:cs typeface="Arial" panose="020B0604020202020204" pitchFamily="34" charset="0"/>
              </a:rPr>
              <a:t>Alb</a:t>
            </a:r>
            <a:endParaRPr lang="en-US" sz="800" i="1" baseline="30000" dirty="0">
              <a:latin typeface="Arial" panose="020B0604020202020204" pitchFamily="34" charset="0"/>
              <a:cs typeface="Arial" panose="020B0604020202020204" pitchFamily="34" charset="0"/>
            </a:endParaRPr>
          </a:p>
        </p:txBody>
      </p:sp>
      <p:sp>
        <p:nvSpPr>
          <p:cNvPr id="19" name="TextBox 18"/>
          <p:cNvSpPr txBox="1"/>
          <p:nvPr/>
        </p:nvSpPr>
        <p:spPr>
          <a:xfrm rot="16200000">
            <a:off x="146889" y="2915273"/>
            <a:ext cx="5809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CD11b</a:t>
            </a:r>
          </a:p>
        </p:txBody>
      </p:sp>
      <p:sp>
        <p:nvSpPr>
          <p:cNvPr id="20" name="TextBox 19"/>
          <p:cNvSpPr txBox="1"/>
          <p:nvPr/>
        </p:nvSpPr>
        <p:spPr>
          <a:xfrm rot="16200000">
            <a:off x="177712" y="3568140"/>
            <a:ext cx="514138"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F4/80</a:t>
            </a:r>
          </a:p>
        </p:txBody>
      </p:sp>
      <p:sp>
        <p:nvSpPr>
          <p:cNvPr id="21" name="TextBox 20"/>
          <p:cNvSpPr txBox="1"/>
          <p:nvPr/>
        </p:nvSpPr>
        <p:spPr>
          <a:xfrm rot="16200000">
            <a:off x="204189" y="4165740"/>
            <a:ext cx="461113"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y6C</a:t>
            </a:r>
          </a:p>
        </p:txBody>
      </p:sp>
      <p:sp>
        <p:nvSpPr>
          <p:cNvPr id="22" name="TextBox 21"/>
          <p:cNvSpPr txBox="1"/>
          <p:nvPr/>
        </p:nvSpPr>
        <p:spPr>
          <a:xfrm rot="16200000">
            <a:off x="202882" y="4791491"/>
            <a:ext cx="454619"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Ly6G</a:t>
            </a:r>
          </a:p>
        </p:txBody>
      </p:sp>
      <p:sp>
        <p:nvSpPr>
          <p:cNvPr id="23" name="TextBox 22">
            <a:extLst>
              <a:ext uri="{FF2B5EF4-FFF2-40B4-BE49-F238E27FC236}">
                <a16:creationId xmlns:a16="http://schemas.microsoft.com/office/drawing/2014/main" id="{2340F642-FD68-41F7-87C0-269980BCFBA2}"/>
              </a:ext>
            </a:extLst>
          </p:cNvPr>
          <p:cNvSpPr txBox="1"/>
          <p:nvPr/>
        </p:nvSpPr>
        <p:spPr>
          <a:xfrm>
            <a:off x="138984" y="2534206"/>
            <a:ext cx="20679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t>
            </a:r>
          </a:p>
        </p:txBody>
      </p:sp>
      <p:pic>
        <p:nvPicPr>
          <p:cNvPr id="24" name="Picture 23"/>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2658558" y="2791303"/>
            <a:ext cx="1043819" cy="587483"/>
          </a:xfrm>
          <a:prstGeom prst="rect">
            <a:avLst/>
          </a:prstGeom>
          <a:ln w="3175">
            <a:solidFill>
              <a:schemeClr val="tx1"/>
            </a:solidFill>
          </a:ln>
        </p:spPr>
      </p:pic>
      <p:pic>
        <p:nvPicPr>
          <p:cNvPr id="25" name="Picture 24"/>
          <p:cNvPicPr>
            <a:picLocks noChangeAspect="1"/>
          </p:cNvPicPr>
          <p:nvPr/>
        </p:nvPicPr>
        <p:blipFill>
          <a:blip r:embed="rId14" cstate="print">
            <a:extLst>
              <a:ext uri="{BEBA8EAE-BF5A-486C-A8C5-ECC9F3942E4B}">
                <a14:imgProps xmlns:a14="http://schemas.microsoft.com/office/drawing/2010/main">
                  <a14:imgLayer r:embed="rId15">
                    <a14:imgEffect>
                      <a14:brightnessContrast bright="12000"/>
                    </a14:imgEffect>
                  </a14:imgLayer>
                </a14:imgProps>
              </a:ext>
              <a:ext uri="{28A0092B-C50C-407E-A947-70E740481C1C}">
                <a14:useLocalDpi xmlns:a14="http://schemas.microsoft.com/office/drawing/2010/main" val="0"/>
              </a:ext>
            </a:extLst>
          </a:blip>
          <a:stretch>
            <a:fillRect/>
          </a:stretch>
        </p:blipFill>
        <p:spPr>
          <a:xfrm>
            <a:off x="2658558" y="3419203"/>
            <a:ext cx="1043819" cy="587484"/>
          </a:xfrm>
          <a:prstGeom prst="rect">
            <a:avLst/>
          </a:prstGeom>
          <a:ln w="3175">
            <a:solidFill>
              <a:schemeClr val="tx1"/>
            </a:solidFill>
          </a:ln>
        </p:spPr>
      </p:pic>
      <p:pic>
        <p:nvPicPr>
          <p:cNvPr id="26" name="Picture 25"/>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2658558" y="4045004"/>
            <a:ext cx="1043819" cy="587484"/>
          </a:xfrm>
          <a:prstGeom prst="rect">
            <a:avLst/>
          </a:prstGeom>
          <a:ln w="3175">
            <a:solidFill>
              <a:schemeClr val="tx1"/>
            </a:solidFill>
          </a:ln>
        </p:spPr>
      </p:pic>
      <p:pic>
        <p:nvPicPr>
          <p:cNvPr id="27" name="Picture 26"/>
          <p:cNvPicPr>
            <a:picLocks noChangeAspect="1"/>
          </p:cNvPicPr>
          <p:nvPr/>
        </p:nvPicPr>
        <p:blipFill>
          <a:blip r:embed="rId17" cstate="print">
            <a:extLst>
              <a:ext uri="{BEBA8EAE-BF5A-486C-A8C5-ECC9F3942E4B}">
                <a14:imgProps xmlns:a14="http://schemas.microsoft.com/office/drawing/2010/main">
                  <a14:imgLayer r:embed="rId18">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2655811" y="4670805"/>
            <a:ext cx="1043819" cy="587484"/>
          </a:xfrm>
          <a:prstGeom prst="rect">
            <a:avLst/>
          </a:prstGeom>
          <a:ln w="3175">
            <a:solidFill>
              <a:schemeClr val="tx1"/>
            </a:solidFill>
          </a:ln>
        </p:spPr>
      </p:pic>
      <p:pic>
        <p:nvPicPr>
          <p:cNvPr id="29" name="Picture 28"/>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2658558" y="5913612"/>
            <a:ext cx="1043819" cy="589344"/>
          </a:xfrm>
          <a:prstGeom prst="rect">
            <a:avLst/>
          </a:prstGeom>
          <a:ln w="3175">
            <a:solidFill>
              <a:schemeClr val="tx1"/>
            </a:solidFill>
          </a:ln>
        </p:spPr>
      </p:pic>
      <p:pic>
        <p:nvPicPr>
          <p:cNvPr id="30" name="Picture 29"/>
          <p:cNvPicPr>
            <a:picLocks noChangeAspect="1"/>
          </p:cNvPicPr>
          <p:nvPr/>
        </p:nvPicPr>
        <p:blipFill rotWithShape="1">
          <a:blip r:embed="rId20" cstate="print">
            <a:extLst>
              <a:ext uri="{28A0092B-C50C-407E-A947-70E740481C1C}">
                <a14:useLocalDpi xmlns:a14="http://schemas.microsoft.com/office/drawing/2010/main" val="0"/>
              </a:ext>
            </a:extLst>
          </a:blip>
          <a:srcRect l="-2" t="-86" r="212"/>
          <a:stretch/>
        </p:blipFill>
        <p:spPr>
          <a:xfrm>
            <a:off x="1590811" y="5294571"/>
            <a:ext cx="1043819" cy="589145"/>
          </a:xfrm>
          <a:prstGeom prst="rect">
            <a:avLst/>
          </a:prstGeom>
          <a:ln w="3175">
            <a:solidFill>
              <a:schemeClr val="tx1"/>
            </a:solidFill>
          </a:ln>
        </p:spPr>
      </p:pic>
      <p:pic>
        <p:nvPicPr>
          <p:cNvPr id="31" name="Picture 30"/>
          <p:cNvPicPr>
            <a:picLocks noChangeAspect="1"/>
          </p:cNvPicPr>
          <p:nvPr/>
        </p:nvPicPr>
        <p:blipFill rotWithShape="1">
          <a:blip r:embed="rId21" cstate="print">
            <a:extLst>
              <a:ext uri="{28A0092B-C50C-407E-A947-70E740481C1C}">
                <a14:useLocalDpi xmlns:a14="http://schemas.microsoft.com/office/drawing/2010/main" val="0"/>
              </a:ext>
            </a:extLst>
          </a:blip>
          <a:srcRect l="80" t="67" r="-99" b="-1"/>
          <a:stretch/>
        </p:blipFill>
        <p:spPr>
          <a:xfrm>
            <a:off x="531393" y="5292207"/>
            <a:ext cx="1042048" cy="589583"/>
          </a:xfrm>
          <a:prstGeom prst="rect">
            <a:avLst/>
          </a:prstGeom>
          <a:ln w="3175">
            <a:solidFill>
              <a:schemeClr val="tx1"/>
            </a:solidFill>
          </a:ln>
        </p:spPr>
      </p:pic>
      <p:pic>
        <p:nvPicPr>
          <p:cNvPr id="32" name="Picture 31"/>
          <p:cNvPicPr>
            <a:picLocks noChangeAspect="1"/>
          </p:cNvPicPr>
          <p:nvPr/>
        </p:nvPicPr>
        <p:blipFill rotWithShape="1">
          <a:blip r:embed="rId22" cstate="print">
            <a:extLst>
              <a:ext uri="{28A0092B-C50C-407E-A947-70E740481C1C}">
                <a14:useLocalDpi xmlns:a14="http://schemas.microsoft.com/office/drawing/2010/main" val="0"/>
              </a:ext>
            </a:extLst>
          </a:blip>
          <a:srcRect l="370" r="370"/>
          <a:stretch/>
        </p:blipFill>
        <p:spPr>
          <a:xfrm>
            <a:off x="1590811" y="5913861"/>
            <a:ext cx="1043819" cy="589093"/>
          </a:xfrm>
          <a:prstGeom prst="rect">
            <a:avLst/>
          </a:prstGeom>
          <a:ln w="3175">
            <a:solidFill>
              <a:schemeClr val="tx1"/>
            </a:solidFill>
          </a:ln>
        </p:spPr>
      </p:pic>
      <p:pic>
        <p:nvPicPr>
          <p:cNvPr id="33" name="Picture 32"/>
          <p:cNvPicPr>
            <a:picLocks noChangeAspect="1"/>
          </p:cNvPicPr>
          <p:nvPr/>
        </p:nvPicPr>
        <p:blipFill rotWithShape="1">
          <a:blip r:embed="rId23" cstate="print">
            <a:extLst>
              <a:ext uri="{28A0092B-C50C-407E-A947-70E740481C1C}">
                <a14:useLocalDpi xmlns:a14="http://schemas.microsoft.com/office/drawing/2010/main" val="0"/>
              </a:ext>
            </a:extLst>
          </a:blip>
          <a:srcRect l="813" r="813"/>
          <a:stretch/>
        </p:blipFill>
        <p:spPr>
          <a:xfrm>
            <a:off x="527550" y="5915710"/>
            <a:ext cx="1043819" cy="589093"/>
          </a:xfrm>
          <a:prstGeom prst="rect">
            <a:avLst/>
          </a:prstGeom>
          <a:ln w="3175">
            <a:solidFill>
              <a:schemeClr val="tx1"/>
            </a:solidFill>
          </a:ln>
        </p:spPr>
      </p:pic>
      <p:sp>
        <p:nvSpPr>
          <p:cNvPr id="34" name="TextBox 33"/>
          <p:cNvSpPr txBox="1"/>
          <p:nvPr/>
        </p:nvSpPr>
        <p:spPr>
          <a:xfrm rot="16200000">
            <a:off x="183818" y="5437654"/>
            <a:ext cx="497352" cy="215444"/>
          </a:xfrm>
          <a:prstGeom prst="rect">
            <a:avLst/>
          </a:prstGeom>
          <a:noFill/>
        </p:spPr>
        <p:txBody>
          <a:bodyPr wrap="square" rtlCol="0">
            <a:spAutoFit/>
          </a:bodyPr>
          <a:lstStyle/>
          <a:p>
            <a:r>
              <a:rPr lang="el-GR" sz="800" dirty="0">
                <a:latin typeface="Arial" panose="020B0604020202020204" pitchFamily="34" charset="0"/>
                <a:cs typeface="Arial" panose="020B0604020202020204" pitchFamily="34" charset="0"/>
              </a:rPr>
              <a:t>α</a:t>
            </a:r>
            <a:r>
              <a:rPr lang="en-US" sz="800" dirty="0">
                <a:latin typeface="Arial" panose="020B0604020202020204" pitchFamily="34" charset="0"/>
                <a:cs typeface="Arial" panose="020B0604020202020204" pitchFamily="34" charset="0"/>
              </a:rPr>
              <a:t>-SMA</a:t>
            </a:r>
          </a:p>
        </p:txBody>
      </p:sp>
      <p:sp>
        <p:nvSpPr>
          <p:cNvPr id="35" name="TextBox 34"/>
          <p:cNvSpPr txBox="1"/>
          <p:nvPr/>
        </p:nvSpPr>
        <p:spPr>
          <a:xfrm rot="16200000">
            <a:off x="79632" y="6095327"/>
            <a:ext cx="689216" cy="215444"/>
          </a:xfrm>
          <a:prstGeom prst="rect">
            <a:avLst/>
          </a:prstGeom>
          <a:noFill/>
        </p:spPr>
        <p:txBody>
          <a:bodyPr wrap="square" rtlCol="0">
            <a:spAutoFit/>
          </a:bodyPr>
          <a:lstStyle/>
          <a:p>
            <a:r>
              <a:rPr lang="en-US" sz="800" dirty="0">
                <a:latin typeface="Arial" panose="020B0604020202020204" pitchFamily="34" charset="0"/>
                <a:cs typeface="Arial" panose="020B0604020202020204" pitchFamily="34" charset="0"/>
              </a:rPr>
              <a:t>Sirius Red</a:t>
            </a:r>
          </a:p>
        </p:txBody>
      </p:sp>
      <p:pic>
        <p:nvPicPr>
          <p:cNvPr id="36" name="Picture 35"/>
          <p:cNvPicPr>
            <a:picLocks noChangeAspect="1"/>
          </p:cNvPicPr>
          <p:nvPr/>
        </p:nvPicPr>
        <p:blipFill>
          <a:blip r:embed="rId24" cstate="print">
            <a:extLst>
              <a:ext uri="{BEBA8EAE-BF5A-486C-A8C5-ECC9F3942E4B}">
                <a14:imgProps xmlns:a14="http://schemas.microsoft.com/office/drawing/2010/main">
                  <a14:imgLayer r:embed="rId25">
                    <a14:imgEffect>
                      <a14:brightnessContrast bright="3000" contrast="13000"/>
                    </a14:imgEffect>
                  </a14:imgLayer>
                </a14:imgProps>
              </a:ext>
              <a:ext uri="{28A0092B-C50C-407E-A947-70E740481C1C}">
                <a14:useLocalDpi xmlns:a14="http://schemas.microsoft.com/office/drawing/2010/main" val="0"/>
              </a:ext>
            </a:extLst>
          </a:blip>
          <a:stretch>
            <a:fillRect/>
          </a:stretch>
        </p:blipFill>
        <p:spPr>
          <a:xfrm>
            <a:off x="2655689" y="5292207"/>
            <a:ext cx="1046688" cy="589583"/>
          </a:xfrm>
          <a:prstGeom prst="rect">
            <a:avLst/>
          </a:prstGeom>
          <a:ln w="3175">
            <a:solidFill>
              <a:schemeClr val="tx1"/>
            </a:solidFill>
          </a:ln>
        </p:spPr>
      </p:pic>
      <p:pic>
        <p:nvPicPr>
          <p:cNvPr id="28" name="Picture 27"/>
          <p:cNvPicPr>
            <a:picLocks noChangeAspect="1"/>
          </p:cNvPicPr>
          <p:nvPr/>
        </p:nvPicPr>
        <p:blipFill>
          <a:blip r:embed="rId26" cstate="hqprint">
            <a:extLst>
              <a:ext uri="{28A0092B-C50C-407E-A947-70E740481C1C}">
                <a14:useLocalDpi xmlns:a14="http://schemas.microsoft.com/office/drawing/2010/main" val="0"/>
              </a:ext>
            </a:extLst>
          </a:blip>
          <a:stretch>
            <a:fillRect/>
          </a:stretch>
        </p:blipFill>
        <p:spPr>
          <a:xfrm>
            <a:off x="3832940" y="5384609"/>
            <a:ext cx="1326889" cy="1180030"/>
          </a:xfrm>
          <a:prstGeom prst="rect">
            <a:avLst/>
          </a:prstGeom>
        </p:spPr>
      </p:pic>
      <p:pic>
        <p:nvPicPr>
          <p:cNvPr id="37" name="Picture 36"/>
          <p:cNvPicPr>
            <a:picLocks noChangeAspect="1"/>
          </p:cNvPicPr>
          <p:nvPr/>
        </p:nvPicPr>
        <p:blipFill>
          <a:blip r:embed="rId27" cstate="hqprint">
            <a:extLst>
              <a:ext uri="{28A0092B-C50C-407E-A947-70E740481C1C}">
                <a14:useLocalDpi xmlns:a14="http://schemas.microsoft.com/office/drawing/2010/main" val="0"/>
              </a:ext>
            </a:extLst>
          </a:blip>
          <a:stretch>
            <a:fillRect/>
          </a:stretch>
        </p:blipFill>
        <p:spPr>
          <a:xfrm>
            <a:off x="5283278" y="2821878"/>
            <a:ext cx="1326889" cy="1129087"/>
          </a:xfrm>
          <a:prstGeom prst="rect">
            <a:avLst/>
          </a:prstGeom>
        </p:spPr>
      </p:pic>
      <p:pic>
        <p:nvPicPr>
          <p:cNvPr id="38" name="Picture 37"/>
          <p:cNvPicPr>
            <a:picLocks noChangeAspect="1"/>
          </p:cNvPicPr>
          <p:nvPr/>
        </p:nvPicPr>
        <p:blipFill>
          <a:blip r:embed="rId28" cstate="hqprint">
            <a:extLst>
              <a:ext uri="{28A0092B-C50C-407E-A947-70E740481C1C}">
                <a14:useLocalDpi xmlns:a14="http://schemas.microsoft.com/office/drawing/2010/main" val="0"/>
              </a:ext>
            </a:extLst>
          </a:blip>
          <a:stretch>
            <a:fillRect/>
          </a:stretch>
        </p:blipFill>
        <p:spPr>
          <a:xfrm>
            <a:off x="3832941" y="4123131"/>
            <a:ext cx="1326889" cy="1148783"/>
          </a:xfrm>
          <a:prstGeom prst="rect">
            <a:avLst/>
          </a:prstGeom>
        </p:spPr>
      </p:pic>
      <p:pic>
        <p:nvPicPr>
          <p:cNvPr id="39" name="Picture 38"/>
          <p:cNvPicPr>
            <a:picLocks noChangeAspect="1"/>
          </p:cNvPicPr>
          <p:nvPr/>
        </p:nvPicPr>
        <p:blipFill>
          <a:blip r:embed="rId29" cstate="hqprint">
            <a:extLst>
              <a:ext uri="{28A0092B-C50C-407E-A947-70E740481C1C}">
                <a14:useLocalDpi xmlns:a14="http://schemas.microsoft.com/office/drawing/2010/main" val="0"/>
              </a:ext>
            </a:extLst>
          </a:blip>
          <a:stretch>
            <a:fillRect/>
          </a:stretch>
        </p:blipFill>
        <p:spPr>
          <a:xfrm>
            <a:off x="5290394" y="4068128"/>
            <a:ext cx="1326889" cy="1180030"/>
          </a:xfrm>
          <a:prstGeom prst="rect">
            <a:avLst/>
          </a:prstGeom>
        </p:spPr>
      </p:pic>
      <p:pic>
        <p:nvPicPr>
          <p:cNvPr id="40" name="Picture 39"/>
          <p:cNvPicPr>
            <a:picLocks noChangeAspect="1"/>
          </p:cNvPicPr>
          <p:nvPr/>
        </p:nvPicPr>
        <p:blipFill>
          <a:blip r:embed="rId30" cstate="hqprint">
            <a:extLst>
              <a:ext uri="{28A0092B-C50C-407E-A947-70E740481C1C}">
                <a14:useLocalDpi xmlns:a14="http://schemas.microsoft.com/office/drawing/2010/main" val="0"/>
              </a:ext>
            </a:extLst>
          </a:blip>
          <a:stretch>
            <a:fillRect/>
          </a:stretch>
        </p:blipFill>
        <p:spPr>
          <a:xfrm>
            <a:off x="5308072" y="5402773"/>
            <a:ext cx="1326889" cy="1148783"/>
          </a:xfrm>
          <a:prstGeom prst="rect">
            <a:avLst/>
          </a:prstGeom>
        </p:spPr>
      </p:pic>
      <p:pic>
        <p:nvPicPr>
          <p:cNvPr id="41" name="Picture 40"/>
          <p:cNvPicPr>
            <a:picLocks noChangeAspect="1"/>
          </p:cNvPicPr>
          <p:nvPr/>
        </p:nvPicPr>
        <p:blipFill>
          <a:blip r:embed="rId31" cstate="hqprint">
            <a:extLst>
              <a:ext uri="{28A0092B-C50C-407E-A947-70E740481C1C}">
                <a14:useLocalDpi xmlns:a14="http://schemas.microsoft.com/office/drawing/2010/main" val="0"/>
              </a:ext>
            </a:extLst>
          </a:blip>
          <a:stretch>
            <a:fillRect/>
          </a:stretch>
        </p:blipFill>
        <p:spPr>
          <a:xfrm>
            <a:off x="3829383" y="2823872"/>
            <a:ext cx="1326889" cy="1134078"/>
          </a:xfrm>
          <a:prstGeom prst="rect">
            <a:avLst/>
          </a:prstGeom>
        </p:spPr>
      </p:pic>
      <p:sp>
        <p:nvSpPr>
          <p:cNvPr id="42" name="TextBox 41">
            <a:extLst>
              <a:ext uri="{FF2B5EF4-FFF2-40B4-BE49-F238E27FC236}">
                <a16:creationId xmlns:a16="http://schemas.microsoft.com/office/drawing/2014/main" id="{294B2B21-CEF3-431F-A01C-1A22CF15B04F}"/>
              </a:ext>
            </a:extLst>
          </p:cNvPr>
          <p:cNvSpPr txBox="1"/>
          <p:nvPr/>
        </p:nvSpPr>
        <p:spPr>
          <a:xfrm>
            <a:off x="0" y="7048996"/>
            <a:ext cx="6858000"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 Fig. 2: CDAA-HFAT diet-induced NASH in </a:t>
            </a:r>
            <a:r>
              <a:rPr lang="en-US" sz="1200" b="1" dirty="0" err="1">
                <a:latin typeface="Arial" panose="020B0604020202020204" pitchFamily="34" charset="0"/>
                <a:cs typeface="Arial" panose="020B0604020202020204" pitchFamily="34" charset="0"/>
              </a:rPr>
              <a:t>Cre</a:t>
            </a:r>
            <a:r>
              <a:rPr lang="en-US" sz="1200" b="1" baseline="30000" dirty="0" err="1">
                <a:latin typeface="Arial" panose="020B0604020202020204" pitchFamily="34" charset="0"/>
                <a:cs typeface="Arial" panose="020B0604020202020204" pitchFamily="34" charset="0"/>
              </a:rPr>
              <a:t>Alb</a:t>
            </a:r>
            <a:r>
              <a:rPr lang="en-US" sz="1200" b="1" baseline="30000" dirty="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mice.</a:t>
            </a:r>
            <a:r>
              <a:rPr lang="en-US" sz="1200" dirty="0">
                <a:latin typeface="Arial" panose="020B0604020202020204" pitchFamily="34" charset="0"/>
                <a:cs typeface="Arial" panose="020B0604020202020204" pitchFamily="34" charset="0"/>
              </a:rPr>
              <a:t> Hepatic gene expression of </a:t>
            </a:r>
            <a:r>
              <a:rPr lang="en-US" sz="1200" i="1" dirty="0">
                <a:latin typeface="Arial" panose="020B0604020202020204" pitchFamily="34" charset="0"/>
                <a:cs typeface="Arial" panose="020B0604020202020204" pitchFamily="34" charset="0"/>
              </a:rPr>
              <a:t>Chil1</a:t>
            </a:r>
            <a:r>
              <a:rPr lang="en-US" sz="1200" dirty="0">
                <a:latin typeface="Arial" panose="020B0604020202020204" pitchFamily="34" charset="0"/>
                <a:cs typeface="Arial" panose="020B0604020202020204" pitchFamily="34" charset="0"/>
              </a:rPr>
              <a:t> and systemic release of CHI3L1 were measured in hepatocyte-specific CHI3L1 KO (</a:t>
            </a:r>
            <a:r>
              <a:rPr lang="en-US" sz="1200" dirty="0" err="1">
                <a:latin typeface="Arial" panose="020B0604020202020204" pitchFamily="34" charset="0"/>
                <a:cs typeface="Arial" panose="020B0604020202020204" pitchFamily="34" charset="0"/>
              </a:rPr>
              <a:t>Cre</a:t>
            </a:r>
            <a:r>
              <a:rPr lang="en-US" sz="1200" baseline="30000" dirty="0" err="1">
                <a:latin typeface="Arial" panose="020B0604020202020204" pitchFamily="34" charset="0"/>
                <a:cs typeface="Arial" panose="020B0604020202020204" pitchFamily="34" charset="0"/>
              </a:rPr>
              <a:t>Alb</a:t>
            </a:r>
            <a:r>
              <a:rPr lang="en-US" sz="1200" dirty="0">
                <a:latin typeface="Arial" panose="020B0604020202020204" pitchFamily="34" charset="0"/>
                <a:cs typeface="Arial" panose="020B0604020202020204" pitchFamily="34" charset="0"/>
              </a:rPr>
              <a:t>) mice via RT-qPCR (A) and serum ELISA (B). (C) Inflammatory cell recruitment and accumulation, hepatic stellate cell (HSC) activation and fibrosis deposition were compared to WT control and NASH mice. Immune cell infiltration was detected by CD11b immunohistochemistry (IHC) in paraffin-embedded liver sections. Pan-macrophage population and pro-inflammatory infiltrating macrophages were detected via F4/80 and Ly6C IHC measurements, respectively. Neutrophil infiltration was assessed by Ly6G IHC. IHC was performed for HSC activation marker </a:t>
            </a:r>
            <a:r>
              <a:rPr lang="el-GR" sz="12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SMA  and Sirius Red staining was performed to detect collagen deposition. Scale bar: 250 </a:t>
            </a:r>
            <a:r>
              <a:rPr lang="el-GR" sz="1200" dirty="0">
                <a:latin typeface="Arial" panose="020B0604020202020204" pitchFamily="34" charset="0"/>
                <a:cs typeface="Arial" panose="020B0604020202020204" pitchFamily="34" charset="0"/>
              </a:rPr>
              <a:t>μ</a:t>
            </a:r>
            <a:r>
              <a:rPr lang="en-US" sz="1200" dirty="0">
                <a:latin typeface="Arial" panose="020B0604020202020204" pitchFamily="34" charset="0"/>
                <a:cs typeface="Arial" panose="020B0604020202020204" pitchFamily="34" charset="0"/>
              </a:rPr>
              <a:t>m.</a:t>
            </a:r>
          </a:p>
        </p:txBody>
      </p:sp>
      <p:sp>
        <p:nvSpPr>
          <p:cNvPr id="45" name="TextBox 44">
            <a:extLst>
              <a:ext uri="{FF2B5EF4-FFF2-40B4-BE49-F238E27FC236}">
                <a16:creationId xmlns:a16="http://schemas.microsoft.com/office/drawing/2014/main" id="{2340F642-FD68-41F7-87C0-269980BCFBA2}"/>
              </a:ext>
            </a:extLst>
          </p:cNvPr>
          <p:cNvSpPr txBox="1"/>
          <p:nvPr/>
        </p:nvSpPr>
        <p:spPr>
          <a:xfrm>
            <a:off x="2926923" y="219694"/>
            <a:ext cx="20679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46" name="TextBox 45"/>
          <p:cNvSpPr txBox="1"/>
          <p:nvPr/>
        </p:nvSpPr>
        <p:spPr>
          <a:xfrm rot="16200000">
            <a:off x="2576533" y="1136693"/>
            <a:ext cx="998003"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CHI3L1 (</a:t>
            </a:r>
            <a:r>
              <a:rPr lang="en-US" sz="800" dirty="0" err="1">
                <a:latin typeface="Arial" panose="020B0604020202020204" pitchFamily="34" charset="0"/>
                <a:cs typeface="Arial" panose="020B0604020202020204" pitchFamily="34" charset="0"/>
              </a:rPr>
              <a:t>pg</a:t>
            </a:r>
            <a:r>
              <a:rPr lang="en-US" sz="800" dirty="0">
                <a:latin typeface="Arial" panose="020B0604020202020204" pitchFamily="34" charset="0"/>
                <a:cs typeface="Arial" panose="020B0604020202020204" pitchFamily="34" charset="0"/>
              </a:rPr>
              <a:t>/mL)</a:t>
            </a:r>
          </a:p>
        </p:txBody>
      </p:sp>
      <p:sp>
        <p:nvSpPr>
          <p:cNvPr id="47" name="TextBox 46"/>
          <p:cNvSpPr txBox="1"/>
          <p:nvPr/>
        </p:nvSpPr>
        <p:spPr>
          <a:xfrm rot="16200000">
            <a:off x="31978" y="1188171"/>
            <a:ext cx="998003" cy="215444"/>
          </a:xfrm>
          <a:prstGeom prst="rect">
            <a:avLst/>
          </a:prstGeom>
          <a:solidFill>
            <a:schemeClr val="bg1"/>
          </a:solidFill>
        </p:spPr>
        <p:txBody>
          <a:bodyPr wrap="square" rtlCol="0">
            <a:spAutoFit/>
          </a:bodyPr>
          <a:lstStyle/>
          <a:p>
            <a:pPr algn="r"/>
            <a:r>
              <a:rPr lang="en-US" sz="800" i="1" dirty="0">
                <a:latin typeface="Arial" panose="020B0604020202020204" pitchFamily="34" charset="0"/>
                <a:cs typeface="Arial" panose="020B0604020202020204" pitchFamily="34" charset="0"/>
              </a:rPr>
              <a:t>Chil1</a:t>
            </a:r>
            <a:r>
              <a:rPr lang="en-US" sz="800" dirty="0">
                <a:latin typeface="Arial" panose="020B0604020202020204" pitchFamily="34" charset="0"/>
                <a:cs typeface="Arial" panose="020B0604020202020204" pitchFamily="34" charset="0"/>
              </a:rPr>
              <a:t> (2^</a:t>
            </a:r>
            <a:r>
              <a:rPr lang="en-US" sz="800" baseline="30000" dirty="0">
                <a:latin typeface="Arial" panose="020B0604020202020204" pitchFamily="34" charset="0"/>
                <a:cs typeface="Arial" panose="020B0604020202020204" pitchFamily="34" charset="0"/>
              </a:rPr>
              <a:t>-∆CT</a:t>
            </a:r>
            <a:r>
              <a:rPr lang="en-US" sz="800" dirty="0">
                <a:latin typeface="Arial" panose="020B0604020202020204" pitchFamily="34" charset="0"/>
                <a:cs typeface="Arial" panose="020B0604020202020204" pitchFamily="34" charset="0"/>
              </a:rPr>
              <a:t>)</a:t>
            </a:r>
          </a:p>
        </p:txBody>
      </p:sp>
      <p:sp>
        <p:nvSpPr>
          <p:cNvPr id="48" name="TextBox 47"/>
          <p:cNvSpPr txBox="1"/>
          <p:nvPr/>
        </p:nvSpPr>
        <p:spPr>
          <a:xfrm rot="16200000">
            <a:off x="3298687" y="3311070"/>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CD11b IHC</a:t>
            </a:r>
          </a:p>
        </p:txBody>
      </p:sp>
      <p:sp>
        <p:nvSpPr>
          <p:cNvPr id="49" name="TextBox 48"/>
          <p:cNvSpPr txBox="1"/>
          <p:nvPr/>
        </p:nvSpPr>
        <p:spPr>
          <a:xfrm rot="16200000">
            <a:off x="4771866" y="3291521"/>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F4/80 IHC</a:t>
            </a:r>
          </a:p>
        </p:txBody>
      </p:sp>
      <p:sp>
        <p:nvSpPr>
          <p:cNvPr id="50" name="TextBox 49"/>
          <p:cNvSpPr txBox="1"/>
          <p:nvPr/>
        </p:nvSpPr>
        <p:spPr>
          <a:xfrm rot="16200000">
            <a:off x="3295242" y="4657741"/>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Ly6C IHC</a:t>
            </a:r>
          </a:p>
        </p:txBody>
      </p:sp>
      <p:sp>
        <p:nvSpPr>
          <p:cNvPr id="51" name="TextBox 50"/>
          <p:cNvSpPr txBox="1"/>
          <p:nvPr/>
        </p:nvSpPr>
        <p:spPr>
          <a:xfrm rot="16200000">
            <a:off x="4771866" y="4617210"/>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Ly6G IHC</a:t>
            </a:r>
          </a:p>
        </p:txBody>
      </p:sp>
      <p:sp>
        <p:nvSpPr>
          <p:cNvPr id="52" name="TextBox 51"/>
          <p:cNvSpPr txBox="1"/>
          <p:nvPr/>
        </p:nvSpPr>
        <p:spPr>
          <a:xfrm rot="16200000">
            <a:off x="3295242" y="5888397"/>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a:t>
            </a:r>
            <a:r>
              <a:rPr lang="el-GR" sz="800" dirty="0">
                <a:latin typeface="Arial" panose="020B0604020202020204" pitchFamily="34" charset="0"/>
                <a:cs typeface="Arial" panose="020B0604020202020204" pitchFamily="34" charset="0"/>
              </a:rPr>
              <a:t>α</a:t>
            </a:r>
            <a:r>
              <a:rPr lang="en-US" sz="800" dirty="0">
                <a:latin typeface="Arial" panose="020B0604020202020204" pitchFamily="34" charset="0"/>
                <a:cs typeface="Arial" panose="020B0604020202020204" pitchFamily="34" charset="0"/>
              </a:rPr>
              <a:t>-SMA IHC</a:t>
            </a:r>
          </a:p>
        </p:txBody>
      </p:sp>
      <p:sp>
        <p:nvSpPr>
          <p:cNvPr id="53" name="TextBox 52"/>
          <p:cNvSpPr txBox="1"/>
          <p:nvPr/>
        </p:nvSpPr>
        <p:spPr>
          <a:xfrm rot="16200000">
            <a:off x="4771867" y="5841838"/>
            <a:ext cx="1116265" cy="215444"/>
          </a:xfrm>
          <a:prstGeom prst="rect">
            <a:avLst/>
          </a:prstGeom>
          <a:solidFill>
            <a:schemeClr val="bg1"/>
          </a:solidFill>
        </p:spPr>
        <p:txBody>
          <a:bodyPr wrap="square" rtlCol="0">
            <a:spAutoFit/>
          </a:bodyPr>
          <a:lstStyle/>
          <a:p>
            <a:pPr algn="r"/>
            <a:r>
              <a:rPr lang="en-US" sz="800" dirty="0">
                <a:latin typeface="Arial" panose="020B0604020202020204" pitchFamily="34" charset="0"/>
                <a:cs typeface="Arial" panose="020B0604020202020204" pitchFamily="34" charset="0"/>
              </a:rPr>
              <a:t>% area Sirius Red</a:t>
            </a:r>
          </a:p>
        </p:txBody>
      </p:sp>
      <p:grpSp>
        <p:nvGrpSpPr>
          <p:cNvPr id="2" name="Group 1">
            <a:extLst>
              <a:ext uri="{FF2B5EF4-FFF2-40B4-BE49-F238E27FC236}">
                <a16:creationId xmlns:a16="http://schemas.microsoft.com/office/drawing/2014/main" id="{0F68F359-B9E5-40AA-96B0-90E9E9A2BCF9}"/>
              </a:ext>
            </a:extLst>
          </p:cNvPr>
          <p:cNvGrpSpPr/>
          <p:nvPr/>
        </p:nvGrpSpPr>
        <p:grpSpPr>
          <a:xfrm>
            <a:off x="423257" y="443232"/>
            <a:ext cx="1968069" cy="1734007"/>
            <a:chOff x="423257" y="443232"/>
            <a:chExt cx="1968069" cy="1734007"/>
          </a:xfrm>
        </p:grpSpPr>
        <p:pic>
          <p:nvPicPr>
            <p:cNvPr id="43" name="Picture 42"/>
            <p:cNvPicPr>
              <a:picLocks/>
            </p:cNvPicPr>
            <p:nvPr/>
          </p:nvPicPr>
          <p:blipFill rotWithShape="1">
            <a:blip r:embed="rId32" cstate="print">
              <a:extLst>
                <a:ext uri="{28A0092B-C50C-407E-A947-70E740481C1C}">
                  <a14:useLocalDpi xmlns:a14="http://schemas.microsoft.com/office/drawing/2010/main" val="0"/>
                </a:ext>
              </a:extLst>
            </a:blip>
            <a:srcRect t="11086" r="29545"/>
            <a:stretch/>
          </p:blipFill>
          <p:spPr>
            <a:xfrm>
              <a:off x="423257" y="443232"/>
              <a:ext cx="1909652" cy="1654813"/>
            </a:xfrm>
            <a:prstGeom prst="rect">
              <a:avLst/>
            </a:prstGeom>
          </p:spPr>
        </p:pic>
        <p:sp>
          <p:nvSpPr>
            <p:cNvPr id="55" name="TextBox 54">
              <a:extLst>
                <a:ext uri="{FF2B5EF4-FFF2-40B4-BE49-F238E27FC236}">
                  <a16:creationId xmlns:a16="http://schemas.microsoft.com/office/drawing/2014/main" id="{821B6DB4-6ED2-445C-B17D-9E9925F5E088}"/>
                </a:ext>
              </a:extLst>
            </p:cNvPr>
            <p:cNvSpPr txBox="1"/>
            <p:nvPr/>
          </p:nvSpPr>
          <p:spPr>
            <a:xfrm>
              <a:off x="1396149" y="1961795"/>
              <a:ext cx="557212" cy="215444"/>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56" name="TextBox 55">
              <a:extLst>
                <a:ext uri="{FF2B5EF4-FFF2-40B4-BE49-F238E27FC236}">
                  <a16:creationId xmlns:a16="http://schemas.microsoft.com/office/drawing/2014/main" id="{A4E80205-98F0-436D-BF66-D369C869091A}"/>
                </a:ext>
              </a:extLst>
            </p:cNvPr>
            <p:cNvSpPr txBox="1"/>
            <p:nvPr/>
          </p:nvSpPr>
          <p:spPr>
            <a:xfrm>
              <a:off x="915137" y="1956513"/>
              <a:ext cx="557212"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57" name="TextBox 56">
              <a:extLst>
                <a:ext uri="{FF2B5EF4-FFF2-40B4-BE49-F238E27FC236}">
                  <a16:creationId xmlns:a16="http://schemas.microsoft.com/office/drawing/2014/main" id="{72DFC689-6FEC-49B6-B650-45D7D31E2465}"/>
                </a:ext>
              </a:extLst>
            </p:cNvPr>
            <p:cNvSpPr txBox="1"/>
            <p:nvPr/>
          </p:nvSpPr>
          <p:spPr>
            <a:xfrm>
              <a:off x="1834114" y="1961795"/>
              <a:ext cx="557212"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grpSp>
      <p:grpSp>
        <p:nvGrpSpPr>
          <p:cNvPr id="3" name="Group 2">
            <a:extLst>
              <a:ext uri="{FF2B5EF4-FFF2-40B4-BE49-F238E27FC236}">
                <a16:creationId xmlns:a16="http://schemas.microsoft.com/office/drawing/2014/main" id="{AB7970F0-20CF-417A-8A08-CE93A5850223}"/>
              </a:ext>
            </a:extLst>
          </p:cNvPr>
          <p:cNvGrpSpPr/>
          <p:nvPr/>
        </p:nvGrpSpPr>
        <p:grpSpPr>
          <a:xfrm>
            <a:off x="3006271" y="468488"/>
            <a:ext cx="1986832" cy="1732625"/>
            <a:chOff x="3006271" y="468488"/>
            <a:chExt cx="1986832" cy="1732625"/>
          </a:xfrm>
        </p:grpSpPr>
        <p:pic>
          <p:nvPicPr>
            <p:cNvPr id="44" name="Picture 43"/>
            <p:cNvPicPr>
              <a:picLocks/>
            </p:cNvPicPr>
            <p:nvPr/>
          </p:nvPicPr>
          <p:blipFill rotWithShape="1">
            <a:blip r:embed="rId33" cstate="print">
              <a:extLst>
                <a:ext uri="{28A0092B-C50C-407E-A947-70E740481C1C}">
                  <a14:useLocalDpi xmlns:a14="http://schemas.microsoft.com/office/drawing/2010/main" val="0"/>
                </a:ext>
              </a:extLst>
            </a:blip>
            <a:srcRect t="11680" r="25818"/>
            <a:stretch/>
          </p:blipFill>
          <p:spPr>
            <a:xfrm>
              <a:off x="3006271" y="468488"/>
              <a:ext cx="1909652" cy="1654813"/>
            </a:xfrm>
            <a:prstGeom prst="rect">
              <a:avLst/>
            </a:prstGeom>
          </p:spPr>
        </p:pic>
        <p:sp>
          <p:nvSpPr>
            <p:cNvPr id="58" name="TextBox 57">
              <a:extLst>
                <a:ext uri="{FF2B5EF4-FFF2-40B4-BE49-F238E27FC236}">
                  <a16:creationId xmlns:a16="http://schemas.microsoft.com/office/drawing/2014/main" id="{51E14EF7-F513-4C37-880C-A4419C091B60}"/>
                </a:ext>
              </a:extLst>
            </p:cNvPr>
            <p:cNvSpPr txBox="1"/>
            <p:nvPr/>
          </p:nvSpPr>
          <p:spPr>
            <a:xfrm>
              <a:off x="4054891" y="1985669"/>
              <a:ext cx="557212" cy="215444"/>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59" name="TextBox 58">
              <a:extLst>
                <a:ext uri="{FF2B5EF4-FFF2-40B4-BE49-F238E27FC236}">
                  <a16:creationId xmlns:a16="http://schemas.microsoft.com/office/drawing/2014/main" id="{599375AA-CD6C-4A8D-82D8-EA4235A56C33}"/>
                </a:ext>
              </a:extLst>
            </p:cNvPr>
            <p:cNvSpPr txBox="1"/>
            <p:nvPr/>
          </p:nvSpPr>
          <p:spPr>
            <a:xfrm>
              <a:off x="3616926" y="1985669"/>
              <a:ext cx="557212"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60" name="TextBox 59">
              <a:extLst>
                <a:ext uri="{FF2B5EF4-FFF2-40B4-BE49-F238E27FC236}">
                  <a16:creationId xmlns:a16="http://schemas.microsoft.com/office/drawing/2014/main" id="{F6EA853A-05FA-492D-AE0E-D2184619B74B}"/>
                </a:ext>
              </a:extLst>
            </p:cNvPr>
            <p:cNvSpPr txBox="1"/>
            <p:nvPr/>
          </p:nvSpPr>
          <p:spPr>
            <a:xfrm>
              <a:off x="4435891" y="1980662"/>
              <a:ext cx="557212"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grpSp>
      <p:sp>
        <p:nvSpPr>
          <p:cNvPr id="61" name="TextBox 60">
            <a:extLst>
              <a:ext uri="{FF2B5EF4-FFF2-40B4-BE49-F238E27FC236}">
                <a16:creationId xmlns:a16="http://schemas.microsoft.com/office/drawing/2014/main" id="{6A13B087-D0C5-43F1-85D6-10D24F096174}"/>
              </a:ext>
            </a:extLst>
          </p:cNvPr>
          <p:cNvSpPr txBox="1"/>
          <p:nvPr/>
        </p:nvSpPr>
        <p:spPr>
          <a:xfrm rot="16200000">
            <a:off x="69540" y="1176242"/>
            <a:ext cx="981298" cy="215444"/>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Chi3L1(2</a:t>
            </a:r>
            <a:r>
              <a:rPr lang="en-US" sz="800" baseline="30000" dirty="0">
                <a:latin typeface="Arial" panose="020B0604020202020204" pitchFamily="34" charset="0"/>
                <a:cs typeface="Arial" panose="020B0604020202020204" pitchFamily="34" charset="0"/>
              </a:rPr>
              <a:t>-</a:t>
            </a:r>
            <a:r>
              <a:rPr lang="el-GR" sz="800" baseline="30000" dirty="0">
                <a:latin typeface="Arial" panose="020B0604020202020204" pitchFamily="34" charset="0"/>
                <a:cs typeface="Arial" panose="020B0604020202020204" pitchFamily="34" charset="0"/>
              </a:rPr>
              <a:t>ΔΔ</a:t>
            </a:r>
            <a:r>
              <a:rPr lang="en-US" sz="800" baseline="30000" dirty="0">
                <a:latin typeface="Arial" panose="020B0604020202020204" pitchFamily="34" charset="0"/>
                <a:cs typeface="Arial" panose="020B0604020202020204" pitchFamily="34" charset="0"/>
              </a:rPr>
              <a:t>CT</a:t>
            </a:r>
            <a:r>
              <a:rPr lang="en-US" sz="800" dirty="0">
                <a:latin typeface="Arial" panose="020B0604020202020204" pitchFamily="34" charset="0"/>
                <a:cs typeface="Arial" panose="020B0604020202020204" pitchFamily="34" charset="0"/>
              </a:rPr>
              <a:t>)</a:t>
            </a:r>
          </a:p>
        </p:txBody>
      </p:sp>
      <p:sp>
        <p:nvSpPr>
          <p:cNvPr id="62" name="TextBox 61">
            <a:extLst>
              <a:ext uri="{FF2B5EF4-FFF2-40B4-BE49-F238E27FC236}">
                <a16:creationId xmlns:a16="http://schemas.microsoft.com/office/drawing/2014/main" id="{2A16D125-83D6-4C6C-9AFC-A5E7D2EC607A}"/>
              </a:ext>
            </a:extLst>
          </p:cNvPr>
          <p:cNvSpPr txBox="1"/>
          <p:nvPr/>
        </p:nvSpPr>
        <p:spPr>
          <a:xfrm rot="16200000">
            <a:off x="2584885" y="1123836"/>
            <a:ext cx="981298" cy="215444"/>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Chi3L1(</a:t>
            </a:r>
            <a:r>
              <a:rPr lang="en-US" sz="800" dirty="0" err="1">
                <a:latin typeface="Arial" panose="020B0604020202020204" pitchFamily="34" charset="0"/>
                <a:cs typeface="Arial" panose="020B0604020202020204" pitchFamily="34" charset="0"/>
              </a:rPr>
              <a:t>pg</a:t>
            </a:r>
            <a:r>
              <a:rPr lang="en-US" sz="800" dirty="0">
                <a:latin typeface="Arial" panose="020B0604020202020204" pitchFamily="34" charset="0"/>
                <a:cs typeface="Arial" panose="020B0604020202020204" pitchFamily="34" charset="0"/>
              </a:rPr>
              <a:t>/mL)</a:t>
            </a:r>
            <a:endParaRPr lang="en-US" sz="800" baseline="300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0BC118E5-0579-4666-8948-6A060C935CE9}"/>
              </a:ext>
            </a:extLst>
          </p:cNvPr>
          <p:cNvSpPr txBox="1"/>
          <p:nvPr/>
        </p:nvSpPr>
        <p:spPr>
          <a:xfrm>
            <a:off x="4033264" y="3880140"/>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63" name="TextBox 62">
            <a:extLst>
              <a:ext uri="{FF2B5EF4-FFF2-40B4-BE49-F238E27FC236}">
                <a16:creationId xmlns:a16="http://schemas.microsoft.com/office/drawing/2014/main" id="{6E6F71FF-27B6-4C13-8463-D7038ED824C3}"/>
              </a:ext>
            </a:extLst>
          </p:cNvPr>
          <p:cNvSpPr txBox="1"/>
          <p:nvPr/>
        </p:nvSpPr>
        <p:spPr>
          <a:xfrm>
            <a:off x="4355105" y="3880140"/>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64" name="TextBox 63">
            <a:extLst>
              <a:ext uri="{FF2B5EF4-FFF2-40B4-BE49-F238E27FC236}">
                <a16:creationId xmlns:a16="http://schemas.microsoft.com/office/drawing/2014/main" id="{645465B7-5977-4E5B-A436-81E8845B74B6}"/>
              </a:ext>
            </a:extLst>
          </p:cNvPr>
          <p:cNvSpPr txBox="1"/>
          <p:nvPr/>
        </p:nvSpPr>
        <p:spPr>
          <a:xfrm>
            <a:off x="4631557" y="3880140"/>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65" name="TextBox 64">
            <a:extLst>
              <a:ext uri="{FF2B5EF4-FFF2-40B4-BE49-F238E27FC236}">
                <a16:creationId xmlns:a16="http://schemas.microsoft.com/office/drawing/2014/main" id="{B90EC15F-628B-4CEB-B5CE-5EE212EE50AC}"/>
              </a:ext>
            </a:extLst>
          </p:cNvPr>
          <p:cNvSpPr txBox="1"/>
          <p:nvPr/>
        </p:nvSpPr>
        <p:spPr>
          <a:xfrm>
            <a:off x="5467683" y="3869421"/>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66" name="TextBox 65">
            <a:extLst>
              <a:ext uri="{FF2B5EF4-FFF2-40B4-BE49-F238E27FC236}">
                <a16:creationId xmlns:a16="http://schemas.microsoft.com/office/drawing/2014/main" id="{264F9312-DD5B-46C6-B561-33BC668578FB}"/>
              </a:ext>
            </a:extLst>
          </p:cNvPr>
          <p:cNvSpPr txBox="1"/>
          <p:nvPr/>
        </p:nvSpPr>
        <p:spPr>
          <a:xfrm>
            <a:off x="5789524" y="3869421"/>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67" name="TextBox 66">
            <a:extLst>
              <a:ext uri="{FF2B5EF4-FFF2-40B4-BE49-F238E27FC236}">
                <a16:creationId xmlns:a16="http://schemas.microsoft.com/office/drawing/2014/main" id="{526F886E-4F29-45CD-A9CB-A0570A8574C3}"/>
              </a:ext>
            </a:extLst>
          </p:cNvPr>
          <p:cNvSpPr txBox="1"/>
          <p:nvPr/>
        </p:nvSpPr>
        <p:spPr>
          <a:xfrm>
            <a:off x="6065976" y="3869421"/>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B48557A7-02EC-4830-A48D-44ED6A9AAE8B}"/>
              </a:ext>
            </a:extLst>
          </p:cNvPr>
          <p:cNvSpPr txBox="1"/>
          <p:nvPr/>
        </p:nvSpPr>
        <p:spPr>
          <a:xfrm>
            <a:off x="4058295" y="5175343"/>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B84C9AFC-BC0D-48AD-9782-83C0AC47BEA6}"/>
              </a:ext>
            </a:extLst>
          </p:cNvPr>
          <p:cNvSpPr txBox="1"/>
          <p:nvPr/>
        </p:nvSpPr>
        <p:spPr>
          <a:xfrm>
            <a:off x="4380136" y="5175343"/>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70" name="TextBox 69">
            <a:extLst>
              <a:ext uri="{FF2B5EF4-FFF2-40B4-BE49-F238E27FC236}">
                <a16:creationId xmlns:a16="http://schemas.microsoft.com/office/drawing/2014/main" id="{166D87D1-6841-48EF-BD9D-10E9BF8F5184}"/>
              </a:ext>
            </a:extLst>
          </p:cNvPr>
          <p:cNvSpPr txBox="1"/>
          <p:nvPr/>
        </p:nvSpPr>
        <p:spPr>
          <a:xfrm>
            <a:off x="4656588" y="5175343"/>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A35302C8-A666-49B5-90E4-A0EBB3EC99DB}"/>
              </a:ext>
            </a:extLst>
          </p:cNvPr>
          <p:cNvSpPr txBox="1"/>
          <p:nvPr/>
        </p:nvSpPr>
        <p:spPr>
          <a:xfrm>
            <a:off x="5495831" y="5164624"/>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2656A955-AC15-44F9-9FFB-956050254C5D}"/>
              </a:ext>
            </a:extLst>
          </p:cNvPr>
          <p:cNvSpPr txBox="1"/>
          <p:nvPr/>
        </p:nvSpPr>
        <p:spPr>
          <a:xfrm>
            <a:off x="5817672" y="5164624"/>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73" name="TextBox 72">
            <a:extLst>
              <a:ext uri="{FF2B5EF4-FFF2-40B4-BE49-F238E27FC236}">
                <a16:creationId xmlns:a16="http://schemas.microsoft.com/office/drawing/2014/main" id="{B68A7EC6-F606-4E56-92CA-9AB07D8B7520}"/>
              </a:ext>
            </a:extLst>
          </p:cNvPr>
          <p:cNvSpPr txBox="1"/>
          <p:nvPr/>
        </p:nvSpPr>
        <p:spPr>
          <a:xfrm>
            <a:off x="6094124" y="5164624"/>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9821B4FF-55C5-44F4-8E81-3C0703AB25DE}"/>
              </a:ext>
            </a:extLst>
          </p:cNvPr>
          <p:cNvSpPr txBox="1"/>
          <p:nvPr/>
        </p:nvSpPr>
        <p:spPr>
          <a:xfrm>
            <a:off x="4011551" y="6479365"/>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75" name="TextBox 74">
            <a:extLst>
              <a:ext uri="{FF2B5EF4-FFF2-40B4-BE49-F238E27FC236}">
                <a16:creationId xmlns:a16="http://schemas.microsoft.com/office/drawing/2014/main" id="{2CD0FE60-4EAA-4598-9C47-CC000534E2AD}"/>
              </a:ext>
            </a:extLst>
          </p:cNvPr>
          <p:cNvSpPr txBox="1"/>
          <p:nvPr/>
        </p:nvSpPr>
        <p:spPr>
          <a:xfrm>
            <a:off x="4333392" y="6479365"/>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76" name="TextBox 75">
            <a:extLst>
              <a:ext uri="{FF2B5EF4-FFF2-40B4-BE49-F238E27FC236}">
                <a16:creationId xmlns:a16="http://schemas.microsoft.com/office/drawing/2014/main" id="{421EBACD-3577-40F1-A2F6-9ABED8574B29}"/>
              </a:ext>
            </a:extLst>
          </p:cNvPr>
          <p:cNvSpPr txBox="1"/>
          <p:nvPr/>
        </p:nvSpPr>
        <p:spPr>
          <a:xfrm>
            <a:off x="4609844" y="6479365"/>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7273A10B-3DE0-4890-BE35-22441ED39646}"/>
              </a:ext>
            </a:extLst>
          </p:cNvPr>
          <p:cNvSpPr txBox="1"/>
          <p:nvPr/>
        </p:nvSpPr>
        <p:spPr>
          <a:xfrm>
            <a:off x="5522312" y="6468646"/>
            <a:ext cx="411774" cy="224016"/>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ltr</a:t>
            </a:r>
            <a:endParaRPr lang="en-US" sz="800" dirty="0">
              <a:latin typeface="Arial" panose="020B0604020202020204" pitchFamily="34" charset="0"/>
              <a:cs typeface="Arial" panose="020B0604020202020204" pitchFamily="34" charset="0"/>
            </a:endParaRPr>
          </a:p>
        </p:txBody>
      </p:sp>
      <p:sp>
        <p:nvSpPr>
          <p:cNvPr id="78" name="TextBox 77">
            <a:extLst>
              <a:ext uri="{FF2B5EF4-FFF2-40B4-BE49-F238E27FC236}">
                <a16:creationId xmlns:a16="http://schemas.microsoft.com/office/drawing/2014/main" id="{869755A7-C09F-45E4-9520-ABE1473AE320}"/>
              </a:ext>
            </a:extLst>
          </p:cNvPr>
          <p:cNvSpPr txBox="1"/>
          <p:nvPr/>
        </p:nvSpPr>
        <p:spPr>
          <a:xfrm>
            <a:off x="5844153" y="6468646"/>
            <a:ext cx="411774" cy="224016"/>
          </a:xfrm>
          <a:prstGeom prst="rect">
            <a:avLst/>
          </a:prstGeom>
          <a:solidFill>
            <a:schemeClr val="bg1"/>
          </a:solidFill>
        </p:spPr>
        <p:txBody>
          <a:bodyPr wrap="square" rtlCol="0">
            <a:spAutoFit/>
          </a:bodyPr>
          <a:lstStyle/>
          <a:p>
            <a:pPr algn="ctr"/>
            <a:r>
              <a:rPr lang="en-US" sz="800" dirty="0">
                <a:latin typeface="Arial" panose="020B0604020202020204" pitchFamily="34" charset="0"/>
                <a:cs typeface="Arial" panose="020B0604020202020204" pitchFamily="34" charset="0"/>
              </a:rPr>
              <a:t>WT</a:t>
            </a:r>
          </a:p>
        </p:txBody>
      </p:sp>
      <p:sp>
        <p:nvSpPr>
          <p:cNvPr id="79" name="TextBox 78">
            <a:extLst>
              <a:ext uri="{FF2B5EF4-FFF2-40B4-BE49-F238E27FC236}">
                <a16:creationId xmlns:a16="http://schemas.microsoft.com/office/drawing/2014/main" id="{07D48631-DE24-40C4-B80D-CA0623E5F19D}"/>
              </a:ext>
            </a:extLst>
          </p:cNvPr>
          <p:cNvSpPr txBox="1"/>
          <p:nvPr/>
        </p:nvSpPr>
        <p:spPr>
          <a:xfrm>
            <a:off x="6120605" y="6468646"/>
            <a:ext cx="464965" cy="215444"/>
          </a:xfrm>
          <a:prstGeom prst="rect">
            <a:avLst/>
          </a:prstGeom>
          <a:solidFill>
            <a:schemeClr val="bg1"/>
          </a:solidFill>
        </p:spPr>
        <p:txBody>
          <a:bodyPr wrap="square" rtlCol="0">
            <a:spAutoFit/>
          </a:bodyPr>
          <a:lstStyle/>
          <a:p>
            <a:pPr algn="ctr"/>
            <a:r>
              <a:rPr lang="en-US" sz="800" dirty="0" err="1">
                <a:latin typeface="Arial" panose="020B0604020202020204" pitchFamily="34" charset="0"/>
                <a:cs typeface="Arial" panose="020B0604020202020204" pitchFamily="34" charset="0"/>
              </a:rPr>
              <a:t>Cre</a:t>
            </a:r>
            <a:r>
              <a:rPr lang="en-US" sz="800" baseline="30000" dirty="0" err="1">
                <a:latin typeface="Arial" panose="020B0604020202020204" pitchFamily="34" charset="0"/>
                <a:cs typeface="Arial" panose="020B0604020202020204" pitchFamily="34" charset="0"/>
              </a:rPr>
              <a:t>Alb</a:t>
            </a:r>
            <a:endParaRPr lang="en-US" sz="800" baseline="30000" dirty="0">
              <a:latin typeface="Arial" panose="020B0604020202020204" pitchFamily="34" charset="0"/>
              <a:cs typeface="Arial" panose="020B0604020202020204" pitchFamily="34" charset="0"/>
            </a:endParaRPr>
          </a:p>
        </p:txBody>
      </p:sp>
      <p:sp>
        <p:nvSpPr>
          <p:cNvPr id="54" name="TextBox 53">
            <a:extLst>
              <a:ext uri="{FF2B5EF4-FFF2-40B4-BE49-F238E27FC236}">
                <a16:creationId xmlns:a16="http://schemas.microsoft.com/office/drawing/2014/main" id="{2340F642-FD68-41F7-87C0-269980BCFBA2}"/>
              </a:ext>
            </a:extLst>
          </p:cNvPr>
          <p:cNvSpPr txBox="1"/>
          <p:nvPr/>
        </p:nvSpPr>
        <p:spPr>
          <a:xfrm>
            <a:off x="353392" y="239408"/>
            <a:ext cx="206796"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4194757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 name="TextBox 42">
            <a:extLst>
              <a:ext uri="{FF2B5EF4-FFF2-40B4-BE49-F238E27FC236}">
                <a16:creationId xmlns:a16="http://schemas.microsoft.com/office/drawing/2014/main" id="{294B2B21-CEF3-431F-A01C-1A22CF15B04F}"/>
              </a:ext>
            </a:extLst>
          </p:cNvPr>
          <p:cNvSpPr txBox="1"/>
          <p:nvPr/>
        </p:nvSpPr>
        <p:spPr>
          <a:xfrm>
            <a:off x="14471" y="5144463"/>
            <a:ext cx="6858000"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 Fig. 3: Full length Western Blots for Figure 4 C and 5 C . </a:t>
            </a:r>
            <a:r>
              <a:rPr lang="en-US" sz="1200" dirty="0">
                <a:latin typeface="Arial" panose="020B0604020202020204" pitchFamily="34" charset="0"/>
                <a:cs typeface="Arial" panose="020B0604020202020204" pitchFamily="34" charset="0"/>
              </a:rPr>
              <a:t>(A) Full Western Blotting is shown for the detection of Collagen type 1 (molecular weight (MW): 138 </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 and housekeeping control band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actin (MW: 43 </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 in liver lysate samples from Main Fig. 4 C; and (B) </a:t>
            </a:r>
            <a:r>
              <a:rPr lang="el-GR" sz="12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SMA (42kDa) and (C) </a:t>
            </a:r>
            <a:r>
              <a:rPr lang="el-GR" sz="1200" dirty="0">
                <a:latin typeface="Arial" panose="020B0604020202020204" pitchFamily="34" charset="0"/>
                <a:cs typeface="Arial" panose="020B0604020202020204" pitchFamily="34" charset="0"/>
              </a:rPr>
              <a:t>α </a:t>
            </a:r>
            <a:r>
              <a:rPr lang="en-US" sz="1200" dirty="0">
                <a:latin typeface="Arial" panose="020B0604020202020204" pitchFamily="34" charset="0"/>
                <a:cs typeface="Arial" panose="020B0604020202020204" pitchFamily="34" charset="0"/>
              </a:rPr>
              <a:t>–tubulin (55 </a:t>
            </a:r>
            <a:r>
              <a:rPr lang="en-US" sz="1200" dirty="0" err="1">
                <a:latin typeface="Arial" panose="020B0604020202020204" pitchFamily="34" charset="0"/>
                <a:cs typeface="Arial" panose="020B0604020202020204" pitchFamily="34" charset="0"/>
              </a:rPr>
              <a:t>kDA</a:t>
            </a:r>
            <a:r>
              <a:rPr lang="en-US" sz="1200" dirty="0">
                <a:latin typeface="Arial" panose="020B0604020202020204" pitchFamily="34" charset="0"/>
                <a:cs typeface="Arial" panose="020B0604020202020204" pitchFamily="34" charset="0"/>
              </a:rPr>
              <a:t>) in LX-2 cells. In Fig 3A,due to cross-reactivity of antibodies, membrane was sectioned prior to incubation with primary antibodies. White lines were added in the </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actin to signalize that lanes were run together but are non-contiguous. In (B) Blot A was exposed first without </a:t>
            </a:r>
            <a:r>
              <a:rPr lang="en-US" sz="1200" dirty="0" err="1">
                <a:latin typeface="Arial" panose="020B0604020202020204" pitchFamily="34" charset="0"/>
                <a:cs typeface="Arial" panose="020B0604020202020204" pitchFamily="34" charset="0"/>
              </a:rPr>
              <a:t>IRDye</a:t>
            </a:r>
            <a:r>
              <a:rPr lang="en-US" sz="1200" dirty="0">
                <a:latin typeface="Arial" panose="020B0604020202020204" pitchFamily="34" charset="0"/>
                <a:cs typeface="Arial" panose="020B0604020202020204" pitchFamily="34" charset="0"/>
              </a:rPr>
              <a:t>® 680RD (RED) staining, thus ladder is not visible. </a:t>
            </a:r>
            <a:r>
              <a:rPr lang="en-US" sz="1200" dirty="0" err="1">
                <a:latin typeface="Arial" panose="020B0604020202020204" pitchFamily="34" charset="0"/>
                <a:cs typeface="Arial" panose="020B0604020202020204" pitchFamily="34" charset="0"/>
              </a:rPr>
              <a:t>IRDye</a:t>
            </a:r>
            <a:r>
              <a:rPr lang="en-US" sz="1200" dirty="0">
                <a:latin typeface="Arial" panose="020B0604020202020204" pitchFamily="34" charset="0"/>
                <a:cs typeface="Arial" panose="020B0604020202020204" pitchFamily="34" charset="0"/>
              </a:rPr>
              <a:t>® 680RD was done later in Blot B (B), where both </a:t>
            </a:r>
            <a:r>
              <a:rPr lang="el-GR" sz="1200" dirty="0">
                <a:latin typeface="Arial" panose="020B0604020202020204" pitchFamily="34" charset="0"/>
                <a:cs typeface="Arial" panose="020B0604020202020204" pitchFamily="34" charset="0"/>
              </a:rPr>
              <a:t>α </a:t>
            </a:r>
            <a:r>
              <a:rPr lang="en-US" sz="1200" dirty="0">
                <a:latin typeface="Arial" panose="020B0604020202020204" pitchFamily="34" charset="0"/>
                <a:cs typeface="Arial" panose="020B0604020202020204" pitchFamily="34" charset="0"/>
              </a:rPr>
              <a:t>–tubulin and ladder is now visible. </a:t>
            </a:r>
          </a:p>
          <a:p>
            <a:pPr algn="just"/>
            <a:endParaRPr lang="en-US" sz="1200" dirty="0">
              <a:latin typeface="Arial" panose="020B0604020202020204" pitchFamily="34" charset="0"/>
              <a:cs typeface="Arial" panose="020B0604020202020204" pitchFamily="34" charset="0"/>
            </a:endParaRPr>
          </a:p>
        </p:txBody>
      </p:sp>
      <p:grpSp>
        <p:nvGrpSpPr>
          <p:cNvPr id="13" name="Group 12"/>
          <p:cNvGrpSpPr/>
          <p:nvPr/>
        </p:nvGrpSpPr>
        <p:grpSpPr>
          <a:xfrm>
            <a:off x="309254" y="291462"/>
            <a:ext cx="4106184" cy="1476595"/>
            <a:chOff x="497031" y="1432379"/>
            <a:chExt cx="4106184" cy="1476595"/>
          </a:xfrm>
        </p:grpSpPr>
        <p:pic>
          <p:nvPicPr>
            <p:cNvPr id="4" name="Picture 3"/>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369" t="-157" b="1605"/>
            <a:stretch/>
          </p:blipFill>
          <p:spPr>
            <a:xfrm>
              <a:off x="750277" y="1453272"/>
              <a:ext cx="3135930" cy="1035483"/>
            </a:xfrm>
            <a:prstGeom prst="rect">
              <a:avLst/>
            </a:prstGeom>
            <a:ln w="3175">
              <a:solidFill>
                <a:schemeClr val="tx2"/>
              </a:solidFill>
            </a:ln>
          </p:spPr>
        </p:pic>
        <p:sp>
          <p:nvSpPr>
            <p:cNvPr id="5" name="TextBox 4">
              <a:extLst>
                <a:ext uri="{FF2B5EF4-FFF2-40B4-BE49-F238E27FC236}">
                  <a16:creationId xmlns:a16="http://schemas.microsoft.com/office/drawing/2014/main" id="{164BB34A-F214-4EEB-B2A7-11C1B567181E}"/>
                </a:ext>
              </a:extLst>
            </p:cNvPr>
            <p:cNvSpPr txBox="1"/>
            <p:nvPr/>
          </p:nvSpPr>
          <p:spPr>
            <a:xfrm>
              <a:off x="3886205" y="1555490"/>
              <a:ext cx="717010" cy="194220"/>
            </a:xfrm>
            <a:prstGeom prst="rect">
              <a:avLst/>
            </a:prstGeom>
            <a:noFill/>
            <a:ln w="3175">
              <a:noFill/>
            </a:ln>
          </p:spPr>
          <p:txBody>
            <a:bodyPr wrap="square" rtlCol="0">
              <a:spAutoFit/>
            </a:bodyPr>
            <a:lstStyle/>
            <a:p>
              <a:r>
                <a:rPr lang="en-US" sz="662" dirty="0">
                  <a:latin typeface="Arial" panose="020B0604020202020204" pitchFamily="34" charset="0"/>
                  <a:cs typeface="Arial" panose="020B0604020202020204" pitchFamily="34" charset="0"/>
                </a:rPr>
                <a:t>Collagen I </a:t>
              </a:r>
            </a:p>
          </p:txBody>
        </p:sp>
        <p:sp>
          <p:nvSpPr>
            <p:cNvPr id="6" name="TextBox 5">
              <a:extLst>
                <a:ext uri="{FF2B5EF4-FFF2-40B4-BE49-F238E27FC236}">
                  <a16:creationId xmlns:a16="http://schemas.microsoft.com/office/drawing/2014/main" id="{C382E78F-6ACA-40F6-B72C-A8C2020CD63C}"/>
                </a:ext>
              </a:extLst>
            </p:cNvPr>
            <p:cNvSpPr txBox="1"/>
            <p:nvPr/>
          </p:nvSpPr>
          <p:spPr>
            <a:xfrm>
              <a:off x="3886208" y="2218775"/>
              <a:ext cx="514001" cy="347757"/>
            </a:xfrm>
            <a:prstGeom prst="rect">
              <a:avLst/>
            </a:prstGeom>
            <a:noFill/>
            <a:ln w="3175">
              <a:noFill/>
            </a:ln>
          </p:spPr>
          <p:txBody>
            <a:bodyPr wrap="square" rtlCol="0">
              <a:spAutoFit/>
            </a:bodyPr>
            <a:lstStyle/>
            <a:p>
              <a:r>
                <a:rPr lang="en-US" sz="662" dirty="0">
                  <a:latin typeface="Arial" panose="020B0604020202020204" pitchFamily="34" charset="0"/>
                  <a:cs typeface="Arial" panose="020B0604020202020204" pitchFamily="34" charset="0"/>
                </a:rPr>
                <a:t>β-actin</a:t>
              </a:r>
            </a:p>
          </p:txBody>
        </p:sp>
        <p:sp>
          <p:nvSpPr>
            <p:cNvPr id="7" name="TextBox 6"/>
            <p:cNvSpPr txBox="1"/>
            <p:nvPr/>
          </p:nvSpPr>
          <p:spPr>
            <a:xfrm>
              <a:off x="1128101" y="2561217"/>
              <a:ext cx="517730" cy="347757"/>
            </a:xfrm>
            <a:prstGeom prst="rect">
              <a:avLst/>
            </a:prstGeom>
            <a:noFill/>
            <a:ln w="3175">
              <a:noFill/>
            </a:ln>
          </p:spPr>
          <p:txBody>
            <a:bodyPr wrap="square" rtlCol="0">
              <a:spAutoFit/>
            </a:bodyPr>
            <a:lstStyle/>
            <a:p>
              <a:r>
                <a:rPr lang="en-US" sz="662" dirty="0">
                  <a:latin typeface="Arial" panose="020B0604020202020204" pitchFamily="34" charset="0"/>
                  <a:cs typeface="Arial" panose="020B0604020202020204" pitchFamily="34" charset="0"/>
                </a:rPr>
                <a:t>Control</a:t>
              </a:r>
            </a:p>
          </p:txBody>
        </p:sp>
        <p:cxnSp>
          <p:nvCxnSpPr>
            <p:cNvPr id="8" name="Straight Connector 7"/>
            <p:cNvCxnSpPr/>
            <p:nvPr/>
          </p:nvCxnSpPr>
          <p:spPr>
            <a:xfrm>
              <a:off x="880377" y="2561217"/>
              <a:ext cx="954000" cy="0"/>
            </a:xfrm>
            <a:prstGeom prst="line">
              <a:avLst/>
            </a:prstGeom>
            <a:ln w="3175"/>
          </p:spPr>
          <p:style>
            <a:lnRef idx="1">
              <a:schemeClr val="dk1"/>
            </a:lnRef>
            <a:fillRef idx="0">
              <a:schemeClr val="dk1"/>
            </a:fillRef>
            <a:effectRef idx="0">
              <a:schemeClr val="dk1"/>
            </a:effectRef>
            <a:fontRef idx="minor">
              <a:schemeClr val="tx1"/>
            </a:fontRef>
          </p:style>
        </p:cxnSp>
        <p:sp>
          <p:nvSpPr>
            <p:cNvPr id="9" name="TextBox 8"/>
            <p:cNvSpPr txBox="1"/>
            <p:nvPr/>
          </p:nvSpPr>
          <p:spPr>
            <a:xfrm>
              <a:off x="2318242" y="2548087"/>
              <a:ext cx="439410" cy="228098"/>
            </a:xfrm>
            <a:prstGeom prst="rect">
              <a:avLst/>
            </a:prstGeom>
            <a:noFill/>
            <a:ln w="3175">
              <a:noFill/>
            </a:ln>
          </p:spPr>
          <p:txBody>
            <a:bodyPr wrap="square" rtlCol="0">
              <a:spAutoFit/>
            </a:bodyPr>
            <a:lstStyle/>
            <a:p>
              <a:r>
                <a:rPr lang="en-US" sz="662" dirty="0">
                  <a:latin typeface="Arial" panose="020B0604020202020204" pitchFamily="34" charset="0"/>
                  <a:cs typeface="Arial" panose="020B0604020202020204" pitchFamily="34" charset="0"/>
                </a:rPr>
                <a:t>WT</a:t>
              </a:r>
              <a:endParaRPr lang="en-US" sz="352" dirty="0">
                <a:latin typeface="Arial" panose="020B0604020202020204" pitchFamily="34" charset="0"/>
                <a:cs typeface="Arial" panose="020B0604020202020204" pitchFamily="34" charset="0"/>
              </a:endParaRPr>
            </a:p>
          </p:txBody>
        </p:sp>
        <p:cxnSp>
          <p:nvCxnSpPr>
            <p:cNvPr id="10" name="Straight Connector 9"/>
            <p:cNvCxnSpPr/>
            <p:nvPr/>
          </p:nvCxnSpPr>
          <p:spPr>
            <a:xfrm>
              <a:off x="1921436" y="2561217"/>
              <a:ext cx="990163" cy="0"/>
            </a:xfrm>
            <a:prstGeom prst="line">
              <a:avLst/>
            </a:prstGeom>
            <a:ln w="3175"/>
          </p:spPr>
          <p:style>
            <a:lnRef idx="1">
              <a:schemeClr val="dk1"/>
            </a:lnRef>
            <a:fillRef idx="0">
              <a:schemeClr val="dk1"/>
            </a:fillRef>
            <a:effectRef idx="0">
              <a:schemeClr val="dk1"/>
            </a:effectRef>
            <a:fontRef idx="minor">
              <a:schemeClr val="tx1"/>
            </a:fontRef>
          </p:style>
        </p:cxnSp>
        <p:sp>
          <p:nvSpPr>
            <p:cNvPr id="11" name="TextBox 10"/>
            <p:cNvSpPr txBox="1"/>
            <p:nvPr/>
          </p:nvSpPr>
          <p:spPr>
            <a:xfrm>
              <a:off x="3227073" y="2548087"/>
              <a:ext cx="659135" cy="228098"/>
            </a:xfrm>
            <a:prstGeom prst="rect">
              <a:avLst/>
            </a:prstGeom>
            <a:noFill/>
            <a:ln w="3175">
              <a:noFill/>
            </a:ln>
          </p:spPr>
          <p:txBody>
            <a:bodyPr wrap="square" rtlCol="0">
              <a:spAutoFit/>
            </a:bodyPr>
            <a:lstStyle/>
            <a:p>
              <a:r>
                <a:rPr lang="en-US" sz="662" dirty="0" err="1">
                  <a:latin typeface="Arial" panose="020B0604020202020204" pitchFamily="34" charset="0"/>
                  <a:cs typeface="Arial" panose="020B0604020202020204" pitchFamily="34" charset="0"/>
                </a:rPr>
                <a:t>Cre</a:t>
              </a:r>
              <a:r>
                <a:rPr lang="en-US" sz="662" baseline="30000" dirty="0" err="1">
                  <a:latin typeface="Arial" panose="020B0604020202020204" pitchFamily="34" charset="0"/>
                  <a:cs typeface="Arial" panose="020B0604020202020204" pitchFamily="34" charset="0"/>
                </a:rPr>
                <a:t>Lyz</a:t>
              </a:r>
              <a:endParaRPr lang="en-US" sz="352" baseline="30000" dirty="0">
                <a:latin typeface="Arial" panose="020B0604020202020204" pitchFamily="34" charset="0"/>
                <a:cs typeface="Arial" panose="020B0604020202020204" pitchFamily="34" charset="0"/>
              </a:endParaRPr>
            </a:p>
          </p:txBody>
        </p:sp>
        <p:cxnSp>
          <p:nvCxnSpPr>
            <p:cNvPr id="12" name="Straight Connector 11"/>
            <p:cNvCxnSpPr/>
            <p:nvPr/>
          </p:nvCxnSpPr>
          <p:spPr>
            <a:xfrm>
              <a:off x="2973650" y="2561217"/>
              <a:ext cx="912558" cy="0"/>
            </a:xfrm>
            <a:prstGeom prst="line">
              <a:avLst/>
            </a:prstGeom>
            <a:ln w="3175"/>
          </p:spPr>
          <p:style>
            <a:lnRef idx="1">
              <a:schemeClr val="dk1"/>
            </a:lnRef>
            <a:fillRef idx="0">
              <a:schemeClr val="dk1"/>
            </a:fillRef>
            <a:effectRef idx="0">
              <a:schemeClr val="dk1"/>
            </a:effectRef>
            <a:fontRef idx="minor">
              <a:schemeClr val="tx1"/>
            </a:fontRef>
          </p:style>
        </p:cxnSp>
        <p:sp>
          <p:nvSpPr>
            <p:cNvPr id="65" name="TextBox 64"/>
            <p:cNvSpPr txBox="1"/>
            <p:nvPr/>
          </p:nvSpPr>
          <p:spPr>
            <a:xfrm>
              <a:off x="497031" y="1432379"/>
              <a:ext cx="24852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a:t>
              </a:r>
            </a:p>
          </p:txBody>
        </p:sp>
        <p:cxnSp>
          <p:nvCxnSpPr>
            <p:cNvPr id="3" name="Straight Connector 2"/>
            <p:cNvCxnSpPr/>
            <p:nvPr/>
          </p:nvCxnSpPr>
          <p:spPr>
            <a:xfrm flipH="1">
              <a:off x="1073497" y="2031833"/>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flipH="1">
              <a:off x="1234077" y="2071234"/>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H="1">
              <a:off x="1391579" y="2082921"/>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flipH="1">
              <a:off x="1557297" y="2102141"/>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flipH="1">
              <a:off x="1723016" y="2155261"/>
              <a:ext cx="15577" cy="16815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flipH="1">
              <a:off x="1874438" y="2159468"/>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flipH="1">
              <a:off x="2041098" y="2165934"/>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flipH="1">
              <a:off x="2206354" y="2159929"/>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flipH="1">
              <a:off x="2371610" y="2174492"/>
              <a:ext cx="22320" cy="20529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flipH="1">
              <a:off x="2556577" y="2202666"/>
              <a:ext cx="147" cy="18866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flipH="1">
              <a:off x="2716741" y="2221242"/>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5" name="Straight Connector 74"/>
            <p:cNvCxnSpPr/>
            <p:nvPr/>
          </p:nvCxnSpPr>
          <p:spPr>
            <a:xfrm flipH="1">
              <a:off x="2888638" y="2230668"/>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6" name="Straight Connector 75"/>
            <p:cNvCxnSpPr/>
            <p:nvPr/>
          </p:nvCxnSpPr>
          <p:spPr>
            <a:xfrm flipH="1">
              <a:off x="3068077" y="2252938"/>
              <a:ext cx="6347" cy="155244"/>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7" name="Straight Connector 76"/>
            <p:cNvCxnSpPr/>
            <p:nvPr/>
          </p:nvCxnSpPr>
          <p:spPr>
            <a:xfrm flipH="1">
              <a:off x="3221673" y="2224301"/>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8" name="Straight Connector 77"/>
            <p:cNvCxnSpPr/>
            <p:nvPr/>
          </p:nvCxnSpPr>
          <p:spPr>
            <a:xfrm>
              <a:off x="3391346" y="2218774"/>
              <a:ext cx="1370" cy="189409"/>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a:off x="3561357" y="2195612"/>
              <a:ext cx="0" cy="200103"/>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flipH="1">
              <a:off x="3710870" y="2227562"/>
              <a:ext cx="23795" cy="186942"/>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grpSp>
      <p:pic>
        <p:nvPicPr>
          <p:cNvPr id="31" name="Picture 30">
            <a:extLst>
              <a:ext uri="{FF2B5EF4-FFF2-40B4-BE49-F238E27FC236}">
                <a16:creationId xmlns:a16="http://schemas.microsoft.com/office/drawing/2014/main" id="{58182917-25A9-47F5-AFD6-FB18B1B97B96}"/>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557783" y="1690917"/>
            <a:ext cx="2811080" cy="2343036"/>
          </a:xfrm>
          <a:prstGeom prst="rect">
            <a:avLst/>
          </a:prstGeom>
        </p:spPr>
      </p:pic>
      <p:pic>
        <p:nvPicPr>
          <p:cNvPr id="32" name="Picture 31">
            <a:extLst>
              <a:ext uri="{FF2B5EF4-FFF2-40B4-BE49-F238E27FC236}">
                <a16:creationId xmlns:a16="http://schemas.microsoft.com/office/drawing/2014/main" id="{E70541BA-C3E4-4A02-9702-1A95B51AC243}"/>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557783" y="4117988"/>
            <a:ext cx="3180424" cy="826497"/>
          </a:xfrm>
          <a:prstGeom prst="rect">
            <a:avLst/>
          </a:prstGeom>
        </p:spPr>
      </p:pic>
      <p:sp>
        <p:nvSpPr>
          <p:cNvPr id="33" name="TextBox 32">
            <a:extLst>
              <a:ext uri="{FF2B5EF4-FFF2-40B4-BE49-F238E27FC236}">
                <a16:creationId xmlns:a16="http://schemas.microsoft.com/office/drawing/2014/main" id="{865BBD82-522C-49D4-83FA-258A84EFC71F}"/>
              </a:ext>
            </a:extLst>
          </p:cNvPr>
          <p:cNvSpPr txBox="1"/>
          <p:nvPr/>
        </p:nvSpPr>
        <p:spPr>
          <a:xfrm>
            <a:off x="3343940" y="1674949"/>
            <a:ext cx="561538" cy="404085"/>
          </a:xfrm>
          <a:prstGeom prst="rect">
            <a:avLst/>
          </a:prstGeom>
          <a:noFill/>
        </p:spPr>
        <p:txBody>
          <a:bodyPr wrap="square" rtlCol="0">
            <a:spAutoFit/>
          </a:bodyPr>
          <a:lstStyle/>
          <a:p>
            <a:r>
              <a:rPr lang="en-US" sz="1013" dirty="0"/>
              <a:t>Blot A:</a:t>
            </a:r>
          </a:p>
          <a:p>
            <a:r>
              <a:rPr lang="el-GR" sz="1013" dirty="0"/>
              <a:t>α</a:t>
            </a:r>
            <a:r>
              <a:rPr lang="en-US" sz="1013" dirty="0"/>
              <a:t>-SMA</a:t>
            </a:r>
          </a:p>
        </p:txBody>
      </p:sp>
      <p:sp>
        <p:nvSpPr>
          <p:cNvPr id="34" name="TextBox 33">
            <a:extLst>
              <a:ext uri="{FF2B5EF4-FFF2-40B4-BE49-F238E27FC236}">
                <a16:creationId xmlns:a16="http://schemas.microsoft.com/office/drawing/2014/main" id="{F2B1EA38-BE4D-4CC9-8FF8-039106ECC0DE}"/>
              </a:ext>
            </a:extLst>
          </p:cNvPr>
          <p:cNvSpPr txBox="1"/>
          <p:nvPr/>
        </p:nvSpPr>
        <p:spPr>
          <a:xfrm>
            <a:off x="3726591" y="4117988"/>
            <a:ext cx="854934" cy="404085"/>
          </a:xfrm>
          <a:prstGeom prst="rect">
            <a:avLst/>
          </a:prstGeom>
          <a:noFill/>
        </p:spPr>
        <p:txBody>
          <a:bodyPr wrap="square" rtlCol="0">
            <a:spAutoFit/>
          </a:bodyPr>
          <a:lstStyle/>
          <a:p>
            <a:r>
              <a:rPr lang="en-US" sz="1013" dirty="0"/>
              <a:t>Blot B:</a:t>
            </a:r>
          </a:p>
          <a:p>
            <a:r>
              <a:rPr lang="el-GR" sz="1013" dirty="0"/>
              <a:t>α </a:t>
            </a:r>
            <a:r>
              <a:rPr lang="en-US" sz="1013" dirty="0"/>
              <a:t>-tubulin</a:t>
            </a:r>
          </a:p>
        </p:txBody>
      </p:sp>
      <p:sp>
        <p:nvSpPr>
          <p:cNvPr id="2" name="TextBox 1">
            <a:extLst>
              <a:ext uri="{FF2B5EF4-FFF2-40B4-BE49-F238E27FC236}">
                <a16:creationId xmlns:a16="http://schemas.microsoft.com/office/drawing/2014/main" id="{E666D394-822D-4441-A483-2720B56DF81E}"/>
              </a:ext>
            </a:extLst>
          </p:cNvPr>
          <p:cNvSpPr txBox="1"/>
          <p:nvPr/>
        </p:nvSpPr>
        <p:spPr>
          <a:xfrm>
            <a:off x="297165" y="1618454"/>
            <a:ext cx="30695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37" name="TextBox 36">
            <a:extLst>
              <a:ext uri="{FF2B5EF4-FFF2-40B4-BE49-F238E27FC236}">
                <a16:creationId xmlns:a16="http://schemas.microsoft.com/office/drawing/2014/main" id="{8A294EC8-D4D9-4EC7-BA61-36376E3E78A2}"/>
              </a:ext>
            </a:extLst>
          </p:cNvPr>
          <p:cNvSpPr txBox="1"/>
          <p:nvPr/>
        </p:nvSpPr>
        <p:spPr>
          <a:xfrm>
            <a:off x="250829" y="4034406"/>
            <a:ext cx="306954"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404340211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a:extLst>
              <a:ext uri="{FF2B5EF4-FFF2-40B4-BE49-F238E27FC236}">
                <a16:creationId xmlns:a16="http://schemas.microsoft.com/office/drawing/2014/main" id="{CB5E01B6-02EA-42B6-83A3-276808DF5133}"/>
              </a:ext>
            </a:extLst>
          </p:cNvPr>
          <p:cNvPicPr>
            <a:picLocks noChangeAspect="1"/>
          </p:cNvPicPr>
          <p:nvPr/>
        </p:nvPicPr>
        <p:blipFill>
          <a:blip r:embed="rId2"/>
          <a:stretch>
            <a:fillRect/>
          </a:stretch>
        </p:blipFill>
        <p:spPr>
          <a:xfrm>
            <a:off x="0" y="719612"/>
            <a:ext cx="6249201" cy="3299938"/>
          </a:xfrm>
          <a:prstGeom prst="rect">
            <a:avLst/>
          </a:prstGeom>
        </p:spPr>
      </p:pic>
      <p:sp>
        <p:nvSpPr>
          <p:cNvPr id="31" name="TextBox 30">
            <a:extLst>
              <a:ext uri="{FF2B5EF4-FFF2-40B4-BE49-F238E27FC236}">
                <a16:creationId xmlns:a16="http://schemas.microsoft.com/office/drawing/2014/main" id="{2DA033B3-6B06-4D89-8138-AF5545BB2359}"/>
              </a:ext>
            </a:extLst>
          </p:cNvPr>
          <p:cNvSpPr txBox="1"/>
          <p:nvPr/>
        </p:nvSpPr>
        <p:spPr>
          <a:xfrm>
            <a:off x="0" y="4118996"/>
            <a:ext cx="6858000"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Supp. Fig. 4: rhChi3L1 induced CCL22 upregulation and this action was blocked by anti-IL13R</a:t>
            </a:r>
            <a:r>
              <a:rPr lang="el-GR" sz="1200" b="1" dirty="0">
                <a:latin typeface="Arial" panose="020B0604020202020204" pitchFamily="34" charset="0"/>
                <a:cs typeface="Arial" panose="020B0604020202020204" pitchFamily="34" charset="0"/>
              </a:rPr>
              <a:t>α</a:t>
            </a:r>
            <a:r>
              <a:rPr lang="en-US" sz="1200" b="1" dirty="0">
                <a:latin typeface="Arial" panose="020B0604020202020204" pitchFamily="34" charset="0"/>
                <a:cs typeface="Arial" panose="020B0604020202020204" pitchFamily="34" charset="0"/>
              </a:rPr>
              <a:t>2 in PMA differentiated THP-1. </a:t>
            </a:r>
            <a:r>
              <a:rPr lang="en-US" sz="1200" dirty="0">
                <a:latin typeface="Arial" panose="020B0604020202020204" pitchFamily="34" charset="0"/>
                <a:cs typeface="Arial" panose="020B0604020202020204" pitchFamily="34" charset="0"/>
              </a:rPr>
              <a:t>M2 gene expression marker CCL22 (4A), M1 gene expression markers IL1</a:t>
            </a:r>
            <a:r>
              <a:rPr lang="el-GR" sz="12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 (4B) and CXCL10 (4C) were measured by qPCR in PMA differentiated THP-1 under various conditions. </a:t>
            </a:r>
          </a:p>
          <a:p>
            <a:pPr algn="just"/>
            <a:endParaRPr lang="en-US" sz="1200" dirty="0">
              <a:latin typeface="Arial" panose="020B0604020202020204" pitchFamily="34" charset="0"/>
              <a:cs typeface="Arial" panose="020B0604020202020204" pitchFamily="34" charset="0"/>
            </a:endParaRPr>
          </a:p>
          <a:p>
            <a:pPr algn="just"/>
            <a:endParaRPr lang="en-US" sz="1200"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78F3D100-454E-4135-A33D-649A99756089}"/>
              </a:ext>
            </a:extLst>
          </p:cNvPr>
          <p:cNvSpPr txBox="1"/>
          <p:nvPr/>
        </p:nvSpPr>
        <p:spPr>
          <a:xfrm>
            <a:off x="1057275" y="1142998"/>
            <a:ext cx="34290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1F91F8C4-75DA-4EC3-BA3E-AEA1466E2897}"/>
              </a:ext>
            </a:extLst>
          </p:cNvPr>
          <p:cNvSpPr txBox="1"/>
          <p:nvPr/>
        </p:nvSpPr>
        <p:spPr>
          <a:xfrm>
            <a:off x="2667000" y="1142998"/>
            <a:ext cx="34290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B</a:t>
            </a:r>
          </a:p>
        </p:txBody>
      </p:sp>
      <p:sp>
        <p:nvSpPr>
          <p:cNvPr id="34" name="TextBox 33">
            <a:extLst>
              <a:ext uri="{FF2B5EF4-FFF2-40B4-BE49-F238E27FC236}">
                <a16:creationId xmlns:a16="http://schemas.microsoft.com/office/drawing/2014/main" id="{15B24997-E34D-43C6-92B1-E737E2A67637}"/>
              </a:ext>
            </a:extLst>
          </p:cNvPr>
          <p:cNvSpPr txBox="1"/>
          <p:nvPr/>
        </p:nvSpPr>
        <p:spPr>
          <a:xfrm>
            <a:off x="4276725" y="1142998"/>
            <a:ext cx="342900" cy="276999"/>
          </a:xfrm>
          <a:prstGeom prst="rect">
            <a:avLst/>
          </a:prstGeom>
          <a:noFill/>
        </p:spPr>
        <p:txBody>
          <a:bodyPr wrap="square" rtlCol="0">
            <a:spAutoFit/>
          </a:bodyPr>
          <a:lstStyle/>
          <a:p>
            <a:pPr algn="ctr"/>
            <a:r>
              <a:rPr lang="en-US" sz="1200"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8396574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6C69C31DC5C7AD44BFD55120B3E7DEE1" ma:contentTypeVersion="12" ma:contentTypeDescription="Create a new document." ma:contentTypeScope="" ma:versionID="deeaf3eae0f45ddc48ed22ffa076db4b">
  <xsd:schema xmlns:xsd="http://www.w3.org/2001/XMLSchema" xmlns:xs="http://www.w3.org/2001/XMLSchema" xmlns:p="http://schemas.microsoft.com/office/2006/metadata/properties" xmlns:ns3="2a51b212-c383-4526-89bd-304026e941b6" xmlns:ns4="b18e05d1-6721-4d3b-9e30-072c77de35ce" targetNamespace="http://schemas.microsoft.com/office/2006/metadata/properties" ma:root="true" ma:fieldsID="f79919c8239e8eb2439a211e3557fed0" ns3:_="" ns4:_="">
    <xsd:import namespace="2a51b212-c383-4526-89bd-304026e941b6"/>
    <xsd:import namespace="b18e05d1-6721-4d3b-9e30-072c77de35ce"/>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ServiceAutoTags" minOccurs="0"/>
                <xsd:element ref="ns3:MediaServiceGenerationTime" minOccurs="0"/>
                <xsd:element ref="ns3:MediaServiceEventHashCode" minOccurs="0"/>
                <xsd:element ref="ns3:MediaServiceOCR" minOccurs="0"/>
                <xsd:element ref="ns3:MediaServiceAutoKeyPoints" minOccurs="0"/>
                <xsd:element ref="ns3:MediaServiceKeyPoint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a51b212-c383-4526-89bd-304026e941b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OCR" ma:index="14" nillable="true" ma:displayName="Extracted Text" ma:internalName="MediaServiceOCR" ma:readOnly="true">
      <xsd:simpleType>
        <xsd:restriction base="dms:Note">
          <xsd:maxLength value="255"/>
        </xsd:restriction>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b18e05d1-6721-4d3b-9e30-072c77de35ce"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F1CE7F7-EB5C-4EC1-A1EA-1EED120BD58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a51b212-c383-4526-89bd-304026e941b6"/>
    <ds:schemaRef ds:uri="b18e05d1-6721-4d3b-9e30-072c77de35c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5137C315-D16C-4B76-BAF8-6B9CC20B70D8}">
  <ds:schemaRefs>
    <ds:schemaRef ds:uri="2a51b212-c383-4526-89bd-304026e941b6"/>
    <ds:schemaRef ds:uri="http://purl.org/dc/terms/"/>
    <ds:schemaRef ds:uri="b18e05d1-6721-4d3b-9e30-072c77de35ce"/>
    <ds:schemaRef ds:uri="http://schemas.microsoft.com/office/2006/documentManagement/types"/>
    <ds:schemaRef ds:uri="http://schemas.microsoft.com/office/infopath/2007/PartnerControls"/>
    <ds:schemaRef ds:uri="http://purl.org/dc/elements/1.1/"/>
    <ds:schemaRef ds:uri="http://schemas.microsoft.com/office/2006/metadata/properties"/>
    <ds:schemaRef ds:uri="http://schemas.openxmlformats.org/package/2006/metadata/core-properties"/>
    <ds:schemaRef ds:uri="http://www.w3.org/XML/1998/namespace"/>
    <ds:schemaRef ds:uri="http://purl.org/dc/dcmitype/"/>
  </ds:schemaRefs>
</ds:datastoreItem>
</file>

<file path=customXml/itemProps3.xml><?xml version="1.0" encoding="utf-8"?>
<ds:datastoreItem xmlns:ds="http://schemas.openxmlformats.org/officeDocument/2006/customXml" ds:itemID="{6AFEFB9C-1AF1-4B51-822E-C3067CBB399F}">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47420</TotalTime>
  <Words>897</Words>
  <Application>Microsoft Office PowerPoint</Application>
  <PresentationFormat>A4 Paper (210x297 mm)</PresentationFormat>
  <Paragraphs>117</Paragraphs>
  <Slides>5</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UCSD Pediatric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im, Andrea</dc:creator>
  <cp:lastModifiedBy>Kui, Lin</cp:lastModifiedBy>
  <cp:revision>86</cp:revision>
  <dcterms:created xsi:type="dcterms:W3CDTF">2022-02-22T20:09:49Z</dcterms:created>
  <dcterms:modified xsi:type="dcterms:W3CDTF">2023-04-17T18:51:3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C69C31DC5C7AD44BFD55120B3E7DEE1</vt:lpwstr>
  </property>
</Properties>
</file>